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734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F99C2F-646C-4701-BDC3-352EFD5BDD90}" type="datetimeFigureOut">
              <a:rPr lang="en-IN" smtClean="0"/>
              <a:t>15-12-2016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D1ADBD-6F90-4172-9061-2186C75F7C9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133069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8D28-E973-4EF5-8B2E-F873ADB7D313}" type="datetimeFigureOut">
              <a:rPr lang="en-IN" smtClean="0"/>
              <a:t>15-12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E13D-F7F5-4D84-8FD1-FE6A27310F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213842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8D28-E973-4EF5-8B2E-F873ADB7D313}" type="datetimeFigureOut">
              <a:rPr lang="en-IN" smtClean="0"/>
              <a:t>15-12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E13D-F7F5-4D84-8FD1-FE6A27310F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986218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8D28-E973-4EF5-8B2E-F873ADB7D313}" type="datetimeFigureOut">
              <a:rPr lang="en-IN" smtClean="0"/>
              <a:t>15-12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E13D-F7F5-4D84-8FD1-FE6A27310F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98370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8D28-E973-4EF5-8B2E-F873ADB7D313}" type="datetimeFigureOut">
              <a:rPr lang="en-IN" smtClean="0"/>
              <a:t>15-12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E13D-F7F5-4D84-8FD1-FE6A27310F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564216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8D28-E973-4EF5-8B2E-F873ADB7D313}" type="datetimeFigureOut">
              <a:rPr lang="en-IN" smtClean="0"/>
              <a:t>15-12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E13D-F7F5-4D84-8FD1-FE6A27310F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71656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8D28-E973-4EF5-8B2E-F873ADB7D313}" type="datetimeFigureOut">
              <a:rPr lang="en-IN" smtClean="0"/>
              <a:t>15-12-201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E13D-F7F5-4D84-8FD1-FE6A27310F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80902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8D28-E973-4EF5-8B2E-F873ADB7D313}" type="datetimeFigureOut">
              <a:rPr lang="en-IN" smtClean="0"/>
              <a:t>15-12-2016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E13D-F7F5-4D84-8FD1-FE6A27310F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898470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8D28-E973-4EF5-8B2E-F873ADB7D313}" type="datetimeFigureOut">
              <a:rPr lang="en-IN" smtClean="0"/>
              <a:t>15-12-2016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E13D-F7F5-4D84-8FD1-FE6A27310F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142917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8D28-E973-4EF5-8B2E-F873ADB7D313}" type="datetimeFigureOut">
              <a:rPr lang="en-IN" smtClean="0"/>
              <a:t>15-12-2016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E13D-F7F5-4D84-8FD1-FE6A27310F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491993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8D28-E973-4EF5-8B2E-F873ADB7D313}" type="datetimeFigureOut">
              <a:rPr lang="en-IN" smtClean="0"/>
              <a:t>15-12-201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E13D-F7F5-4D84-8FD1-FE6A27310F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32098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E88D28-E973-4EF5-8B2E-F873ADB7D313}" type="datetimeFigureOut">
              <a:rPr lang="en-IN" smtClean="0"/>
              <a:t>15-12-201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E13D-F7F5-4D84-8FD1-FE6A27310F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399158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88D28-E973-4EF5-8B2E-F873ADB7D313}" type="datetimeFigureOut">
              <a:rPr lang="en-IN" smtClean="0"/>
              <a:t>15-12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5E13D-F7F5-4D84-8FD1-FE6A27310F6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72787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>
            <a:spLocks noChangeAspect="1"/>
          </p:cNvSpPr>
          <p:nvPr/>
        </p:nvSpPr>
        <p:spPr>
          <a:xfrm>
            <a:off x="6234752" y="-18108"/>
            <a:ext cx="2909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upplementary figure 1; Nawaz et.al., 2016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990600" y="1664907"/>
            <a:ext cx="3657600" cy="2286000"/>
            <a:chOff x="2326211" y="1904158"/>
            <a:chExt cx="4114800" cy="2526764"/>
          </a:xfrm>
        </p:grpSpPr>
        <p:grpSp>
          <p:nvGrpSpPr>
            <p:cNvPr id="15" name="Group 14"/>
            <p:cNvGrpSpPr/>
            <p:nvPr/>
          </p:nvGrpSpPr>
          <p:grpSpPr>
            <a:xfrm>
              <a:off x="2326211" y="1904158"/>
              <a:ext cx="4114800" cy="2526764"/>
              <a:chOff x="4713857" y="709053"/>
              <a:chExt cx="3657600" cy="1945587"/>
            </a:xfrm>
          </p:grpSpPr>
          <p:grpSp>
            <p:nvGrpSpPr>
              <p:cNvPr id="22" name="Group 21"/>
              <p:cNvGrpSpPr/>
              <p:nvPr/>
            </p:nvGrpSpPr>
            <p:grpSpPr>
              <a:xfrm>
                <a:off x="4713857" y="810265"/>
                <a:ext cx="3657600" cy="1844375"/>
                <a:chOff x="4713857" y="810265"/>
                <a:chExt cx="3657600" cy="1844375"/>
              </a:xfrm>
            </p:grpSpPr>
            <p:grpSp>
              <p:nvGrpSpPr>
                <p:cNvPr id="29" name="Group 5"/>
                <p:cNvGrpSpPr>
                  <a:grpSpLocks/>
                </p:cNvGrpSpPr>
                <p:nvPr/>
              </p:nvGrpSpPr>
              <p:grpSpPr bwMode="auto">
                <a:xfrm>
                  <a:off x="4713857" y="810265"/>
                  <a:ext cx="3657600" cy="1828800"/>
                  <a:chOff x="4959" y="1095"/>
                  <a:chExt cx="2730" cy="1497"/>
                </a:xfrm>
              </p:grpSpPr>
              <p:sp>
                <p:nvSpPr>
                  <p:cNvPr id="34" name="AutoShape 4"/>
                  <p:cNvSpPr>
                    <a:spLocks noChangeAspect="1" noChangeArrowheads="1" noTextEdit="1"/>
                  </p:cNvSpPr>
                  <p:nvPr/>
                </p:nvSpPr>
                <p:spPr bwMode="auto">
                  <a:xfrm>
                    <a:off x="5013" y="1095"/>
                    <a:ext cx="2676" cy="149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grpSp>
                <p:nvGrpSpPr>
                  <p:cNvPr id="35" name="Group 206"/>
                  <p:cNvGrpSpPr>
                    <a:grpSpLocks/>
                  </p:cNvGrpSpPr>
                  <p:nvPr/>
                </p:nvGrpSpPr>
                <p:grpSpPr bwMode="auto">
                  <a:xfrm>
                    <a:off x="4959" y="1095"/>
                    <a:ext cx="2676" cy="1497"/>
                    <a:chOff x="4959" y="1095"/>
                    <a:chExt cx="2676" cy="1497"/>
                  </a:xfrm>
                </p:grpSpPr>
                <p:sp>
                  <p:nvSpPr>
                    <p:cNvPr id="1085" name="Rectangle 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4959" y="1095"/>
                      <a:ext cx="2676" cy="149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86" name="Rectangle 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447" y="1249"/>
                      <a:ext cx="1950" cy="1136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87" name="Line 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447" y="1931"/>
                      <a:ext cx="1951" cy="0"/>
                    </a:xfrm>
                    <a:prstGeom prst="line">
                      <a:avLst/>
                    </a:prstGeom>
                    <a:noFill/>
                    <a:ln w="1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88" name="Line 9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610" y="1931"/>
                      <a:ext cx="0" cy="32"/>
                    </a:xfrm>
                    <a:prstGeom prst="line">
                      <a:avLst/>
                    </a:prstGeom>
                    <a:noFill/>
                    <a:ln w="1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89" name="Line 11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936" y="1931"/>
                      <a:ext cx="0" cy="32"/>
                    </a:xfrm>
                    <a:prstGeom prst="line">
                      <a:avLst/>
                    </a:prstGeom>
                    <a:noFill/>
                    <a:ln w="1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90" name="Line 13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261" y="1931"/>
                      <a:ext cx="0" cy="32"/>
                    </a:xfrm>
                    <a:prstGeom prst="line">
                      <a:avLst/>
                    </a:prstGeom>
                    <a:noFill/>
                    <a:ln w="1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91" name="Line 1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587" y="1931"/>
                      <a:ext cx="0" cy="32"/>
                    </a:xfrm>
                    <a:prstGeom prst="line">
                      <a:avLst/>
                    </a:prstGeom>
                    <a:noFill/>
                    <a:ln w="1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92" name="Line 1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912" y="1931"/>
                      <a:ext cx="0" cy="32"/>
                    </a:xfrm>
                    <a:prstGeom prst="line">
                      <a:avLst/>
                    </a:prstGeom>
                    <a:noFill/>
                    <a:ln w="1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93" name="Line 19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7238" y="1931"/>
                      <a:ext cx="0" cy="32"/>
                    </a:xfrm>
                    <a:prstGeom prst="line">
                      <a:avLst/>
                    </a:prstGeom>
                    <a:noFill/>
                    <a:ln w="1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94" name="Line 21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5447" y="1249"/>
                      <a:ext cx="0" cy="1136"/>
                    </a:xfrm>
                    <a:prstGeom prst="line">
                      <a:avLst/>
                    </a:prstGeom>
                    <a:noFill/>
                    <a:ln w="1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95" name="Line 22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415" y="2385"/>
                      <a:ext cx="32" cy="0"/>
                    </a:xfrm>
                    <a:prstGeom prst="line">
                      <a:avLst/>
                    </a:prstGeom>
                    <a:noFill/>
                    <a:ln w="1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96" name="Rectangle 2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298" y="2337"/>
                      <a:ext cx="80" cy="116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-2</a:t>
                      </a:r>
                      <a:endParaRPr kumimoji="0" 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097" name="Line 24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415" y="2158"/>
                      <a:ext cx="32" cy="0"/>
                    </a:xfrm>
                    <a:prstGeom prst="line">
                      <a:avLst/>
                    </a:prstGeom>
                    <a:noFill/>
                    <a:ln w="1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98" name="Rectangle 2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298" y="2110"/>
                      <a:ext cx="80" cy="116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-1</a:t>
                      </a:r>
                      <a:endParaRPr kumimoji="0" 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099" name="Line 26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415" y="1931"/>
                      <a:ext cx="32" cy="0"/>
                    </a:xfrm>
                    <a:prstGeom prst="line">
                      <a:avLst/>
                    </a:prstGeom>
                    <a:noFill/>
                    <a:ln w="1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00" name="Rectangle 2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330" y="1882"/>
                      <a:ext cx="48" cy="116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</a:t>
                      </a:r>
                      <a:endParaRPr kumimoji="0" 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101" name="Line 28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415" y="1703"/>
                      <a:ext cx="32" cy="0"/>
                    </a:xfrm>
                    <a:prstGeom prst="line">
                      <a:avLst/>
                    </a:prstGeom>
                    <a:noFill/>
                    <a:ln w="1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02" name="Rectangle 2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330" y="1655"/>
                      <a:ext cx="48" cy="116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</a:t>
                      </a:r>
                      <a:endParaRPr kumimoji="0" 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103" name="Line 30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415" y="1476"/>
                      <a:ext cx="32" cy="0"/>
                    </a:xfrm>
                    <a:prstGeom prst="line">
                      <a:avLst/>
                    </a:prstGeom>
                    <a:noFill/>
                    <a:ln w="1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04" name="Rectangle 3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330" y="1428"/>
                      <a:ext cx="48" cy="116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</a:t>
                      </a:r>
                      <a:endParaRPr kumimoji="0" 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105" name="Line 32"/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5415" y="1249"/>
                      <a:ext cx="32" cy="0"/>
                    </a:xfrm>
                    <a:prstGeom prst="line">
                      <a:avLst/>
                    </a:prstGeom>
                    <a:noFill/>
                    <a:ln w="1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06" name="Rectangle 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330" y="1200"/>
                      <a:ext cx="48" cy="116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3</a:t>
                      </a:r>
                      <a:endParaRPr kumimoji="0" lang="en-US" sz="1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107" name="Oval 3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564" y="191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08" name="Oval 3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632" y="191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09" name="Oval 3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598" y="200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10" name="Oval 3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598" y="196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11" name="Oval 3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666" y="190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12" name="Oval 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598" y="187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13" name="Oval 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564" y="186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14" name="Oval 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564" y="194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15" name="Oval 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598" y="191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16" name="Oval 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529" y="189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17" name="Line 4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502" y="1931"/>
                      <a:ext cx="215" cy="0"/>
                    </a:xfrm>
                    <a:prstGeom prst="line">
                      <a:avLst/>
                    </a:prstGeom>
                    <a:noFill/>
                    <a:ln w="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18" name="Oval 4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9" y="194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19" name="Oval 4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3" y="179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20" name="Oval 4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6" y="180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21" name="Oval 4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33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22" name="Oval 4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38" y="180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23" name="Oval 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49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24" name="Oval 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42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25" name="Oval 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38" y="158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26" name="Oval 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148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27" name="Oval 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81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28" name="Oval 5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48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29" name="Oval 5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1880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30" name="Oval 5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6" y="173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31" name="Oval 5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6" y="196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32" name="Oval 5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1" y="157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33" name="Oval 6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1" y="169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34" name="Oval 6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77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35" name="Oval 6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1" y="182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36" name="Oval 6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9" y="196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37" name="Oval 6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40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38" name="Oval 6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7" y="189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39" name="Oval 6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46" y="165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40" name="Oval 6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66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41" name="Oval 6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3" y="175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42" name="Oval 6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0" y="1626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43" name="Oval 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1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44" name="Oval 7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77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45" name="Oval 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78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46" name="Oval 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36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47" name="Oval 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32" y="165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48" name="Oval 7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7" y="172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49" name="Oval 7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2" y="175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50" name="Oval 7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71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51" name="Oval 7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4" y="186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52" name="Oval 7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32" y="158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53" name="Oval 8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5" y="189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54" name="Oval 8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68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55" name="Oval 8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4" y="160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56" name="Oval 8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67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57" name="Oval 8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98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58" name="Oval 8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0" y="153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59" name="Oval 8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163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60" name="Oval 8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74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61" name="Oval 8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6" y="175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62" name="Oval 8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170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63" name="Oval 9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1" y="175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64" name="Oval 9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1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65" name="Oval 9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81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66" name="Oval 9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2" y="164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67" name="Oval 9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60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68" name="Oval 9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74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69" name="Oval 9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6" y="162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70" name="Oval 9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46" y="183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71" name="Oval 9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79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72" name="Oval 9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31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73" name="Oval 10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0" y="1802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74" name="Oval 10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46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75" name="Oval 10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9" y="173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76" name="Oval 10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85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77" name="Oval 10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84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78" name="Oval 10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5" y="182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79" name="Oval 10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71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80" name="Oval 10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38" y="154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81" name="Oval 10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81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82" name="Oval 10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0" y="187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83" name="Oval 11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98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84" name="Oval 11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79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85" name="Oval 11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3" y="181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86" name="Oval 11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203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87" name="Oval 11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2" y="188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88" name="Oval 11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72" y="200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89" name="Oval 11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88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90" name="Oval 11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95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91" name="Oval 11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200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92" name="Oval 1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72" y="187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93" name="Oval 12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173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94" name="Oval 12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7" y="160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95" name="Oval 1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15" y="162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96" name="Oval 12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77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97" name="Oval 12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39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98" name="Oval 12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0" y="1699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99" name="Oval 12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7" y="169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00" name="Oval 12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0" y="169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01" name="Oval 12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3" y="169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02" name="Oval 12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7" y="180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03" name="Oval 13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55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04" name="Oval 13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66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05" name="Oval 13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5" y="152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06" name="Oval 1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0" y="1532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07" name="Oval 13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3" y="164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08" name="Oval 13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184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09" name="Oval 13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5" y="175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10" name="Oval 13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15" y="176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11" name="Oval 13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81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12" name="Oval 1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0" y="1902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13" name="Oval 1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15" y="154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14" name="Oval 1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146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15" name="Oval 1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84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16" name="Oval 1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1" y="187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17" name="Oval 14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79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18" name="Oval 14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8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19" name="Oval 14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0" y="1932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20" name="Oval 14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5" y="180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21" name="Oval 14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200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22" name="Oval 14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177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23" name="Oval 1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84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24" name="Oval 1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68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25" name="Oval 1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8" y="181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26" name="Oval 1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75" y="196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27" name="Oval 1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81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28" name="Oval 15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88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29" name="Oval 15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71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30" name="Oval 15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1" y="180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31" name="Oval 15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71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32" name="Oval 15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1" y="176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33" name="Oval 16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7" y="182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34" name="Oval 16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198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35" name="Oval 16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1" y="170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36" name="Oval 16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72" y="177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37" name="Oval 16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85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38" name="Oval 16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2" y="172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39" name="Oval 16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70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40" name="Oval 16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71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41" name="Oval 16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32" y="196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42" name="Oval 16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3" y="175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43" name="Oval 1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9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44" name="Oval 17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9" y="1819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45" name="Oval 1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15" y="190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46" name="Oval 1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4" y="179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47" name="Oval 1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8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48" name="Oval 17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0" y="175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49" name="Oval 17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9" y="168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50" name="Oval 17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8" y="168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51" name="Oval 17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5" y="187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52" name="Oval 17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71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53" name="Oval 18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2" y="179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54" name="Oval 18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84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55" name="Oval 18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194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56" name="Oval 18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1" y="180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57" name="Oval 18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1" y="187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58" name="Oval 18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7" y="192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59" name="Oval 18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812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60" name="Oval 18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8" y="175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61" name="Oval 18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75" y="173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62" name="Oval 18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0" y="183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63" name="Oval 19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7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64" name="Oval 19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3" y="172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65" name="Oval 19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67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66" name="Oval 19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0" y="164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67" name="Oval 19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63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68" name="Oval 19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75" y="162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69" name="Oval 19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4" y="182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70" name="Oval 19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6" y="183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71" name="Oval 19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0" y="173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72" name="Oval 19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679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73" name="Oval 20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46" y="193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74" name="Oval 20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75" y="191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75" name="Oval 20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38" y="196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76" name="Oval 20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9" y="187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77" name="Oval 20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72" y="166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78" name="Oval 20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81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</p:grpSp>
              <p:grpSp>
                <p:nvGrpSpPr>
                  <p:cNvPr id="36" name="Group 407"/>
                  <p:cNvGrpSpPr>
                    <a:grpSpLocks/>
                  </p:cNvGrpSpPr>
                  <p:nvPr/>
                </p:nvGrpSpPr>
                <p:grpSpPr bwMode="auto">
                  <a:xfrm>
                    <a:off x="5838" y="1383"/>
                    <a:ext cx="194" cy="746"/>
                    <a:chOff x="5838" y="1383"/>
                    <a:chExt cx="194" cy="746"/>
                  </a:xfrm>
                </p:grpSpPr>
                <p:sp>
                  <p:nvSpPr>
                    <p:cNvPr id="885" name="Oval 20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1" y="189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86" name="Oval 20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38" y="199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87" name="Oval 20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81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88" name="Oval 21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9" y="1751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89" name="Oval 21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787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90" name="Oval 21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4" y="188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91" name="Oval 21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84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92" name="Oval 21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32" y="180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93" name="Oval 21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4" y="172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94" name="Oval 21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81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95" name="Oval 21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75" y="184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96" name="Oval 21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7" y="165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97" name="Oval 2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79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98" name="Oval 22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4" y="186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99" name="Oval 22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15" y="196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00" name="Oval 2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0" y="182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01" name="Oval 22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4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02" name="Oval 22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5" y="162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03" name="Oval 22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7" y="164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04" name="Oval 22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79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05" name="Oval 22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55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06" name="Oval 22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7" y="175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07" name="Oval 22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1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08" name="Oval 23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55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09" name="Oval 23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1" y="1808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10" name="Oval 23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78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11" name="Oval 2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78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12" name="Oval 23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2" y="186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13" name="Oval 23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32" y="190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14" name="Oval 23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6" y="165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15" name="Oval 23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84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16" name="Oval 23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3" y="188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17" name="Oval 2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95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18" name="Oval 2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7" y="186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19" name="Oval 2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4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20" name="Oval 2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72" y="191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21" name="Oval 2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85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22" name="Oval 24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9" y="179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23" name="Oval 24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4" y="179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24" name="Oval 24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88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25" name="Oval 24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91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26" name="Oval 24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203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27" name="Oval 24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46" y="187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28" name="Oval 2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7" y="189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29" name="Oval 2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46" y="190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30" name="Oval 2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8" y="188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31" name="Oval 2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4" y="175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32" name="Oval 2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0" y="169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33" name="Oval 25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84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34" name="Oval 25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91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35" name="Oval 25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4" y="180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36" name="Oval 25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4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37" name="Oval 25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7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38" name="Oval 26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67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39" name="Oval 26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9" y="1643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40" name="Oval 26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75" y="170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41" name="Oval 26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71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42" name="Oval 26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81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43" name="Oval 26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5" y="169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44" name="Oval 26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4" y="160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45" name="Oval 26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1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46" name="Oval 26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8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47" name="Oval 26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15" y="170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48" name="Oval 2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422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49" name="Oval 27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145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50" name="Oval 2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6" y="157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51" name="Oval 2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60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52" name="Oval 2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7" y="162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53" name="Oval 27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68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54" name="Oval 27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166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55" name="Oval 27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73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56" name="Oval 27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3" y="179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57" name="Oval 27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1" y="164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58" name="Oval 28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138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59" name="Oval 28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15" y="193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60" name="Oval 28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1" y="157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61" name="Oval 28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0" y="165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62" name="Oval 28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0" y="1572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63" name="Oval 28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148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64" name="Oval 28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68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65" name="Oval 28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32" y="153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66" name="Oval 28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1" y="183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67" name="Oval 28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3" y="182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68" name="Oval 29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8" y="164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69" name="Oval 29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46" y="153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70" name="Oval 29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38" y="173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71" name="Oval 29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15" y="180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72" name="Oval 29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7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73" name="Oval 29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4" y="172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74" name="Oval 29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1" y="172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75" name="Oval 29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38" y="165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76" name="Oval 29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63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77" name="Oval 29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7" y="193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78" name="Oval 30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32" y="176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79" name="Oval 30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77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80" name="Oval 30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882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81" name="Oval 30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9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82" name="Oval 30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75" y="176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83" name="Oval 30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91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84" name="Oval 30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4" y="175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85" name="Oval 30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5" y="176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86" name="Oval 30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181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87" name="Oval 30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75" y="181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88" name="Oval 31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32" y="187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89" name="Oval 31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9" y="154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90" name="Oval 31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15" y="173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91" name="Oval 31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4" y="186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92" name="Oval 31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5" y="189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93" name="Oval 31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0" y="193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94" name="Oval 31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1" y="180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95" name="Oval 31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1" y="1734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96" name="Oval 31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70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97" name="Oval 3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88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98" name="Oval 32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1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99" name="Oval 32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41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00" name="Oval 3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67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01" name="Oval 32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7" y="173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02" name="Oval 32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0" y="176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03" name="Oval 32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72" y="170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04" name="Oval 32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81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05" name="Oval 32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1" y="161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06" name="Oval 32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0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07" name="Oval 32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77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08" name="Oval 33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2" y="182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09" name="Oval 33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6" y="169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10" name="Oval 33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32" y="173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11" name="Oval 3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0" y="187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12" name="Oval 33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84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13" name="Oval 33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98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14" name="Oval 33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72" y="196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15" name="Oval 33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1" y="187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16" name="Oval 33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8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17" name="Oval 3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4" y="181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18" name="Oval 3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38" y="191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19" name="Oval 3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2074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20" name="Oval 3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1" y="182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21" name="Oval 3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0" y="196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22" name="Oval 34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32" y="183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23" name="Oval 34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38" y="194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24" name="Oval 34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9" y="188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25" name="Oval 34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5" y="192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26" name="Oval 34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9" y="199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27" name="Oval 34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6" y="153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28" name="Oval 3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74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29" name="Oval 3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0" y="190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30" name="Oval 3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81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31" name="Oval 3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85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32" name="Oval 3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38" y="183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33" name="Oval 35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74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34" name="Oval 35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5" y="193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35" name="Oval 35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99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36" name="Oval 35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75" y="194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37" name="Oval 35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3" y="186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38" name="Oval 36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95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39" name="Oval 36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9" y="181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40" name="Oval 36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0" y="186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41" name="Oval 36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198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42" name="Oval 36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1" y="190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43" name="Oval 36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1" y="192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44" name="Oval 36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91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45" name="Oval 36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88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46" name="Oval 36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210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47" name="Oval 36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9" y="170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48" name="Oval 3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72" y="173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49" name="Oval 37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1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50" name="Oval 3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9" y="190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51" name="Oval 3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3" y="172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52" name="Oval 3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15" y="187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53" name="Oval 37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709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54" name="Oval 37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66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55" name="Oval 37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85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56" name="Oval 37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8" y="172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57" name="Oval 37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9" y="166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58" name="Oval 38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1" y="1537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59" name="Oval 38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38" y="170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60" name="Oval 38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5" y="160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61" name="Oval 38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67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62" name="Oval 38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46" y="176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63" name="Oval 38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5" y="169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64" name="Oval 38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2005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65" name="Oval 38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71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66" name="Oval 38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38" y="187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67" name="Oval 38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0" y="1762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68" name="Oval 39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7" y="180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69" name="Oval 39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81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70" name="Oval 39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72" y="163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71" name="Oval 39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81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72" name="Oval 39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6" y="190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73" name="Oval 39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712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74" name="Oval 39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51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75" name="Oval 39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6" y="176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76" name="Oval 39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72" y="181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77" name="Oval 39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173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78" name="Oval 40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1" y="192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79" name="Oval 40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0" y="196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80" name="Oval 40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0" y="183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81" name="Oval 40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85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82" name="Oval 40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1" y="193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83" name="Oval 40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81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84" name="Oval 40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95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</p:grpSp>
              <p:grpSp>
                <p:nvGrpSpPr>
                  <p:cNvPr id="37" name="Group 608"/>
                  <p:cNvGrpSpPr>
                    <a:grpSpLocks/>
                  </p:cNvGrpSpPr>
                  <p:nvPr/>
                </p:nvGrpSpPr>
                <p:grpSpPr bwMode="auto">
                  <a:xfrm>
                    <a:off x="5827" y="1369"/>
                    <a:ext cx="736" cy="724"/>
                    <a:chOff x="5827" y="1369"/>
                    <a:chExt cx="736" cy="724"/>
                  </a:xfrm>
                </p:grpSpPr>
                <p:sp>
                  <p:nvSpPr>
                    <p:cNvPr id="685" name="Oval 40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75" y="187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86" name="Oval 40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4" y="188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87" name="Oval 41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78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88" name="Oval 41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155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89" name="Oval 41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46" y="169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90" name="Oval 41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85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91" name="Oval 41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6" y="192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92" name="Oval 41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88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93" name="Oval 41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40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94" name="Oval 41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201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95" name="Oval 41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67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96" name="Oval 4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78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97" name="Oval 42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204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98" name="Oval 42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63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99" name="Oval 4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1" y="175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00" name="Oval 42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6" y="187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01" name="Oval 42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46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02" name="Oval 42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5" y="156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03" name="Oval 42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6" y="189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04" name="Oval 42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0" y="1607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05" name="Oval 42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84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06" name="Oval 42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74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07" name="Oval 43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5" y="164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08" name="Oval 43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2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09" name="Oval 43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46" y="180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10" name="Oval 4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32" y="170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11" name="Oval 43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1" y="164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12" name="Oval 43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6" y="187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13" name="Oval 43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46" y="173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14" name="Oval 43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98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15" name="Oval 43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1" y="169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16" name="Oval 4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181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17" name="Oval 4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4" y="188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18" name="Oval 4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0" y="192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19" name="Oval 4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3" y="186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20" name="Oval 4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1" y="189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21" name="Oval 44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1" y="173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22" name="Oval 44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91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23" name="Oval 44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9" y="183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24" name="Oval 44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75" y="166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25" name="Oval 44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1913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26" name="Oval 44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9" y="1862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27" name="Oval 4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9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28" name="Oval 4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1" y="193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29" name="Oval 4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187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30" name="Oval 4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859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31" name="Oval 4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159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32" name="Oval 45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46" y="196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33" name="Oval 45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36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34" name="Oval 45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2" y="169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35" name="Oval 45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200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36" name="Oval 45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59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37" name="Oval 46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3" y="168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38" name="Oval 46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0" y="189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39" name="Oval 46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170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40" name="Oval 46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5" y="173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41" name="Oval 46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4" y="164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42" name="Oval 46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7" y="169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43" name="Oval 46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72" y="158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44" name="Oval 46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72" y="154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45" name="Oval 46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9" y="176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46" name="Oval 46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1" y="162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47" name="Oval 4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50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48" name="Oval 47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6" y="173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49" name="Oval 4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9" y="172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50" name="Oval 4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81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51" name="Oval 4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74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52" name="Oval 47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163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53" name="Oval 47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68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54" name="Oval 47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0" y="162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55" name="Oval 47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15" y="165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56" name="Oval 47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39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57" name="Oval 48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70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58" name="Oval 48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1" y="161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59" name="Oval 48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155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60" name="Oval 48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85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61" name="Oval 48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70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62" name="Oval 48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84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63" name="Oval 48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44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64" name="Oval 48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1" y="1967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65" name="Oval 48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72" y="184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66" name="Oval 48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191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67" name="Oval 49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70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68" name="Oval 49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0" y="1806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69" name="Oval 49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3" y="189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70" name="Oval 49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7" y="157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71" name="Oval 49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55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72" name="Oval 49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5" y="180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73" name="Oval 49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84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74" name="Oval 49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207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75" name="Oval 49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5" y="182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76" name="Oval 49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8" y="179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77" name="Oval 50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5" y="165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78" name="Oval 50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715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79" name="Oval 50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63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80" name="Oval 50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1" y="175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81" name="Oval 50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74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82" name="Oval 50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38" y="162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83" name="Oval 50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72" y="137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84" name="Oval 50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512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85" name="Oval 50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0" y="180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86" name="Oval 50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8" y="186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87" name="Oval 51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1" y="187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88" name="Oval 51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0" y="165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89" name="Oval 51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15" y="183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90" name="Oval 51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4" y="175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91" name="Oval 51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63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92" name="Oval 51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7" y="176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93" name="Oval 51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9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94" name="Oval 51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75" y="200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95" name="Oval 51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7" y="187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96" name="Oval 5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1" y="165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97" name="Oval 52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72" y="194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98" name="Oval 52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41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799" name="Oval 5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1950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00" name="Oval 52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1" y="189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01" name="Oval 52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7" y="182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02" name="Oval 52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68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03" name="Oval 52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32" y="162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04" name="Oval 52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46" y="162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05" name="Oval 52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9" y="162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06" name="Oval 52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1770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07" name="Oval 53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6" y="161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08" name="Oval 53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1" y="165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09" name="Oval 53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166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10" name="Oval 5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67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11" name="Oval 53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139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12" name="Oval 53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7" y="153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13" name="Oval 53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72" y="145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14" name="Oval 53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75" y="154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15" name="Oval 53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55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16" name="Oval 5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59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17" name="Oval 5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1" y="182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18" name="Oval 5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6" y="193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19" name="Oval 5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2" y="160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20" name="Oval 5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64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21" name="Oval 54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78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22" name="Oval 54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9" y="158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23" name="Oval 54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84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24" name="Oval 54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1" y="161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25" name="Oval 54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6" y="169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26" name="Oval 54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4" y="164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27" name="Oval 5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1" y="173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28" name="Oval 5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4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29" name="Oval 5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38" y="176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30" name="Oval 5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0" y="172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31" name="Oval 5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71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32" name="Oval 55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1" y="169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33" name="Oval 55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79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34" name="Oval 55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4" y="169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35" name="Oval 55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72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36" name="Oval 55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68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37" name="Oval 56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68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38" name="Oval 56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48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39" name="Oval 56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0" y="1733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40" name="Oval 56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47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41" name="Oval 56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6" y="182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42" name="Oval 56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000" y="157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43" name="Oval 56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4" y="172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44" name="Oval 56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5" y="172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45" name="Oval 56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63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46" name="Oval 56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67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47" name="Oval 5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06" y="159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48" name="Oval 57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5" y="177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49" name="Oval 5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75" y="158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50" name="Oval 5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4" y="164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51" name="Oval 5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15" y="158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52" name="Oval 57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78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53" name="Oval 57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71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54" name="Oval 57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4" y="182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55" name="Oval 57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2" y="149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56" name="Oval 57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42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57" name="Oval 58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85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58" name="Oval 58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6" y="180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59" name="Oval 58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41" y="1842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60" name="Oval 58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79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61" name="Oval 58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58" y="195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62" name="Oval 58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93" y="164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63" name="Oval 58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32" y="193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64" name="Oval 58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5" y="187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65" name="Oval 58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3" y="160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66" name="Oval 58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54" y="168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67" name="Oval 59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89" y="159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68" name="Oval 59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3" y="168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69" name="Oval 59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846" y="157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70" name="Oval 59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24" y="168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71" name="Oval 59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5966" y="165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72" name="Line 59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5827" y="1765"/>
                      <a:ext cx="215" cy="0"/>
                    </a:xfrm>
                    <a:prstGeom prst="line">
                      <a:avLst/>
                    </a:prstGeom>
                    <a:noFill/>
                    <a:ln w="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73" name="Oval 59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249" y="201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74" name="Oval 59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283" y="199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75" name="Oval 59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249" y="196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76" name="Oval 59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317" y="190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77" name="Oval 60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249" y="192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78" name="Oval 60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180" y="190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79" name="Oval 60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249" y="188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80" name="Oval 60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249" y="176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81" name="Oval 60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283" y="192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82" name="Oval 60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215" y="191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83" name="Line 60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153" y="1931"/>
                      <a:ext cx="215" cy="0"/>
                    </a:xfrm>
                    <a:prstGeom prst="line">
                      <a:avLst/>
                    </a:prstGeom>
                    <a:noFill/>
                    <a:ln w="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84" name="Oval 60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3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</p:grpSp>
              <p:grpSp>
                <p:nvGrpSpPr>
                  <p:cNvPr id="38" name="Group 809"/>
                  <p:cNvGrpSpPr>
                    <a:grpSpLocks/>
                  </p:cNvGrpSpPr>
                  <p:nvPr/>
                </p:nvGrpSpPr>
                <p:grpSpPr bwMode="auto">
                  <a:xfrm>
                    <a:off x="6489" y="1651"/>
                    <a:ext cx="194" cy="544"/>
                    <a:chOff x="6489" y="1651"/>
                    <a:chExt cx="194" cy="544"/>
                  </a:xfrm>
                </p:grpSpPr>
                <p:sp>
                  <p:nvSpPr>
                    <p:cNvPr id="485" name="Oval 60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66" y="179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86" name="Oval 61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7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87" name="Oval 61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8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88" name="Oval 61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7" y="204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89" name="Oval 61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4" y="187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90" name="Oval 61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6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91" name="Oval 61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7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92" name="Oval 61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7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93" name="Oval 61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97" y="185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94" name="Oval 61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7" y="195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95" name="Oval 6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26" y="171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96" name="Oval 62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3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97" name="Oval 62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200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98" name="Oval 6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89" y="208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99" name="Oval 62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5" y="187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00" name="Oval 62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2" y="185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01" name="Oval 62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25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02" name="Oval 62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2" y="184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03" name="Oval 62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2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04" name="Oval 62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68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05" name="Oval 62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660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06" name="Oval 63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89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07" name="Oval 63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0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08" name="Oval 63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77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09" name="Oval 6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8" y="198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10" name="Oval 63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81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11" name="Oval 63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3" y="198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12" name="Oval 63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3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13" name="Oval 63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2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14" name="Oval 63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5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15" name="Oval 6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6" y="188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16" name="Oval 6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83" y="202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17" name="Oval 6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3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18" name="Oval 6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3" y="2021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19" name="Oval 6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52" y="2049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20" name="Oval 64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89" y="199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21" name="Oval 64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3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22" name="Oval 64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5" y="195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23" name="Oval 64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70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24" name="Oval 64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4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25" name="Oval 64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8" y="204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26" name="Oval 6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4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27" name="Oval 6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12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28" name="Oval 6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206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29" name="Oval 6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60" y="208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30" name="Oval 6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4" y="1841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31" name="Oval 65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60" y="185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32" name="Oval 65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9" y="187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33" name="Oval 65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26" y="196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34" name="Oval 65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6" y="195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35" name="Oval 65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8" y="207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36" name="Oval 66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57" y="206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37" name="Oval 66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2139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38" name="Oval 66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211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39" name="Oval 66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4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40" name="Oval 66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50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41" name="Oval 66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5" y="187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42" name="Oval 66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92" y="206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43" name="Oval 66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2" y="192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44" name="Oval 66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8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45" name="Oval 66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7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46" name="Oval 6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4" y="204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47" name="Oval 67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1" y="198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48" name="Oval 6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4" y="1985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49" name="Oval 6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2" y="205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50" name="Oval 6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1" y="198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51" name="Oval 67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200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52" name="Oval 67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97" y="191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53" name="Oval 67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57" y="177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54" name="Oval 67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26" y="202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55" name="Oval 67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4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56" name="Oval 68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8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57" name="Oval 68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201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58" name="Oval 68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74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59" name="Oval 68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5" y="201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60" name="Oval 68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31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61" name="Oval 68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0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62" name="Oval 68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4" y="195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63" name="Oval 68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89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64" name="Oval 68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5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65" name="Oval 68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23" y="192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66" name="Oval 69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7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67" name="Oval 69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4" y="198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68" name="Oval 69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89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69" name="Oval 69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3" y="184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70" name="Oval 69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4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71" name="Oval 69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0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72" name="Oval 69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7" y="207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73" name="Oval 69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4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74" name="Oval 69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83" y="196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75" name="Oval 69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7" y="196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76" name="Oval 70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3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77" name="Oval 70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97" y="188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78" name="Oval 70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52" y="1752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79" name="Oval 70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73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80" name="Oval 70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85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81" name="Oval 70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1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82" name="Oval 70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09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83" name="Oval 70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7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84" name="Oval 70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89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85" name="Oval 70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7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86" name="Oval 71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3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87" name="Oval 71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0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88" name="Oval 71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0" y="187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89" name="Oval 71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74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90" name="Oval 71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66" y="192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91" name="Oval 71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7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92" name="Oval 71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7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93" name="Oval 71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89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94" name="Oval 71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5" y="195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95" name="Oval 7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2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96" name="Oval 72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4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97" name="Oval 72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5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98" name="Oval 7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1" y="178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599" name="Oval 72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3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00" name="Oval 72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87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01" name="Oval 72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9" y="183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02" name="Oval 72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81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03" name="Oval 72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92" y="196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04" name="Oval 72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87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05" name="Oval 72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2" y="191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06" name="Oval 73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82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07" name="Oval 73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23" y="171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08" name="Oval 73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4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09" name="Oval 7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4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10" name="Oval 73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0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11" name="Oval 73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5" y="183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12" name="Oval 73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4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13" name="Oval 73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4" y="183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14" name="Oval 73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65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15" name="Oval 7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786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16" name="Oval 7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5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17" name="Oval 7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6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18" name="Oval 7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210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19" name="Oval 7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2" y="207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20" name="Oval 74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2" y="188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21" name="Oval 74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89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22" name="Oval 74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3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23" name="Oval 74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26" y="176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24" name="Oval 74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97" y="207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25" name="Oval 74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209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26" name="Oval 7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6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27" name="Oval 7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92" y="209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28" name="Oval 7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86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29" name="Oval 7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6" y="188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30" name="Oval 7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4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31" name="Oval 75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200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32" name="Oval 75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2069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33" name="Oval 75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1" y="207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34" name="Oval 75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200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35" name="Oval 75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26" y="208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36" name="Oval 76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7" y="201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37" name="Oval 76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217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38" name="Oval 76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8" y="201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39" name="Oval 76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4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40" name="Oval 76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206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41" name="Oval 76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4" y="201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42" name="Oval 76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74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43" name="Oval 76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3" y="1880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44" name="Oval 76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4" y="187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45" name="Oval 76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3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46" name="Oval 7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81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47" name="Oval 77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34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48" name="Oval 7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88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49" name="Oval 7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0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50" name="Oval 7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4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51" name="Oval 77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7" y="179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52" name="Oval 77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83" y="185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53" name="Oval 77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3" y="184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54" name="Oval 77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7" y="185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55" name="Oval 77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2" y="188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56" name="Oval 78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89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57" name="Oval 78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9" y="201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58" name="Oval 78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4" y="191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59" name="Oval 78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5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60" name="Oval 78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203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61" name="Oval 78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7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62" name="Oval 78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3" y="195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63" name="Oval 78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60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64" name="Oval 78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6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65" name="Oval 78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2" y="196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66" name="Oval 79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2" y="179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67" name="Oval 79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52" y="188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68" name="Oval 79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9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69" name="Oval 79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0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70" name="Oval 79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89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71" name="Oval 79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6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72" name="Oval 79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3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73" name="Oval 79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7" y="175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74" name="Oval 79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8" y="184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75" name="Oval 79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86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76" name="Oval 80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23" y="185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77" name="Oval 80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7" y="191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78" name="Oval 80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92" y="181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79" name="Oval 80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83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80" name="Oval 80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1" y="188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81" name="Oval 80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7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82" name="Oval 80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200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83" name="Oval 80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6" y="204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684" name="Oval 80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7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</p:grpSp>
              <p:grpSp>
                <p:nvGrpSpPr>
                  <p:cNvPr id="39" name="Group 1010"/>
                  <p:cNvGrpSpPr>
                    <a:grpSpLocks/>
                  </p:cNvGrpSpPr>
                  <p:nvPr/>
                </p:nvGrpSpPr>
                <p:grpSpPr bwMode="auto">
                  <a:xfrm>
                    <a:off x="6489" y="1651"/>
                    <a:ext cx="194" cy="551"/>
                    <a:chOff x="6489" y="1651"/>
                    <a:chExt cx="194" cy="551"/>
                  </a:xfrm>
                </p:grpSpPr>
                <p:sp>
                  <p:nvSpPr>
                    <p:cNvPr id="285" name="Oval 81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83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86" name="Oval 81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26" y="188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87" name="Oval 81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97" y="202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88" name="Oval 81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4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89" name="Oval 81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6" y="191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90" name="Oval 81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1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91" name="Oval 81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2" y="202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92" name="Oval 81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6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93" name="Oval 81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6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94" name="Oval 8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1" y="201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95" name="Oval 82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206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96" name="Oval 82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4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97" name="Oval 8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9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98" name="Oval 82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0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99" name="Oval 82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4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00" name="Oval 82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89" y="185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01" name="Oval 82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9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02" name="Oval 82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6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03" name="Oval 82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9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04" name="Oval 82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200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05" name="Oval 83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201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06" name="Oval 83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2" y="204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07" name="Oval 83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9" y="198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08" name="Oval 8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7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09" name="Oval 83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52" y="1919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10" name="Oval 83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8" y="195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11" name="Oval 83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200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12" name="Oval 83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50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13" name="Oval 83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85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14" name="Oval 8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89" y="188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15" name="Oval 8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89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16" name="Oval 8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2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17" name="Oval 8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57" y="188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18" name="Oval 8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6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19" name="Oval 84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72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20" name="Oval 84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23" y="176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21" name="Oval 84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23" y="188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22" name="Oval 84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2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23" name="Oval 84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82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24" name="Oval 84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86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25" name="Oval 8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0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26" name="Oval 8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0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27" name="Oval 8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6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28" name="Oval 8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65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29" name="Oval 8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65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30" name="Oval 85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7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31" name="Oval 85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6" y="184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32" name="Oval 85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52" y="1792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33" name="Oval 85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86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34" name="Oval 85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68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35" name="Oval 86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1" y="184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36" name="Oval 86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60" y="180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37" name="Oval 86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7" y="188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38" name="Oval 86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97" y="179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39" name="Oval 86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85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40" name="Oval 86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84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41" name="Oval 86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85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42" name="Oval 86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66" y="196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43" name="Oval 86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211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44" name="Oval 86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57" y="171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45" name="Oval 8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8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46" name="Oval 87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66" y="188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47" name="Oval 8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0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48" name="Oval 8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0" y="183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49" name="Oval 8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8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50" name="Oval 87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4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51" name="Oval 87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2" y="195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52" name="Oval 87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84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53" name="Oval 87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23" y="202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54" name="Oval 87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87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55" name="Oval 88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1" y="185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56" name="Oval 88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203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57" name="Oval 88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7" y="192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58" name="Oval 88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6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59" name="Oval 88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34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60" name="Oval 88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60" y="188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61" name="Oval 88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4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62" name="Oval 88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57" y="209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63" name="Oval 88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0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64" name="Oval 88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26" y="192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65" name="Oval 89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8" y="204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66" name="Oval 89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4" y="201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67" name="Oval 89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4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68" name="Oval 89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77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69" name="Oval 89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6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70" name="Oval 89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3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71" name="Oval 89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4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72" name="Oval 89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6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73" name="Oval 89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7" y="188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74" name="Oval 89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31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75" name="Oval 90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83" y="192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76" name="Oval 90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4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77" name="Oval 90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4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78" name="Oval 90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89" y="171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79" name="Oval 90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26" y="180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80" name="Oval 90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52" y="185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81" name="Oval 90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201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82" name="Oval 90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85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83" name="Oval 90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92" y="177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84" name="Oval 90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60" y="171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85" name="Oval 91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4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86" name="Oval 91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89" y="205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87" name="Oval 91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3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88" name="Oval 91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60" y="205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89" name="Oval 91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69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90" name="Oval 91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7" y="205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91" name="Oval 91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200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92" name="Oval 91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3" y="204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93" name="Oval 91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8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94" name="Oval 9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23" y="205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95" name="Oval 92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203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96" name="Oval 92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32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97" name="Oval 9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5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98" name="Oval 92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9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399" name="Oval 92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206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00" name="Oval 92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0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01" name="Oval 92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200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02" name="Oval 92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23" y="208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03" name="Oval 92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1" y="195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04" name="Oval 92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8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05" name="Oval 93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57" y="167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06" name="Oval 93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8" y="198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07" name="Oval 93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1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08" name="Oval 9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83" y="205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09" name="Oval 93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200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10" name="Oval 93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85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11" name="Oval 93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5" y="198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12" name="Oval 93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57" y="202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13" name="Oval 93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3" y="1988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14" name="Oval 9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70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15" name="Oval 9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7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16" name="Oval 9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89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17" name="Oval 9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7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18" name="Oval 9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209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19" name="Oval 94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60" y="202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20" name="Oval 94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1" y="204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21" name="Oval 94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5" y="184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22" name="Oval 94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83" y="199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23" name="Oval 94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200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24" name="Oval 94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66" y="199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25" name="Oval 9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3" y="1959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26" name="Oval 9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5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27" name="Oval 9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4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28" name="Oval 9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8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29" name="Oval 9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2179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30" name="Oval 95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81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31" name="Oval 95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52" y="196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32" name="Oval 95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4" y="1876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33" name="Oval 95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97" y="205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34" name="Oval 95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4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35" name="Oval 96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6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36" name="Oval 96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8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37" name="Oval 96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86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38" name="Oval 96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6" y="201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39" name="Oval 96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1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40" name="Oval 96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1" y="195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41" name="Oval 96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83" y="188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42" name="Oval 96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7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43" name="Oval 96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8" y="191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44" name="Oval 96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89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45" name="Oval 9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3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46" name="Oval 97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66" y="185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47" name="Oval 9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8" y="202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48" name="Oval 9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6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49" name="Oval 9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9" y="195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50" name="Oval 97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7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51" name="Oval 97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2" y="199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52" name="Oval 97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7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53" name="Oval 97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3" y="191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54" name="Oval 97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52" y="2023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55" name="Oval 98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7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56" name="Oval 98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2004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57" name="Oval 98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89" y="192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58" name="Oval 98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6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59" name="Oval 98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86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60" name="Oval 98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200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61" name="Oval 98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0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62" name="Oval 98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86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63" name="Oval 98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26" y="205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64" name="Oval 98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210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65" name="Oval 99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9" y="191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66" name="Oval 99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6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67" name="Oval 99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83" y="176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68" name="Oval 99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60" y="199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69" name="Oval 99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4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70" name="Oval 99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3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71" name="Oval 99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60" y="192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72" name="Oval 99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52" y="199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73" name="Oval 99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8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74" name="Oval 99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57" y="196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75" name="Oval 100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7" y="202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76" name="Oval 100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78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77" name="Oval 100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3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78" name="Oval 100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5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79" name="Oval 100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209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80" name="Oval 100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92" y="199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81" name="Oval 100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97" y="175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82" name="Oval 100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6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83" name="Oval 100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0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484" name="Oval 100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0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</p:grpSp>
              <p:grpSp>
                <p:nvGrpSpPr>
                  <p:cNvPr id="40" name="Group 1211"/>
                  <p:cNvGrpSpPr>
                    <a:grpSpLocks/>
                  </p:cNvGrpSpPr>
                  <p:nvPr/>
                </p:nvGrpSpPr>
                <p:grpSpPr bwMode="auto">
                  <a:xfrm>
                    <a:off x="6478" y="1545"/>
                    <a:ext cx="479" cy="630"/>
                    <a:chOff x="6478" y="1545"/>
                    <a:chExt cx="479" cy="630"/>
                  </a:xfrm>
                </p:grpSpPr>
                <p:sp>
                  <p:nvSpPr>
                    <p:cNvPr id="85" name="Oval 101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6" y="195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6" name="Oval 101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8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7" name="Oval 101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5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8" name="Oval 101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8" y="179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89" name="Oval 101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89" y="180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0" name="Oval 101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8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1" name="Oval 101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8" y="191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2" name="Oval 101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92" y="188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3" name="Oval 10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203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4" name="Oval 102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23" y="180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5" name="Oval 102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3" y="1788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6" name="Oval 10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4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7" name="Oval 102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215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8" name="Oval 102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89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99" name="Oval 102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6" y="191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0" name="Oval 102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210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1" name="Oval 102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7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2" name="Oval 102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52" y="2076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3" name="Oval 102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0" y="201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4" name="Oval 103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2" y="198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5" name="Oval 103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6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6" name="Oval 103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97" y="199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7" name="Oval 10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7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8" name="Oval 103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66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09" name="Oval 103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86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0" name="Oval 103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7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1" name="Oval 103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1" y="204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2" name="Oval 103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78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3" name="Oval 10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0" y="198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4" name="Oval 10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6" y="198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5" name="Oval 10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4" y="198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6" name="Oval 10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0" y="203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7" name="Oval 10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9" y="203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8" name="Oval 104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200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19" name="Oval 104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0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0" name="Oval 104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4" y="201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1" name="Oval 104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69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2" name="Oval 104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3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3" name="Oval 104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83" y="207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4" name="Oval 10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4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5" name="Oval 10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3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6" name="Oval 10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214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7" name="Oval 10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5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8" name="Oval 10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5" y="201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29" name="Oval 105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3" y="1916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30" name="Oval 105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2004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31" name="Oval 105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48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32" name="Oval 105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85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33" name="Oval 105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9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34" name="Oval 106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3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35" name="Oval 106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6" y="184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36" name="Oval 106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203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37" name="Oval 106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3" y="201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38" name="Oval 106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82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39" name="Oval 106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82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40" name="Oval 106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83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41" name="Oval 106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92" y="203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42" name="Oval 106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92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43" name="Oval 106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5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44" name="Oval 10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92" y="167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45" name="Oval 107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4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46" name="Oval 10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3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47" name="Oval 10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3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48" name="Oval 10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2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49" name="Oval 107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7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50" name="Oval 107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60" y="176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51" name="Oval 107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200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52" name="Oval 107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3" y="204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53" name="Oval 107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67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54" name="Oval 108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83" y="179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55" name="Oval 108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66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56" name="Oval 108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3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57" name="Oval 108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5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58" name="Oval 108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97" y="196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59" name="Oval 108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86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60" name="Oval 108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57" y="185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61" name="Oval 108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200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62" name="Oval 108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200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63" name="Oval 108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6" y="2041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64" name="Oval 109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7" y="198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65" name="Oval 109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51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66" name="Oval 109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8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67" name="Oval 109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6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68" name="Oval 109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6" y="202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69" name="Oval 109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6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70" name="Oval 109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60" y="196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71" name="Oval 109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8" y="185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72" name="Oval 109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69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73" name="Oval 109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4" y="184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74" name="Oval 110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7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75" name="Oval 110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203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76" name="Oval 110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23" y="199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77" name="Oval 110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4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78" name="Oval 110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3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79" name="Oval 110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2" y="2018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80" name="Oval 110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3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81" name="Oval 110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9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82" name="Oval 110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7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83" name="Oval 110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0" y="195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84" name="Oval 111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4" y="195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85" name="Oval 111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89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86" name="Oval 111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4" y="1913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87" name="Oval 111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89" y="176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88" name="Oval 111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51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89" name="Oval 111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66" y="202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90" name="Oval 111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3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91" name="Oval 111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7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92" name="Oval 111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0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93" name="Oval 111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0" y="191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94" name="Oval 112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0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95" name="Oval 112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8" y="188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96" name="Oval 112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1" y="191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97" name="Oval 112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4" y="1915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98" name="Oval 112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2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199" name="Oval 112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0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00" name="Oval 112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13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01" name="Oval 112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4" y="1956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02" name="Oval 112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0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03" name="Oval 112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59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04" name="Oval 113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85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05" name="Oval 113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860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06" name="Oval 113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7" y="184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07" name="Oval 11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1" y="191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08" name="Oval 113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0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09" name="Oval 113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97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10" name="Oval 113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0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11" name="Oval 113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6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12" name="Oval 113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78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13" name="Oval 113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89" y="202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14" name="Oval 114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26" y="199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15" name="Oval 114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5" y="191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16" name="Oval 114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4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17" name="Oval 114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40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18" name="Oval 114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04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19" name="Oval 114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5" y="203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20" name="Oval 114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6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21" name="Oval 114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67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22" name="Oval 114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12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23" name="Oval 114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66" y="205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24" name="Oval 115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54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25" name="Oval 11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35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26" name="Oval 115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92" y="172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27" name="Oval 115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1" y="202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28" name="Oval 115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6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29" name="Oval 115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2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30" name="Oval 115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58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31" name="Oval 115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48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32" name="Oval 115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92" y="192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33" name="Oval 115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4" y="203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34" name="Oval 116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2002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35" name="Oval 116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0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36" name="Oval 116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92" y="185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37" name="Oval 116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42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38" name="Oval 116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201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39" name="Oval 116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87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40" name="Oval 116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8" y="187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41" name="Oval 116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32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42" name="Oval 116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5" y="1986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43" name="Oval 116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7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44" name="Oval 11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23" y="196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45" name="Oval 117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2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46" name="Oval 11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6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47" name="Oval 11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97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48" name="Oval 11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5" y="191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49" name="Oval 117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7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50" name="Oval 117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1" y="1879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51" name="Oval 117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66" y="207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52" name="Oval 117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87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53" name="Oval 117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71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54" name="Oval 118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57" y="1997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55" name="Oval 118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06" y="1968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56" name="Oval 118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8" y="196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57" name="Oval 118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4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58" name="Oval 118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73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59" name="Oval 118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7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60" name="Oval 118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895"/>
                      <a:ext cx="22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61" name="Oval 118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46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62" name="Oval 118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26" y="185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63" name="Oval 118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87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64" name="Oval 119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3" y="1882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65" name="Oval 119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89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66" name="Oval 119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6" y="1987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67" name="Oval 119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57" y="181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68" name="Oval 119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57" y="192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69" name="Oval 119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75" y="1937"/>
                      <a:ext cx="22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70" name="Oval 119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17" y="199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71" name="Oval 119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32" y="1760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72" name="Oval 119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09" y="196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73" name="Oval 119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43" y="1925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74" name="Oval 120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66" y="176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75" name="Oval 120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89" y="196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76" name="Oval 120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964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77" name="Oval 120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540" y="1899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78" name="Line 120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6478" y="1942"/>
                      <a:ext cx="216" cy="0"/>
                    </a:xfrm>
                    <a:prstGeom prst="line">
                      <a:avLst/>
                    </a:prstGeom>
                    <a:noFill/>
                    <a:ln w="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79" name="Oval 120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866" y="175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80" name="Oval 120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900" y="1773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81" name="Oval 120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900" y="1682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82" name="Oval 120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900" y="211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83" name="Oval 120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866" y="2081"/>
                      <a:ext cx="23" cy="23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  <p:sp>
                  <p:nvSpPr>
                    <p:cNvPr id="284" name="Oval 121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934" y="2114"/>
                      <a:ext cx="23" cy="22"/>
                    </a:xfrm>
                    <a:prstGeom prst="ellipse">
                      <a:avLst/>
                    </a:prstGeom>
                    <a:solidFill>
                      <a:srgbClr val="000000"/>
                    </a:solidFill>
                    <a:ln w="1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IN" dirty="0"/>
                    </a:p>
                  </p:txBody>
                </p:sp>
              </p:grpSp>
              <p:sp>
                <p:nvSpPr>
                  <p:cNvPr id="41" name="Line 1212"/>
                  <p:cNvSpPr>
                    <a:spLocks noChangeShapeType="1"/>
                  </p:cNvSpPr>
                  <p:nvPr/>
                </p:nvSpPr>
                <p:spPr bwMode="auto">
                  <a:xfrm>
                    <a:off x="6804" y="1932"/>
                    <a:ext cx="215" cy="0"/>
                  </a:xfrm>
                  <a:prstGeom prst="line">
                    <a:avLst/>
                  </a:prstGeom>
                  <a:noFill/>
                  <a:ln w="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42" name="Oval 1213"/>
                  <p:cNvSpPr>
                    <a:spLocks noChangeArrowheads="1"/>
                  </p:cNvSpPr>
                  <p:nvPr/>
                </p:nvSpPr>
                <p:spPr bwMode="auto">
                  <a:xfrm>
                    <a:off x="7294" y="1591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43" name="Oval 1214"/>
                  <p:cNvSpPr>
                    <a:spLocks noChangeArrowheads="1"/>
                  </p:cNvSpPr>
                  <p:nvPr/>
                </p:nvSpPr>
                <p:spPr bwMode="auto">
                  <a:xfrm>
                    <a:off x="7157" y="1589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44" name="Oval 1215"/>
                  <p:cNvSpPr>
                    <a:spLocks noChangeArrowheads="1"/>
                  </p:cNvSpPr>
                  <p:nvPr/>
                </p:nvSpPr>
                <p:spPr bwMode="auto">
                  <a:xfrm>
                    <a:off x="7157" y="175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45" name="Oval 1216"/>
                  <p:cNvSpPr>
                    <a:spLocks noChangeArrowheads="1"/>
                  </p:cNvSpPr>
                  <p:nvPr/>
                </p:nvSpPr>
                <p:spPr bwMode="auto">
                  <a:xfrm>
                    <a:off x="7157" y="162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46" name="Oval 1217"/>
                  <p:cNvSpPr>
                    <a:spLocks noChangeArrowheads="1"/>
                  </p:cNvSpPr>
                  <p:nvPr/>
                </p:nvSpPr>
                <p:spPr bwMode="auto">
                  <a:xfrm>
                    <a:off x="7226" y="1660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47" name="Oval 1218"/>
                  <p:cNvSpPr>
                    <a:spLocks noChangeArrowheads="1"/>
                  </p:cNvSpPr>
                  <p:nvPr/>
                </p:nvSpPr>
                <p:spPr bwMode="auto">
                  <a:xfrm>
                    <a:off x="7226" y="171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48" name="Oval 1219"/>
                  <p:cNvSpPr>
                    <a:spLocks noChangeArrowheads="1"/>
                  </p:cNvSpPr>
                  <p:nvPr/>
                </p:nvSpPr>
                <p:spPr bwMode="auto">
                  <a:xfrm>
                    <a:off x="7226" y="158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49" name="Oval 1220"/>
                  <p:cNvSpPr>
                    <a:spLocks noChangeArrowheads="1"/>
                  </p:cNvSpPr>
                  <p:nvPr/>
                </p:nvSpPr>
                <p:spPr bwMode="auto">
                  <a:xfrm>
                    <a:off x="7260" y="170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50" name="Oval 1221"/>
                  <p:cNvSpPr>
                    <a:spLocks noChangeArrowheads="1"/>
                  </p:cNvSpPr>
                  <p:nvPr/>
                </p:nvSpPr>
                <p:spPr bwMode="auto">
                  <a:xfrm>
                    <a:off x="7226" y="162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51" name="Oval 1222"/>
                  <p:cNvSpPr>
                    <a:spLocks noChangeArrowheads="1"/>
                  </p:cNvSpPr>
                  <p:nvPr/>
                </p:nvSpPr>
                <p:spPr bwMode="auto">
                  <a:xfrm>
                    <a:off x="7226" y="136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52" name="Oval 1223"/>
                  <p:cNvSpPr>
                    <a:spLocks noChangeArrowheads="1"/>
                  </p:cNvSpPr>
                  <p:nvPr/>
                </p:nvSpPr>
                <p:spPr bwMode="auto">
                  <a:xfrm>
                    <a:off x="7260" y="152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53" name="Oval 1224"/>
                  <p:cNvSpPr>
                    <a:spLocks noChangeArrowheads="1"/>
                  </p:cNvSpPr>
                  <p:nvPr/>
                </p:nvSpPr>
                <p:spPr bwMode="auto">
                  <a:xfrm>
                    <a:off x="7260" y="164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54" name="Oval 1225"/>
                  <p:cNvSpPr>
                    <a:spLocks noChangeArrowheads="1"/>
                  </p:cNvSpPr>
                  <p:nvPr/>
                </p:nvSpPr>
                <p:spPr bwMode="auto">
                  <a:xfrm>
                    <a:off x="7226" y="178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55" name="Oval 1226"/>
                  <p:cNvSpPr>
                    <a:spLocks noChangeArrowheads="1"/>
                  </p:cNvSpPr>
                  <p:nvPr/>
                </p:nvSpPr>
                <p:spPr bwMode="auto">
                  <a:xfrm>
                    <a:off x="7191" y="1608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56" name="Oval 1227"/>
                  <p:cNvSpPr>
                    <a:spLocks noChangeArrowheads="1"/>
                  </p:cNvSpPr>
                  <p:nvPr/>
                </p:nvSpPr>
                <p:spPr bwMode="auto">
                  <a:xfrm>
                    <a:off x="7260" y="160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57" name="Oval 1228"/>
                  <p:cNvSpPr>
                    <a:spLocks noChangeArrowheads="1"/>
                  </p:cNvSpPr>
                  <p:nvPr/>
                </p:nvSpPr>
                <p:spPr bwMode="auto">
                  <a:xfrm>
                    <a:off x="7294" y="175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58" name="Oval 1229"/>
                  <p:cNvSpPr>
                    <a:spLocks noChangeArrowheads="1"/>
                  </p:cNvSpPr>
                  <p:nvPr/>
                </p:nvSpPr>
                <p:spPr bwMode="auto">
                  <a:xfrm>
                    <a:off x="7191" y="165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59" name="Oval 1230"/>
                  <p:cNvSpPr>
                    <a:spLocks noChangeArrowheads="1"/>
                  </p:cNvSpPr>
                  <p:nvPr/>
                </p:nvSpPr>
                <p:spPr bwMode="auto">
                  <a:xfrm>
                    <a:off x="7191" y="157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60" name="Oval 1231"/>
                  <p:cNvSpPr>
                    <a:spLocks noChangeArrowheads="1"/>
                  </p:cNvSpPr>
                  <p:nvPr/>
                </p:nvSpPr>
                <p:spPr bwMode="auto">
                  <a:xfrm>
                    <a:off x="7191" y="150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61" name="Oval 1232"/>
                  <p:cNvSpPr>
                    <a:spLocks noChangeArrowheads="1"/>
                  </p:cNvSpPr>
                  <p:nvPr/>
                </p:nvSpPr>
                <p:spPr bwMode="auto">
                  <a:xfrm>
                    <a:off x="7191" y="170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62" name="Oval 1233"/>
                  <p:cNvSpPr>
                    <a:spLocks noChangeArrowheads="1"/>
                  </p:cNvSpPr>
                  <p:nvPr/>
                </p:nvSpPr>
                <p:spPr bwMode="auto">
                  <a:xfrm>
                    <a:off x="7191" y="1770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63" name="Oval 1234"/>
                  <p:cNvSpPr>
                    <a:spLocks noChangeArrowheads="1"/>
                  </p:cNvSpPr>
                  <p:nvPr/>
                </p:nvSpPr>
                <p:spPr bwMode="auto">
                  <a:xfrm>
                    <a:off x="7243" y="191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64" name="Oval 1235"/>
                  <p:cNvSpPr>
                    <a:spLocks noChangeArrowheads="1"/>
                  </p:cNvSpPr>
                  <p:nvPr/>
                </p:nvSpPr>
                <p:spPr bwMode="auto">
                  <a:xfrm>
                    <a:off x="7260" y="193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65" name="Oval 1236"/>
                  <p:cNvSpPr>
                    <a:spLocks noChangeArrowheads="1"/>
                  </p:cNvSpPr>
                  <p:nvPr/>
                </p:nvSpPr>
                <p:spPr bwMode="auto">
                  <a:xfrm>
                    <a:off x="7226" y="1533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66" name="Oval 1237"/>
                  <p:cNvSpPr>
                    <a:spLocks noChangeArrowheads="1"/>
                  </p:cNvSpPr>
                  <p:nvPr/>
                </p:nvSpPr>
                <p:spPr bwMode="auto">
                  <a:xfrm>
                    <a:off x="7226" y="2077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67" name="Oval 1238"/>
                  <p:cNvSpPr>
                    <a:spLocks noChangeArrowheads="1"/>
                  </p:cNvSpPr>
                  <p:nvPr/>
                </p:nvSpPr>
                <p:spPr bwMode="auto">
                  <a:xfrm>
                    <a:off x="7191" y="184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68" name="Oval 1239"/>
                  <p:cNvSpPr>
                    <a:spLocks noChangeArrowheads="1"/>
                  </p:cNvSpPr>
                  <p:nvPr/>
                </p:nvSpPr>
                <p:spPr bwMode="auto">
                  <a:xfrm>
                    <a:off x="7260" y="179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69" name="Oval 1240"/>
                  <p:cNvSpPr>
                    <a:spLocks noChangeArrowheads="1"/>
                  </p:cNvSpPr>
                  <p:nvPr/>
                </p:nvSpPr>
                <p:spPr bwMode="auto">
                  <a:xfrm>
                    <a:off x="7191" y="1970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70" name="Oval 1241"/>
                  <p:cNvSpPr>
                    <a:spLocks noChangeArrowheads="1"/>
                  </p:cNvSpPr>
                  <p:nvPr/>
                </p:nvSpPr>
                <p:spPr bwMode="auto">
                  <a:xfrm>
                    <a:off x="7260" y="175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71" name="Oval 1242"/>
                  <p:cNvSpPr>
                    <a:spLocks noChangeArrowheads="1"/>
                  </p:cNvSpPr>
                  <p:nvPr/>
                </p:nvSpPr>
                <p:spPr bwMode="auto">
                  <a:xfrm>
                    <a:off x="7191" y="193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72" name="Oval 1243"/>
                  <p:cNvSpPr>
                    <a:spLocks noChangeArrowheads="1"/>
                  </p:cNvSpPr>
                  <p:nvPr/>
                </p:nvSpPr>
                <p:spPr bwMode="auto">
                  <a:xfrm>
                    <a:off x="7226" y="194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73" name="Oval 1244"/>
                  <p:cNvSpPr>
                    <a:spLocks noChangeArrowheads="1"/>
                  </p:cNvSpPr>
                  <p:nvPr/>
                </p:nvSpPr>
                <p:spPr bwMode="auto">
                  <a:xfrm>
                    <a:off x="7157" y="192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74" name="Oval 1245"/>
                  <p:cNvSpPr>
                    <a:spLocks noChangeArrowheads="1"/>
                  </p:cNvSpPr>
                  <p:nvPr/>
                </p:nvSpPr>
                <p:spPr bwMode="auto">
                  <a:xfrm>
                    <a:off x="7226" y="181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75" name="Oval 1246"/>
                  <p:cNvSpPr>
                    <a:spLocks noChangeArrowheads="1"/>
                  </p:cNvSpPr>
                  <p:nvPr/>
                </p:nvSpPr>
                <p:spPr bwMode="auto">
                  <a:xfrm>
                    <a:off x="7226" y="2002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76" name="Oval 1247"/>
                  <p:cNvSpPr>
                    <a:spLocks noChangeArrowheads="1"/>
                  </p:cNvSpPr>
                  <p:nvPr/>
                </p:nvSpPr>
                <p:spPr bwMode="auto">
                  <a:xfrm>
                    <a:off x="7260" y="183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77" name="Oval 1248"/>
                  <p:cNvSpPr>
                    <a:spLocks noChangeArrowheads="1"/>
                  </p:cNvSpPr>
                  <p:nvPr/>
                </p:nvSpPr>
                <p:spPr bwMode="auto">
                  <a:xfrm>
                    <a:off x="7226" y="1860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78" name="Oval 1249"/>
                  <p:cNvSpPr>
                    <a:spLocks noChangeArrowheads="1"/>
                  </p:cNvSpPr>
                  <p:nvPr/>
                </p:nvSpPr>
                <p:spPr bwMode="auto">
                  <a:xfrm>
                    <a:off x="7260" y="204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79" name="Oval 1250"/>
                  <p:cNvSpPr>
                    <a:spLocks noChangeArrowheads="1"/>
                  </p:cNvSpPr>
                  <p:nvPr/>
                </p:nvSpPr>
                <p:spPr bwMode="auto">
                  <a:xfrm>
                    <a:off x="7294" y="169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80" name="Oval 1251"/>
                  <p:cNvSpPr>
                    <a:spLocks noChangeArrowheads="1"/>
                  </p:cNvSpPr>
                  <p:nvPr/>
                </p:nvSpPr>
                <p:spPr bwMode="auto">
                  <a:xfrm>
                    <a:off x="7294" y="1933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81" name="Oval 1252"/>
                  <p:cNvSpPr>
                    <a:spLocks noChangeArrowheads="1"/>
                  </p:cNvSpPr>
                  <p:nvPr/>
                </p:nvSpPr>
                <p:spPr bwMode="auto">
                  <a:xfrm>
                    <a:off x="7157" y="183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82" name="Line 1253"/>
                  <p:cNvSpPr>
                    <a:spLocks noChangeShapeType="1"/>
                  </p:cNvSpPr>
                  <p:nvPr/>
                </p:nvSpPr>
                <p:spPr bwMode="auto">
                  <a:xfrm>
                    <a:off x="7130" y="1761"/>
                    <a:ext cx="215" cy="0"/>
                  </a:xfrm>
                  <a:prstGeom prst="line">
                    <a:avLst/>
                  </a:prstGeom>
                  <a:noFill/>
                  <a:ln w="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83" name="Rectangle 1254"/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4689" y="1740"/>
                    <a:ext cx="942" cy="23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algn="ctr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000" b="1" dirty="0" smtClean="0">
                        <a:solidFill>
                          <a:srgbClr val="000000"/>
                        </a:solidFill>
                        <a:latin typeface="Times New Roman" pitchFamily="18" charset="0"/>
                        <a:cs typeface="Arial" pitchFamily="34" charset="0"/>
                      </a:rPr>
                      <a:t>BCCIP</a:t>
                    </a:r>
                    <a:r>
                      <a:rPr kumimoji="0" lang="en-US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rPr>
                      <a:t> transcript</a:t>
                    </a:r>
                  </a:p>
                  <a:p>
                    <a:pPr algn="ctr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kumimoji="0" lang="en-US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rPr>
                      <a:t>(Log</a:t>
                    </a:r>
                    <a:r>
                      <a:rPr kumimoji="0" lang="en-US" sz="1000" b="1" i="0" u="none" strike="noStrike" cap="none" normalizeH="0" baseline="-2500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rPr>
                      <a:t>2</a:t>
                    </a:r>
                    <a:r>
                      <a:rPr kumimoji="0" lang="en-US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rPr>
                      <a:t> ratio)</a:t>
                    </a:r>
                    <a:endParaRPr kumimoji="0" lang="en-US" sz="10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4" name="Rectangle 1255"/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5205" y="1751"/>
                    <a:ext cx="24" cy="11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sz="100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rPr>
                      <a:t> </a:t>
                    </a:r>
                    <a:endParaRPr kumimoji="0" lang="en-US" sz="100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30" name="TextBox 29"/>
                <p:cNvSpPr txBox="1"/>
                <p:nvPr/>
              </p:nvSpPr>
              <p:spPr>
                <a:xfrm>
                  <a:off x="5454090" y="2446093"/>
                  <a:ext cx="2504212" cy="2085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Times New Roman" pitchFamily="18" charset="0"/>
                      <a:cs typeface="Times New Roman" pitchFamily="18" charset="0"/>
                    </a:rPr>
                    <a:t>  TCGA i            TCGA ii           GSE22866 </a:t>
                  </a:r>
                  <a:endParaRPr lang="en-IN" sz="10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cxnSp>
              <p:nvCxnSpPr>
                <p:cNvPr id="31" name="Straight Connector 30"/>
                <p:cNvCxnSpPr/>
                <p:nvPr/>
              </p:nvCxnSpPr>
              <p:spPr>
                <a:xfrm>
                  <a:off x="5433945" y="2441289"/>
                  <a:ext cx="72517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Connector 31"/>
                <p:cNvCxnSpPr/>
                <p:nvPr/>
              </p:nvCxnSpPr>
              <p:spPr>
                <a:xfrm>
                  <a:off x="7191132" y="2441289"/>
                  <a:ext cx="72517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Straight Connector 32"/>
                <p:cNvCxnSpPr/>
                <p:nvPr/>
              </p:nvCxnSpPr>
              <p:spPr>
                <a:xfrm>
                  <a:off x="6304028" y="2441289"/>
                  <a:ext cx="72517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3" name="Right Bracket 22"/>
              <p:cNvSpPr/>
              <p:nvPr/>
            </p:nvSpPr>
            <p:spPr>
              <a:xfrm rot="16200000">
                <a:off x="5738372" y="720059"/>
                <a:ext cx="64008" cy="457200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IN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5565903" y="709053"/>
                <a:ext cx="415498" cy="2556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***</a:t>
                </a:r>
                <a:endParaRPr lang="en-IN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" name="Right Bracket 24"/>
              <p:cNvSpPr/>
              <p:nvPr/>
            </p:nvSpPr>
            <p:spPr>
              <a:xfrm rot="16200000">
                <a:off x="6656997" y="720059"/>
                <a:ext cx="64008" cy="457200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IN" dirty="0"/>
              </a:p>
            </p:txBody>
          </p:sp>
          <p:sp>
            <p:nvSpPr>
              <p:cNvPr id="26" name="Right Bracket 25"/>
              <p:cNvSpPr/>
              <p:nvPr/>
            </p:nvSpPr>
            <p:spPr>
              <a:xfrm rot="16200000">
                <a:off x="7504871" y="720059"/>
                <a:ext cx="64008" cy="457200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IN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6542688" y="714313"/>
                <a:ext cx="298480" cy="2272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ns</a:t>
                </a:r>
                <a:endParaRPr lang="en-IN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7406070" y="709053"/>
                <a:ext cx="261610" cy="2556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*</a:t>
                </a:r>
                <a:endParaRPr lang="en-IN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16" name="Rectangle 13"/>
            <p:cNvSpPr>
              <a:spLocks noChangeArrowheads="1"/>
            </p:cNvSpPr>
            <p:nvPr/>
          </p:nvSpPr>
          <p:spPr bwMode="auto">
            <a:xfrm>
              <a:off x="5089253" y="3863168"/>
              <a:ext cx="367251" cy="2510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Control </a:t>
              </a:r>
            </a:p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Brain</a:t>
              </a:r>
              <a:endParaRPr kumimoji="0" lang="en-US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Rectangle 13"/>
            <p:cNvSpPr>
              <a:spLocks noChangeArrowheads="1"/>
            </p:cNvSpPr>
            <p:nvPr/>
          </p:nvSpPr>
          <p:spPr bwMode="auto">
            <a:xfrm>
              <a:off x="4111522" y="3863168"/>
              <a:ext cx="367251" cy="2510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Control </a:t>
              </a:r>
            </a:p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Brain</a:t>
              </a:r>
              <a:endParaRPr kumimoji="0" lang="en-US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Rectangle 13"/>
            <p:cNvSpPr>
              <a:spLocks noChangeArrowheads="1"/>
            </p:cNvSpPr>
            <p:nvPr/>
          </p:nvSpPr>
          <p:spPr bwMode="auto">
            <a:xfrm>
              <a:off x="3122998" y="3863168"/>
              <a:ext cx="367420" cy="251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Control </a:t>
              </a:r>
            </a:p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Brain</a:t>
              </a:r>
              <a:endParaRPr kumimoji="0" lang="en-US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Rectangle 15"/>
            <p:cNvSpPr>
              <a:spLocks noChangeArrowheads="1"/>
            </p:cNvSpPr>
            <p:nvPr/>
          </p:nvSpPr>
          <p:spPr bwMode="auto">
            <a:xfrm>
              <a:off x="3661433" y="3863168"/>
              <a:ext cx="275946" cy="132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GBM</a:t>
              </a:r>
              <a:endPara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Rectangle 19"/>
            <p:cNvSpPr>
              <a:spLocks noChangeArrowheads="1"/>
            </p:cNvSpPr>
            <p:nvPr/>
          </p:nvSpPr>
          <p:spPr bwMode="auto">
            <a:xfrm>
              <a:off x="4656067" y="3863168"/>
              <a:ext cx="275946" cy="132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GBM</a:t>
              </a:r>
              <a:endPara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Rectangle 23"/>
            <p:cNvSpPr>
              <a:spLocks noChangeArrowheads="1"/>
            </p:cNvSpPr>
            <p:nvPr/>
          </p:nvSpPr>
          <p:spPr bwMode="auto">
            <a:xfrm>
              <a:off x="5632133" y="3863168"/>
              <a:ext cx="275946" cy="132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GBM</a:t>
              </a:r>
              <a:endParaRPr kumimoji="0" lang="en-US" sz="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279" name="Group 1278"/>
          <p:cNvGrpSpPr/>
          <p:nvPr/>
        </p:nvGrpSpPr>
        <p:grpSpPr>
          <a:xfrm>
            <a:off x="4648200" y="1664907"/>
            <a:ext cx="2743200" cy="2286000"/>
            <a:chOff x="2761060" y="1595196"/>
            <a:chExt cx="3200400" cy="2535402"/>
          </a:xfrm>
        </p:grpSpPr>
        <p:grpSp>
          <p:nvGrpSpPr>
            <p:cNvPr id="1280" name="Group 1279"/>
            <p:cNvGrpSpPr/>
            <p:nvPr/>
          </p:nvGrpSpPr>
          <p:grpSpPr>
            <a:xfrm>
              <a:off x="2761060" y="1595196"/>
              <a:ext cx="3200400" cy="2535402"/>
              <a:chOff x="1675099" y="2480480"/>
              <a:chExt cx="2742590" cy="1947650"/>
            </a:xfrm>
          </p:grpSpPr>
          <p:grpSp>
            <p:nvGrpSpPr>
              <p:cNvPr id="1285" name="Group 694"/>
              <p:cNvGrpSpPr>
                <a:grpSpLocks noChangeAspect="1"/>
              </p:cNvGrpSpPr>
              <p:nvPr/>
            </p:nvGrpSpPr>
            <p:grpSpPr bwMode="auto">
              <a:xfrm>
                <a:off x="1675099" y="2480480"/>
                <a:ext cx="2742590" cy="1828800"/>
                <a:chOff x="1757" y="1597"/>
                <a:chExt cx="2245" cy="1497"/>
              </a:xfrm>
            </p:grpSpPr>
            <p:sp>
              <p:nvSpPr>
                <p:cNvPr id="1293" name="AutoShape 693"/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1757" y="1597"/>
                  <a:ext cx="2245" cy="14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grpSp>
              <p:nvGrpSpPr>
                <p:cNvPr id="1294" name="Group 895"/>
                <p:cNvGrpSpPr>
                  <a:grpSpLocks/>
                </p:cNvGrpSpPr>
                <p:nvPr/>
              </p:nvGrpSpPr>
              <p:grpSpPr bwMode="auto">
                <a:xfrm>
                  <a:off x="1757" y="1597"/>
                  <a:ext cx="2245" cy="1497"/>
                  <a:chOff x="1757" y="1597"/>
                  <a:chExt cx="2245" cy="1497"/>
                </a:xfrm>
              </p:grpSpPr>
              <p:sp>
                <p:nvSpPr>
                  <p:cNvPr id="1778" name="Rectangle 695"/>
                  <p:cNvSpPr>
                    <a:spLocks noChangeArrowheads="1"/>
                  </p:cNvSpPr>
                  <p:nvPr/>
                </p:nvSpPr>
                <p:spPr bwMode="auto">
                  <a:xfrm>
                    <a:off x="1757" y="1597"/>
                    <a:ext cx="2245" cy="149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79" name="Rectangle 696"/>
                  <p:cNvSpPr>
                    <a:spLocks noChangeArrowheads="1"/>
                  </p:cNvSpPr>
                  <p:nvPr/>
                </p:nvSpPr>
                <p:spPr bwMode="auto">
                  <a:xfrm>
                    <a:off x="2252" y="1751"/>
                    <a:ext cx="1512" cy="114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80" name="Line 697"/>
                  <p:cNvSpPr>
                    <a:spLocks noChangeShapeType="1"/>
                  </p:cNvSpPr>
                  <p:nvPr/>
                </p:nvSpPr>
                <p:spPr bwMode="auto">
                  <a:xfrm>
                    <a:off x="2252" y="2322"/>
                    <a:ext cx="1513" cy="0"/>
                  </a:xfrm>
                  <a:prstGeom prst="line">
                    <a:avLst/>
                  </a:prstGeom>
                  <a:noFill/>
                  <a:ln w="1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81" name="Line 698"/>
                  <p:cNvSpPr>
                    <a:spLocks noChangeShapeType="1"/>
                  </p:cNvSpPr>
                  <p:nvPr/>
                </p:nvSpPr>
                <p:spPr bwMode="auto">
                  <a:xfrm>
                    <a:off x="2441" y="2322"/>
                    <a:ext cx="0" cy="32"/>
                  </a:xfrm>
                  <a:prstGeom prst="line">
                    <a:avLst/>
                  </a:prstGeom>
                  <a:noFill/>
                  <a:ln w="1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82" name="Line 700"/>
                  <p:cNvSpPr>
                    <a:spLocks noChangeShapeType="1"/>
                  </p:cNvSpPr>
                  <p:nvPr/>
                </p:nvSpPr>
                <p:spPr bwMode="auto">
                  <a:xfrm>
                    <a:off x="2818" y="2322"/>
                    <a:ext cx="0" cy="32"/>
                  </a:xfrm>
                  <a:prstGeom prst="line">
                    <a:avLst/>
                  </a:prstGeom>
                  <a:noFill/>
                  <a:ln w="1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83" name="Line 702"/>
                  <p:cNvSpPr>
                    <a:spLocks noChangeShapeType="1"/>
                  </p:cNvSpPr>
                  <p:nvPr/>
                </p:nvSpPr>
                <p:spPr bwMode="auto">
                  <a:xfrm>
                    <a:off x="3196" y="2322"/>
                    <a:ext cx="0" cy="32"/>
                  </a:xfrm>
                  <a:prstGeom prst="line">
                    <a:avLst/>
                  </a:prstGeom>
                  <a:noFill/>
                  <a:ln w="1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84" name="Line 704"/>
                  <p:cNvSpPr>
                    <a:spLocks noChangeShapeType="1"/>
                  </p:cNvSpPr>
                  <p:nvPr/>
                </p:nvSpPr>
                <p:spPr bwMode="auto">
                  <a:xfrm>
                    <a:off x="3573" y="2322"/>
                    <a:ext cx="0" cy="32"/>
                  </a:xfrm>
                  <a:prstGeom prst="line">
                    <a:avLst/>
                  </a:prstGeom>
                  <a:noFill/>
                  <a:ln w="1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85" name="Line 70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52" y="1751"/>
                    <a:ext cx="0" cy="1141"/>
                  </a:xfrm>
                  <a:prstGeom prst="line">
                    <a:avLst/>
                  </a:prstGeom>
                  <a:noFill/>
                  <a:ln w="1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86" name="Line 70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19" y="2892"/>
                    <a:ext cx="33" cy="0"/>
                  </a:xfrm>
                  <a:prstGeom prst="line">
                    <a:avLst/>
                  </a:prstGeom>
                  <a:noFill/>
                  <a:ln w="1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87" name="Rectangle 708"/>
                  <p:cNvSpPr>
                    <a:spLocks noChangeArrowheads="1"/>
                  </p:cNvSpPr>
                  <p:nvPr/>
                </p:nvSpPr>
                <p:spPr bwMode="auto">
                  <a:xfrm>
                    <a:off x="2093" y="2844"/>
                    <a:ext cx="88" cy="11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rPr>
                      <a:t>-3</a:t>
                    </a:r>
                    <a:endParaRPr kumimoji="0" lang="en-US" sz="18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788" name="Line 70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19" y="2702"/>
                    <a:ext cx="33" cy="0"/>
                  </a:xfrm>
                  <a:prstGeom prst="line">
                    <a:avLst/>
                  </a:prstGeom>
                  <a:noFill/>
                  <a:ln w="1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89" name="Rectangle 710"/>
                  <p:cNvSpPr>
                    <a:spLocks noChangeArrowheads="1"/>
                  </p:cNvSpPr>
                  <p:nvPr/>
                </p:nvSpPr>
                <p:spPr bwMode="auto">
                  <a:xfrm>
                    <a:off x="2093" y="2654"/>
                    <a:ext cx="88" cy="11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rPr>
                      <a:t>-2</a:t>
                    </a:r>
                    <a:endParaRPr kumimoji="0" lang="en-US" sz="18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790" name="Line 71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19" y="2512"/>
                    <a:ext cx="33" cy="0"/>
                  </a:xfrm>
                  <a:prstGeom prst="line">
                    <a:avLst/>
                  </a:prstGeom>
                  <a:noFill/>
                  <a:ln w="1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91" name="Rectangle 712"/>
                  <p:cNvSpPr>
                    <a:spLocks noChangeArrowheads="1"/>
                  </p:cNvSpPr>
                  <p:nvPr/>
                </p:nvSpPr>
                <p:spPr bwMode="auto">
                  <a:xfrm>
                    <a:off x="2093" y="2463"/>
                    <a:ext cx="88" cy="11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rPr>
                      <a:t>-1</a:t>
                    </a:r>
                    <a:endParaRPr kumimoji="0" lang="en-US" sz="18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792" name="Line 71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19" y="2322"/>
                    <a:ext cx="33" cy="0"/>
                  </a:xfrm>
                  <a:prstGeom prst="line">
                    <a:avLst/>
                  </a:prstGeom>
                  <a:noFill/>
                  <a:ln w="1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93" name="Rectangle 714"/>
                  <p:cNvSpPr>
                    <a:spLocks noChangeArrowheads="1"/>
                  </p:cNvSpPr>
                  <p:nvPr/>
                </p:nvSpPr>
                <p:spPr bwMode="auto">
                  <a:xfrm>
                    <a:off x="2129" y="2273"/>
                    <a:ext cx="52" cy="11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rPr>
                      <a:t>0</a:t>
                    </a:r>
                    <a:endParaRPr kumimoji="0" lang="en-US" sz="18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794" name="Line 71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19" y="2132"/>
                    <a:ext cx="33" cy="0"/>
                  </a:xfrm>
                  <a:prstGeom prst="line">
                    <a:avLst/>
                  </a:prstGeom>
                  <a:noFill/>
                  <a:ln w="1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95" name="Rectangle 716"/>
                  <p:cNvSpPr>
                    <a:spLocks noChangeArrowheads="1"/>
                  </p:cNvSpPr>
                  <p:nvPr/>
                </p:nvSpPr>
                <p:spPr bwMode="auto">
                  <a:xfrm>
                    <a:off x="2129" y="2083"/>
                    <a:ext cx="52" cy="11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rPr>
                      <a:t>1</a:t>
                    </a:r>
                    <a:endParaRPr kumimoji="0" lang="en-US" sz="18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796" name="Line 71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19" y="1941"/>
                    <a:ext cx="33" cy="0"/>
                  </a:xfrm>
                  <a:prstGeom prst="line">
                    <a:avLst/>
                  </a:prstGeom>
                  <a:noFill/>
                  <a:ln w="1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97" name="Rectangle 718"/>
                  <p:cNvSpPr>
                    <a:spLocks noChangeArrowheads="1"/>
                  </p:cNvSpPr>
                  <p:nvPr/>
                </p:nvSpPr>
                <p:spPr bwMode="auto">
                  <a:xfrm>
                    <a:off x="2129" y="1893"/>
                    <a:ext cx="52" cy="11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rPr>
                      <a:t>2</a:t>
                    </a:r>
                    <a:endParaRPr kumimoji="0" lang="en-US" sz="18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798" name="Line 71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219" y="1751"/>
                    <a:ext cx="33" cy="0"/>
                  </a:xfrm>
                  <a:prstGeom prst="line">
                    <a:avLst/>
                  </a:prstGeom>
                  <a:noFill/>
                  <a:ln w="11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99" name="Rectangle 720"/>
                  <p:cNvSpPr>
                    <a:spLocks noChangeArrowheads="1"/>
                  </p:cNvSpPr>
                  <p:nvPr/>
                </p:nvSpPr>
                <p:spPr bwMode="auto">
                  <a:xfrm>
                    <a:off x="2129" y="1703"/>
                    <a:ext cx="52" cy="11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rPr>
                      <a:t>3</a:t>
                    </a:r>
                    <a:endParaRPr kumimoji="0" lang="en-US" sz="18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00" name="Oval 721"/>
                  <p:cNvSpPr>
                    <a:spLocks noChangeArrowheads="1"/>
                  </p:cNvSpPr>
                  <p:nvPr/>
                </p:nvSpPr>
                <p:spPr bwMode="auto">
                  <a:xfrm>
                    <a:off x="2429" y="220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01" name="Oval 722"/>
                  <p:cNvSpPr>
                    <a:spLocks noChangeArrowheads="1"/>
                  </p:cNvSpPr>
                  <p:nvPr/>
                </p:nvSpPr>
                <p:spPr bwMode="auto">
                  <a:xfrm>
                    <a:off x="2395" y="231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02" name="Oval 723"/>
                  <p:cNvSpPr>
                    <a:spLocks noChangeArrowheads="1"/>
                  </p:cNvSpPr>
                  <p:nvPr/>
                </p:nvSpPr>
                <p:spPr bwMode="auto">
                  <a:xfrm>
                    <a:off x="2498" y="228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03" name="Oval 724"/>
                  <p:cNvSpPr>
                    <a:spLocks noChangeArrowheads="1"/>
                  </p:cNvSpPr>
                  <p:nvPr/>
                </p:nvSpPr>
                <p:spPr bwMode="auto">
                  <a:xfrm>
                    <a:off x="2463" y="231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04" name="Oval 725"/>
                  <p:cNvSpPr>
                    <a:spLocks noChangeArrowheads="1"/>
                  </p:cNvSpPr>
                  <p:nvPr/>
                </p:nvSpPr>
                <p:spPr bwMode="auto">
                  <a:xfrm>
                    <a:off x="2429" y="236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05" name="Oval 726"/>
                  <p:cNvSpPr>
                    <a:spLocks noChangeArrowheads="1"/>
                  </p:cNvSpPr>
                  <p:nvPr/>
                </p:nvSpPr>
                <p:spPr bwMode="auto">
                  <a:xfrm>
                    <a:off x="2395" y="234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06" name="Oval 727"/>
                  <p:cNvSpPr>
                    <a:spLocks noChangeArrowheads="1"/>
                  </p:cNvSpPr>
                  <p:nvPr/>
                </p:nvSpPr>
                <p:spPr bwMode="auto">
                  <a:xfrm>
                    <a:off x="2360" y="2286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07" name="Oval 728"/>
                  <p:cNvSpPr>
                    <a:spLocks noChangeArrowheads="1"/>
                  </p:cNvSpPr>
                  <p:nvPr/>
                </p:nvSpPr>
                <p:spPr bwMode="auto">
                  <a:xfrm>
                    <a:off x="2429" y="231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08" name="Oval 729"/>
                  <p:cNvSpPr>
                    <a:spLocks noChangeArrowheads="1"/>
                  </p:cNvSpPr>
                  <p:nvPr/>
                </p:nvSpPr>
                <p:spPr bwMode="auto">
                  <a:xfrm>
                    <a:off x="2463" y="234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09" name="Oval 730"/>
                  <p:cNvSpPr>
                    <a:spLocks noChangeArrowheads="1"/>
                  </p:cNvSpPr>
                  <p:nvPr/>
                </p:nvSpPr>
                <p:spPr bwMode="auto">
                  <a:xfrm>
                    <a:off x="2498" y="234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10" name="Line 731"/>
                  <p:cNvSpPr>
                    <a:spLocks noChangeShapeType="1"/>
                  </p:cNvSpPr>
                  <p:nvPr/>
                </p:nvSpPr>
                <p:spPr bwMode="auto">
                  <a:xfrm>
                    <a:off x="2315" y="2322"/>
                    <a:ext cx="251" cy="0"/>
                  </a:xfrm>
                  <a:prstGeom prst="line">
                    <a:avLst/>
                  </a:prstGeom>
                  <a:noFill/>
                  <a:ln w="5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11" name="Oval 732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7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12" name="Oval 733"/>
                  <p:cNvSpPr>
                    <a:spLocks noChangeArrowheads="1"/>
                  </p:cNvSpPr>
                  <p:nvPr/>
                </p:nvSpPr>
                <p:spPr bwMode="auto">
                  <a:xfrm>
                    <a:off x="2703" y="243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13" name="Oval 734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40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14" name="Oval 735"/>
                  <p:cNvSpPr>
                    <a:spLocks noChangeArrowheads="1"/>
                  </p:cNvSpPr>
                  <p:nvPr/>
                </p:nvSpPr>
                <p:spPr bwMode="auto">
                  <a:xfrm>
                    <a:off x="2764" y="242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15" name="Oval 736"/>
                  <p:cNvSpPr>
                    <a:spLocks noChangeArrowheads="1"/>
                  </p:cNvSpPr>
                  <p:nvPr/>
                </p:nvSpPr>
                <p:spPr bwMode="auto">
                  <a:xfrm>
                    <a:off x="2913" y="241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16" name="Oval 737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7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17" name="Oval 738"/>
                  <p:cNvSpPr>
                    <a:spLocks noChangeArrowheads="1"/>
                  </p:cNvSpPr>
                  <p:nvPr/>
                </p:nvSpPr>
                <p:spPr bwMode="auto">
                  <a:xfrm>
                    <a:off x="2805" y="230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18" name="Oval 739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40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19" name="Oval 740"/>
                  <p:cNvSpPr>
                    <a:spLocks noChangeArrowheads="1"/>
                  </p:cNvSpPr>
                  <p:nvPr/>
                </p:nvSpPr>
                <p:spPr bwMode="auto">
                  <a:xfrm>
                    <a:off x="2892" y="2421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20" name="Oval 741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9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21" name="Oval 742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03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22" name="Oval 743"/>
                  <p:cNvSpPr>
                    <a:spLocks noChangeArrowheads="1"/>
                  </p:cNvSpPr>
                  <p:nvPr/>
                </p:nvSpPr>
                <p:spPr bwMode="auto">
                  <a:xfrm>
                    <a:off x="2695" y="238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23" name="Oval 744"/>
                  <p:cNvSpPr>
                    <a:spLocks noChangeArrowheads="1"/>
                  </p:cNvSpPr>
                  <p:nvPr/>
                </p:nvSpPr>
                <p:spPr bwMode="auto">
                  <a:xfrm>
                    <a:off x="2805" y="2441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24" name="Oval 745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3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25" name="Oval 746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7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26" name="Oval 747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5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27" name="Oval 748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6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28" name="Oval 749"/>
                  <p:cNvSpPr>
                    <a:spLocks noChangeArrowheads="1"/>
                  </p:cNvSpPr>
                  <p:nvPr/>
                </p:nvSpPr>
                <p:spPr bwMode="auto">
                  <a:xfrm>
                    <a:off x="2849" y="244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29" name="Oval 750"/>
                  <p:cNvSpPr>
                    <a:spLocks noChangeArrowheads="1"/>
                  </p:cNvSpPr>
                  <p:nvPr/>
                </p:nvSpPr>
                <p:spPr bwMode="auto">
                  <a:xfrm>
                    <a:off x="2877" y="229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30" name="Oval 751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9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31" name="Oval 752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8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32" name="Oval 753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41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33" name="Oval 754"/>
                  <p:cNvSpPr>
                    <a:spLocks noChangeArrowheads="1"/>
                  </p:cNvSpPr>
                  <p:nvPr/>
                </p:nvSpPr>
                <p:spPr bwMode="auto">
                  <a:xfrm>
                    <a:off x="2803" y="241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34" name="Oval 755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81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35" name="Oval 756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402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36" name="Oval 757"/>
                  <p:cNvSpPr>
                    <a:spLocks noChangeArrowheads="1"/>
                  </p:cNvSpPr>
                  <p:nvPr/>
                </p:nvSpPr>
                <p:spPr bwMode="auto">
                  <a:xfrm>
                    <a:off x="2810" y="234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37" name="Oval 758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40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38" name="Oval 759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7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39" name="Oval 760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28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40" name="Oval 761"/>
                  <p:cNvSpPr>
                    <a:spLocks noChangeArrowheads="1"/>
                  </p:cNvSpPr>
                  <p:nvPr/>
                </p:nvSpPr>
                <p:spPr bwMode="auto">
                  <a:xfrm>
                    <a:off x="2764" y="234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41" name="Oval 762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2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42" name="Oval 763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6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43" name="Oval 764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40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44" name="Oval 765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0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45" name="Oval 766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9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46" name="Oval 767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65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47" name="Oval 768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5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48" name="Oval 769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5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49" name="Oval 770"/>
                  <p:cNvSpPr>
                    <a:spLocks noChangeArrowheads="1"/>
                  </p:cNvSpPr>
                  <p:nvPr/>
                </p:nvSpPr>
                <p:spPr bwMode="auto">
                  <a:xfrm>
                    <a:off x="2768" y="234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50" name="Oval 771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7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51" name="Oval 772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8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52" name="Oval 773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28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53" name="Oval 774"/>
                  <p:cNvSpPr>
                    <a:spLocks noChangeArrowheads="1"/>
                  </p:cNvSpPr>
                  <p:nvPr/>
                </p:nvSpPr>
                <p:spPr bwMode="auto">
                  <a:xfrm>
                    <a:off x="2884" y="238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54" name="Oval 775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40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55" name="Oval 776"/>
                  <p:cNvSpPr>
                    <a:spLocks noChangeArrowheads="1"/>
                  </p:cNvSpPr>
                  <p:nvPr/>
                </p:nvSpPr>
                <p:spPr bwMode="auto">
                  <a:xfrm>
                    <a:off x="2798" y="238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56" name="Oval 777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3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57" name="Oval 778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3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58" name="Oval 779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38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59" name="Oval 780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5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60" name="Oval 781"/>
                  <p:cNvSpPr>
                    <a:spLocks noChangeArrowheads="1"/>
                  </p:cNvSpPr>
                  <p:nvPr/>
                </p:nvSpPr>
                <p:spPr bwMode="auto">
                  <a:xfrm>
                    <a:off x="2876" y="2382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61" name="Oval 782"/>
                  <p:cNvSpPr>
                    <a:spLocks noChangeArrowheads="1"/>
                  </p:cNvSpPr>
                  <p:nvPr/>
                </p:nvSpPr>
                <p:spPr bwMode="auto">
                  <a:xfrm>
                    <a:off x="2798" y="234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62" name="Oval 783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3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63" name="Oval 784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5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64" name="Oval 785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6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65" name="Oval 786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74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66" name="Oval 787"/>
                  <p:cNvSpPr>
                    <a:spLocks noChangeArrowheads="1"/>
                  </p:cNvSpPr>
                  <p:nvPr/>
                </p:nvSpPr>
                <p:spPr bwMode="auto">
                  <a:xfrm>
                    <a:off x="2876" y="234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67" name="Oval 788"/>
                  <p:cNvSpPr>
                    <a:spLocks noChangeArrowheads="1"/>
                  </p:cNvSpPr>
                  <p:nvPr/>
                </p:nvSpPr>
                <p:spPr bwMode="auto">
                  <a:xfrm>
                    <a:off x="2703" y="228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68" name="Oval 789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412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69" name="Oval 790"/>
                  <p:cNvSpPr>
                    <a:spLocks noChangeArrowheads="1"/>
                  </p:cNvSpPr>
                  <p:nvPr/>
                </p:nvSpPr>
                <p:spPr bwMode="auto">
                  <a:xfrm>
                    <a:off x="2879" y="234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70" name="Oval 791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6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71" name="Oval 792"/>
                  <p:cNvSpPr>
                    <a:spLocks noChangeArrowheads="1"/>
                  </p:cNvSpPr>
                  <p:nvPr/>
                </p:nvSpPr>
                <p:spPr bwMode="auto">
                  <a:xfrm>
                    <a:off x="2815" y="234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72" name="Oval 793"/>
                  <p:cNvSpPr>
                    <a:spLocks noChangeArrowheads="1"/>
                  </p:cNvSpPr>
                  <p:nvPr/>
                </p:nvSpPr>
                <p:spPr bwMode="auto">
                  <a:xfrm>
                    <a:off x="2877" y="234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73" name="Oval 794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2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74" name="Oval 795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6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75" name="Oval 796"/>
                  <p:cNvSpPr>
                    <a:spLocks noChangeArrowheads="1"/>
                  </p:cNvSpPr>
                  <p:nvPr/>
                </p:nvSpPr>
                <p:spPr bwMode="auto">
                  <a:xfrm>
                    <a:off x="2737" y="228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76" name="Oval 797"/>
                  <p:cNvSpPr>
                    <a:spLocks noChangeArrowheads="1"/>
                  </p:cNvSpPr>
                  <p:nvPr/>
                </p:nvSpPr>
                <p:spPr bwMode="auto">
                  <a:xfrm>
                    <a:off x="2789" y="227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77" name="Oval 798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9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78" name="Oval 799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31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79" name="Oval 800"/>
                  <p:cNvSpPr>
                    <a:spLocks noChangeArrowheads="1"/>
                  </p:cNvSpPr>
                  <p:nvPr/>
                </p:nvSpPr>
                <p:spPr bwMode="auto">
                  <a:xfrm>
                    <a:off x="2858" y="227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80" name="Oval 801"/>
                  <p:cNvSpPr>
                    <a:spLocks noChangeArrowheads="1"/>
                  </p:cNvSpPr>
                  <p:nvPr/>
                </p:nvSpPr>
                <p:spPr bwMode="auto">
                  <a:xfrm>
                    <a:off x="2721" y="2268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81" name="Oval 802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5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82" name="Oval 803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5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83" name="Oval 804"/>
                  <p:cNvSpPr>
                    <a:spLocks noChangeArrowheads="1"/>
                  </p:cNvSpPr>
                  <p:nvPr/>
                </p:nvSpPr>
                <p:spPr bwMode="auto">
                  <a:xfrm>
                    <a:off x="2771" y="229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84" name="Oval 805"/>
                  <p:cNvSpPr>
                    <a:spLocks noChangeArrowheads="1"/>
                  </p:cNvSpPr>
                  <p:nvPr/>
                </p:nvSpPr>
                <p:spPr bwMode="auto">
                  <a:xfrm>
                    <a:off x="2849" y="226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85" name="Oval 806"/>
                  <p:cNvSpPr>
                    <a:spLocks noChangeArrowheads="1"/>
                  </p:cNvSpPr>
                  <p:nvPr/>
                </p:nvSpPr>
                <p:spPr bwMode="auto">
                  <a:xfrm>
                    <a:off x="2884" y="230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86" name="Oval 807"/>
                  <p:cNvSpPr>
                    <a:spLocks noChangeArrowheads="1"/>
                  </p:cNvSpPr>
                  <p:nvPr/>
                </p:nvSpPr>
                <p:spPr bwMode="auto">
                  <a:xfrm>
                    <a:off x="2824" y="235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87" name="Oval 808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26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88" name="Oval 809"/>
                  <p:cNvSpPr>
                    <a:spLocks noChangeArrowheads="1"/>
                  </p:cNvSpPr>
                  <p:nvPr/>
                </p:nvSpPr>
                <p:spPr bwMode="auto">
                  <a:xfrm>
                    <a:off x="2721" y="231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89" name="Oval 810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5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90" name="Oval 811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23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91" name="Oval 812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53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92" name="Oval 813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62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93" name="Oval 814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7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94" name="Oval 815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5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95" name="Oval 816"/>
                  <p:cNvSpPr>
                    <a:spLocks noChangeArrowheads="1"/>
                  </p:cNvSpPr>
                  <p:nvPr/>
                </p:nvSpPr>
                <p:spPr bwMode="auto">
                  <a:xfrm>
                    <a:off x="2824" y="227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96" name="Oval 817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27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97" name="Oval 818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65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98" name="Oval 819"/>
                  <p:cNvSpPr>
                    <a:spLocks noChangeArrowheads="1"/>
                  </p:cNvSpPr>
                  <p:nvPr/>
                </p:nvSpPr>
                <p:spPr bwMode="auto">
                  <a:xfrm>
                    <a:off x="2789" y="231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899" name="Oval 820"/>
                  <p:cNvSpPr>
                    <a:spLocks noChangeArrowheads="1"/>
                  </p:cNvSpPr>
                  <p:nvPr/>
                </p:nvSpPr>
                <p:spPr bwMode="auto">
                  <a:xfrm>
                    <a:off x="2803" y="234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00" name="Oval 821"/>
                  <p:cNvSpPr>
                    <a:spLocks noChangeArrowheads="1"/>
                  </p:cNvSpPr>
                  <p:nvPr/>
                </p:nvSpPr>
                <p:spPr bwMode="auto">
                  <a:xfrm>
                    <a:off x="2755" y="221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01" name="Oval 822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062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02" name="Oval 823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5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03" name="Oval 824"/>
                  <p:cNvSpPr>
                    <a:spLocks noChangeArrowheads="1"/>
                  </p:cNvSpPr>
                  <p:nvPr/>
                </p:nvSpPr>
                <p:spPr bwMode="auto">
                  <a:xfrm>
                    <a:off x="2858" y="235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04" name="Oval 825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6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05" name="Oval 826"/>
                  <p:cNvSpPr>
                    <a:spLocks noChangeArrowheads="1"/>
                  </p:cNvSpPr>
                  <p:nvPr/>
                </p:nvSpPr>
                <p:spPr bwMode="auto">
                  <a:xfrm>
                    <a:off x="2700" y="230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06" name="Oval 827"/>
                  <p:cNvSpPr>
                    <a:spLocks noChangeArrowheads="1"/>
                  </p:cNvSpPr>
                  <p:nvPr/>
                </p:nvSpPr>
                <p:spPr bwMode="auto">
                  <a:xfrm>
                    <a:off x="2843" y="238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07" name="Oval 828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63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08" name="Oval 829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33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09" name="Oval 830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229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10" name="Oval 831"/>
                  <p:cNvSpPr>
                    <a:spLocks noChangeArrowheads="1"/>
                  </p:cNvSpPr>
                  <p:nvPr/>
                </p:nvSpPr>
                <p:spPr bwMode="auto">
                  <a:xfrm>
                    <a:off x="2911" y="229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11" name="Oval 832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8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12" name="Oval 833"/>
                  <p:cNvSpPr>
                    <a:spLocks noChangeArrowheads="1"/>
                  </p:cNvSpPr>
                  <p:nvPr/>
                </p:nvSpPr>
                <p:spPr bwMode="auto">
                  <a:xfrm>
                    <a:off x="2806" y="229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13" name="Oval 834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63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14" name="Oval 835"/>
                  <p:cNvSpPr>
                    <a:spLocks noChangeArrowheads="1"/>
                  </p:cNvSpPr>
                  <p:nvPr/>
                </p:nvSpPr>
                <p:spPr bwMode="auto">
                  <a:xfrm>
                    <a:off x="2858" y="231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15" name="Oval 836"/>
                  <p:cNvSpPr>
                    <a:spLocks noChangeArrowheads="1"/>
                  </p:cNvSpPr>
                  <p:nvPr/>
                </p:nvSpPr>
                <p:spPr bwMode="auto">
                  <a:xfrm>
                    <a:off x="2876" y="228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16" name="Oval 837"/>
                  <p:cNvSpPr>
                    <a:spLocks noChangeArrowheads="1"/>
                  </p:cNvSpPr>
                  <p:nvPr/>
                </p:nvSpPr>
                <p:spPr bwMode="auto">
                  <a:xfrm>
                    <a:off x="2918" y="241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17" name="Oval 838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27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18" name="Oval 839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2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19" name="Oval 840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24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20" name="Oval 841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7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21" name="Oval 842"/>
                  <p:cNvSpPr>
                    <a:spLocks noChangeArrowheads="1"/>
                  </p:cNvSpPr>
                  <p:nvPr/>
                </p:nvSpPr>
                <p:spPr bwMode="auto">
                  <a:xfrm>
                    <a:off x="2755" y="231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22" name="Oval 843"/>
                  <p:cNvSpPr>
                    <a:spLocks noChangeArrowheads="1"/>
                  </p:cNvSpPr>
                  <p:nvPr/>
                </p:nvSpPr>
                <p:spPr bwMode="auto">
                  <a:xfrm>
                    <a:off x="2768" y="230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23" name="Oval 844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5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24" name="Oval 845"/>
                  <p:cNvSpPr>
                    <a:spLocks noChangeArrowheads="1"/>
                  </p:cNvSpPr>
                  <p:nvPr/>
                </p:nvSpPr>
                <p:spPr bwMode="auto">
                  <a:xfrm>
                    <a:off x="2702" y="229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25" name="Oval 846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24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26" name="Oval 847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74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27" name="Oval 848"/>
                  <p:cNvSpPr>
                    <a:spLocks noChangeArrowheads="1"/>
                  </p:cNvSpPr>
                  <p:nvPr/>
                </p:nvSpPr>
                <p:spPr bwMode="auto">
                  <a:xfrm>
                    <a:off x="2695" y="234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28" name="Oval 849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5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29" name="Oval 850"/>
                  <p:cNvSpPr>
                    <a:spLocks noChangeArrowheads="1"/>
                  </p:cNvSpPr>
                  <p:nvPr/>
                </p:nvSpPr>
                <p:spPr bwMode="auto">
                  <a:xfrm>
                    <a:off x="2842" y="229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30" name="Oval 851"/>
                  <p:cNvSpPr>
                    <a:spLocks noChangeArrowheads="1"/>
                  </p:cNvSpPr>
                  <p:nvPr/>
                </p:nvSpPr>
                <p:spPr bwMode="auto">
                  <a:xfrm>
                    <a:off x="2849" y="230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31" name="Oval 852"/>
                  <p:cNvSpPr>
                    <a:spLocks noChangeArrowheads="1"/>
                  </p:cNvSpPr>
                  <p:nvPr/>
                </p:nvSpPr>
                <p:spPr bwMode="auto">
                  <a:xfrm>
                    <a:off x="2884" y="225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32" name="Oval 853"/>
                  <p:cNvSpPr>
                    <a:spLocks noChangeArrowheads="1"/>
                  </p:cNvSpPr>
                  <p:nvPr/>
                </p:nvSpPr>
                <p:spPr bwMode="auto">
                  <a:xfrm>
                    <a:off x="2845" y="234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33" name="Oval 854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40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34" name="Oval 855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04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35" name="Oval 856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65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36" name="Oval 857"/>
                  <p:cNvSpPr>
                    <a:spLocks noChangeArrowheads="1"/>
                  </p:cNvSpPr>
                  <p:nvPr/>
                </p:nvSpPr>
                <p:spPr bwMode="auto">
                  <a:xfrm>
                    <a:off x="2808" y="2414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37" name="Oval 858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402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38" name="Oval 859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0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39" name="Oval 860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7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40" name="Oval 861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43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41" name="Oval 862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94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42" name="Oval 863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40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43" name="Oval 864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7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44" name="Oval 865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40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45" name="Oval 866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7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46" name="Oval 867"/>
                  <p:cNvSpPr>
                    <a:spLocks noChangeArrowheads="1"/>
                  </p:cNvSpPr>
                  <p:nvPr/>
                </p:nvSpPr>
                <p:spPr bwMode="auto">
                  <a:xfrm>
                    <a:off x="2808" y="234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47" name="Oval 868"/>
                  <p:cNvSpPr>
                    <a:spLocks noChangeArrowheads="1"/>
                  </p:cNvSpPr>
                  <p:nvPr/>
                </p:nvSpPr>
                <p:spPr bwMode="auto">
                  <a:xfrm>
                    <a:off x="2843" y="241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48" name="Oval 869"/>
                  <p:cNvSpPr>
                    <a:spLocks noChangeArrowheads="1"/>
                  </p:cNvSpPr>
                  <p:nvPr/>
                </p:nvSpPr>
                <p:spPr bwMode="auto">
                  <a:xfrm>
                    <a:off x="2842" y="2382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49" name="Oval 870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9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50" name="Oval 871"/>
                  <p:cNvSpPr>
                    <a:spLocks noChangeArrowheads="1"/>
                  </p:cNvSpPr>
                  <p:nvPr/>
                </p:nvSpPr>
                <p:spPr bwMode="auto">
                  <a:xfrm>
                    <a:off x="2768" y="241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51" name="Oval 872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26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52" name="Oval 873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28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53" name="Oval 874"/>
                  <p:cNvSpPr>
                    <a:spLocks noChangeArrowheads="1"/>
                  </p:cNvSpPr>
                  <p:nvPr/>
                </p:nvSpPr>
                <p:spPr bwMode="auto">
                  <a:xfrm>
                    <a:off x="2770" y="234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54" name="Oval 875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40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55" name="Oval 876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13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56" name="Oval 877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73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57" name="Oval 878"/>
                  <p:cNvSpPr>
                    <a:spLocks noChangeArrowheads="1"/>
                  </p:cNvSpPr>
                  <p:nvPr/>
                </p:nvSpPr>
                <p:spPr bwMode="auto">
                  <a:xfrm>
                    <a:off x="2734" y="241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58" name="Oval 879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9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59" name="Oval 880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288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60" name="Oval 881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7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61" name="Oval 882"/>
                  <p:cNvSpPr>
                    <a:spLocks noChangeArrowheads="1"/>
                  </p:cNvSpPr>
                  <p:nvPr/>
                </p:nvSpPr>
                <p:spPr bwMode="auto">
                  <a:xfrm>
                    <a:off x="2729" y="234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62" name="Oval 883"/>
                  <p:cNvSpPr>
                    <a:spLocks noChangeArrowheads="1"/>
                  </p:cNvSpPr>
                  <p:nvPr/>
                </p:nvSpPr>
                <p:spPr bwMode="auto">
                  <a:xfrm>
                    <a:off x="2845" y="230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63" name="Oval 884"/>
                  <p:cNvSpPr>
                    <a:spLocks noChangeArrowheads="1"/>
                  </p:cNvSpPr>
                  <p:nvPr/>
                </p:nvSpPr>
                <p:spPr bwMode="auto">
                  <a:xfrm>
                    <a:off x="2721" y="238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64" name="Oval 885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5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65" name="Oval 886"/>
                  <p:cNvSpPr>
                    <a:spLocks noChangeArrowheads="1"/>
                  </p:cNvSpPr>
                  <p:nvPr/>
                </p:nvSpPr>
                <p:spPr bwMode="auto">
                  <a:xfrm>
                    <a:off x="2700" y="234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66" name="Oval 887"/>
                  <p:cNvSpPr>
                    <a:spLocks noChangeArrowheads="1"/>
                  </p:cNvSpPr>
                  <p:nvPr/>
                </p:nvSpPr>
                <p:spPr bwMode="auto">
                  <a:xfrm>
                    <a:off x="2824" y="238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67" name="Oval 888"/>
                  <p:cNvSpPr>
                    <a:spLocks noChangeArrowheads="1"/>
                  </p:cNvSpPr>
                  <p:nvPr/>
                </p:nvSpPr>
                <p:spPr bwMode="auto">
                  <a:xfrm>
                    <a:off x="2737" y="233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68" name="Oval 889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03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69" name="Oval 890"/>
                  <p:cNvSpPr>
                    <a:spLocks noChangeArrowheads="1"/>
                  </p:cNvSpPr>
                  <p:nvPr/>
                </p:nvSpPr>
                <p:spPr bwMode="auto">
                  <a:xfrm>
                    <a:off x="2845" y="2443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70" name="Oval 891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5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71" name="Oval 892"/>
                  <p:cNvSpPr>
                    <a:spLocks noChangeArrowheads="1"/>
                  </p:cNvSpPr>
                  <p:nvPr/>
                </p:nvSpPr>
                <p:spPr bwMode="auto">
                  <a:xfrm>
                    <a:off x="2849" y="242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72" name="Oval 893"/>
                  <p:cNvSpPr>
                    <a:spLocks noChangeArrowheads="1"/>
                  </p:cNvSpPr>
                  <p:nvPr/>
                </p:nvSpPr>
                <p:spPr bwMode="auto">
                  <a:xfrm>
                    <a:off x="2877" y="243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973" name="Oval 894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26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</p:grpSp>
            <p:grpSp>
              <p:nvGrpSpPr>
                <p:cNvPr id="1295" name="Group 1096"/>
                <p:cNvGrpSpPr>
                  <a:grpSpLocks/>
                </p:cNvGrpSpPr>
                <p:nvPr/>
              </p:nvGrpSpPr>
              <p:grpSpPr bwMode="auto">
                <a:xfrm>
                  <a:off x="2695" y="2040"/>
                  <a:ext cx="246" cy="653"/>
                  <a:chOff x="2695" y="2040"/>
                  <a:chExt cx="246" cy="653"/>
                </a:xfrm>
              </p:grpSpPr>
              <p:sp>
                <p:nvSpPr>
                  <p:cNvPr id="1578" name="Oval 896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8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79" name="Oval 897"/>
                  <p:cNvSpPr>
                    <a:spLocks noChangeArrowheads="1"/>
                  </p:cNvSpPr>
                  <p:nvPr/>
                </p:nvSpPr>
                <p:spPr bwMode="auto">
                  <a:xfrm>
                    <a:off x="2695" y="230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80" name="Oval 898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42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81" name="Oval 899"/>
                  <p:cNvSpPr>
                    <a:spLocks noChangeArrowheads="1"/>
                  </p:cNvSpPr>
                  <p:nvPr/>
                </p:nvSpPr>
                <p:spPr bwMode="auto">
                  <a:xfrm>
                    <a:off x="2695" y="241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82" name="Oval 900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0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83" name="Oval 901"/>
                  <p:cNvSpPr>
                    <a:spLocks noChangeArrowheads="1"/>
                  </p:cNvSpPr>
                  <p:nvPr/>
                </p:nvSpPr>
                <p:spPr bwMode="auto">
                  <a:xfrm>
                    <a:off x="2810" y="241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84" name="Oval 902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42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85" name="Oval 903"/>
                  <p:cNvSpPr>
                    <a:spLocks noChangeArrowheads="1"/>
                  </p:cNvSpPr>
                  <p:nvPr/>
                </p:nvSpPr>
                <p:spPr bwMode="auto">
                  <a:xfrm>
                    <a:off x="2808" y="2434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86" name="Oval 904"/>
                  <p:cNvSpPr>
                    <a:spLocks noChangeArrowheads="1"/>
                  </p:cNvSpPr>
                  <p:nvPr/>
                </p:nvSpPr>
                <p:spPr bwMode="auto">
                  <a:xfrm>
                    <a:off x="2729" y="225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87" name="Oval 905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81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88" name="Oval 906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6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89" name="Oval 907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40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90" name="Oval 908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9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91" name="Oval 909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33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92" name="Oval 910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61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93" name="Oval 911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2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94" name="Oval 912"/>
                  <p:cNvSpPr>
                    <a:spLocks noChangeArrowheads="1"/>
                  </p:cNvSpPr>
                  <p:nvPr/>
                </p:nvSpPr>
                <p:spPr bwMode="auto">
                  <a:xfrm>
                    <a:off x="2736" y="2343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95" name="Oval 913"/>
                  <p:cNvSpPr>
                    <a:spLocks noChangeArrowheads="1"/>
                  </p:cNvSpPr>
                  <p:nvPr/>
                </p:nvSpPr>
                <p:spPr bwMode="auto">
                  <a:xfrm>
                    <a:off x="2876" y="241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96" name="Oval 914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41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97" name="Oval 915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9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98" name="Oval 916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06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99" name="Oval 917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422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00" name="Oval 918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13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01" name="Oval 919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8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02" name="Oval 920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7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03" name="Oval 921"/>
                  <p:cNvSpPr>
                    <a:spLocks noChangeArrowheads="1"/>
                  </p:cNvSpPr>
                  <p:nvPr/>
                </p:nvSpPr>
                <p:spPr bwMode="auto">
                  <a:xfrm>
                    <a:off x="2845" y="241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04" name="Oval 922"/>
                  <p:cNvSpPr>
                    <a:spLocks noChangeArrowheads="1"/>
                  </p:cNvSpPr>
                  <p:nvPr/>
                </p:nvSpPr>
                <p:spPr bwMode="auto">
                  <a:xfrm>
                    <a:off x="2736" y="238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05" name="Oval 923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5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06" name="Oval 924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7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07" name="Oval 925"/>
                  <p:cNvSpPr>
                    <a:spLocks noChangeArrowheads="1"/>
                  </p:cNvSpPr>
                  <p:nvPr/>
                </p:nvSpPr>
                <p:spPr bwMode="auto">
                  <a:xfrm>
                    <a:off x="2805" y="241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08" name="Oval 926"/>
                  <p:cNvSpPr>
                    <a:spLocks noChangeArrowheads="1"/>
                  </p:cNvSpPr>
                  <p:nvPr/>
                </p:nvSpPr>
                <p:spPr bwMode="auto">
                  <a:xfrm>
                    <a:off x="2700" y="2441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09" name="Oval 927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43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10" name="Oval 928"/>
                  <p:cNvSpPr>
                    <a:spLocks noChangeArrowheads="1"/>
                  </p:cNvSpPr>
                  <p:nvPr/>
                </p:nvSpPr>
                <p:spPr bwMode="auto">
                  <a:xfrm>
                    <a:off x="2729" y="241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11" name="Oval 929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9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12" name="Oval 930"/>
                  <p:cNvSpPr>
                    <a:spLocks noChangeArrowheads="1"/>
                  </p:cNvSpPr>
                  <p:nvPr/>
                </p:nvSpPr>
                <p:spPr bwMode="auto">
                  <a:xfrm>
                    <a:off x="2702" y="238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13" name="Oval 931"/>
                  <p:cNvSpPr>
                    <a:spLocks noChangeArrowheads="1"/>
                  </p:cNvSpPr>
                  <p:nvPr/>
                </p:nvSpPr>
                <p:spPr bwMode="auto">
                  <a:xfrm>
                    <a:off x="2703" y="241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14" name="Oval 932"/>
                  <p:cNvSpPr>
                    <a:spLocks noChangeArrowheads="1"/>
                  </p:cNvSpPr>
                  <p:nvPr/>
                </p:nvSpPr>
                <p:spPr bwMode="auto">
                  <a:xfrm>
                    <a:off x="2918" y="238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15" name="Oval 933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40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16" name="Oval 934"/>
                  <p:cNvSpPr>
                    <a:spLocks noChangeArrowheads="1"/>
                  </p:cNvSpPr>
                  <p:nvPr/>
                </p:nvSpPr>
                <p:spPr bwMode="auto">
                  <a:xfrm>
                    <a:off x="2755" y="249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17" name="Oval 935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0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18" name="Oval 936"/>
                  <p:cNvSpPr>
                    <a:spLocks noChangeArrowheads="1"/>
                  </p:cNvSpPr>
                  <p:nvPr/>
                </p:nvSpPr>
                <p:spPr bwMode="auto">
                  <a:xfrm>
                    <a:off x="2877" y="241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19" name="Oval 937"/>
                  <p:cNvSpPr>
                    <a:spLocks noChangeArrowheads="1"/>
                  </p:cNvSpPr>
                  <p:nvPr/>
                </p:nvSpPr>
                <p:spPr bwMode="auto">
                  <a:xfrm>
                    <a:off x="2702" y="241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20" name="Oval 938"/>
                  <p:cNvSpPr>
                    <a:spLocks noChangeArrowheads="1"/>
                  </p:cNvSpPr>
                  <p:nvPr/>
                </p:nvSpPr>
                <p:spPr bwMode="auto">
                  <a:xfrm>
                    <a:off x="2845" y="238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21" name="Oval 939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422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22" name="Oval 940"/>
                  <p:cNvSpPr>
                    <a:spLocks noChangeArrowheads="1"/>
                  </p:cNvSpPr>
                  <p:nvPr/>
                </p:nvSpPr>
                <p:spPr bwMode="auto">
                  <a:xfrm>
                    <a:off x="2808" y="244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23" name="Oval 941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96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24" name="Oval 942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41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25" name="Oval 943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41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26" name="Oval 944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91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27" name="Oval 945"/>
                  <p:cNvSpPr>
                    <a:spLocks noChangeArrowheads="1"/>
                  </p:cNvSpPr>
                  <p:nvPr/>
                </p:nvSpPr>
                <p:spPr bwMode="auto">
                  <a:xfrm>
                    <a:off x="2771" y="241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28" name="Oval 946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6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29" name="Oval 947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7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30" name="Oval 948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6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31" name="Oval 949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40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32" name="Oval 950"/>
                  <p:cNvSpPr>
                    <a:spLocks noChangeArrowheads="1"/>
                  </p:cNvSpPr>
                  <p:nvPr/>
                </p:nvSpPr>
                <p:spPr bwMode="auto">
                  <a:xfrm>
                    <a:off x="2729" y="238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33" name="Oval 951"/>
                  <p:cNvSpPr>
                    <a:spLocks noChangeArrowheads="1"/>
                  </p:cNvSpPr>
                  <p:nvPr/>
                </p:nvSpPr>
                <p:spPr bwMode="auto">
                  <a:xfrm>
                    <a:off x="2755" y="227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34" name="Oval 952"/>
                  <p:cNvSpPr>
                    <a:spLocks noChangeArrowheads="1"/>
                  </p:cNvSpPr>
                  <p:nvPr/>
                </p:nvSpPr>
                <p:spPr bwMode="auto">
                  <a:xfrm>
                    <a:off x="2810" y="244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35" name="Oval 953"/>
                  <p:cNvSpPr>
                    <a:spLocks noChangeArrowheads="1"/>
                  </p:cNvSpPr>
                  <p:nvPr/>
                </p:nvSpPr>
                <p:spPr bwMode="auto">
                  <a:xfrm>
                    <a:off x="2755" y="2481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36" name="Oval 954"/>
                  <p:cNvSpPr>
                    <a:spLocks noChangeArrowheads="1"/>
                  </p:cNvSpPr>
                  <p:nvPr/>
                </p:nvSpPr>
                <p:spPr bwMode="auto">
                  <a:xfrm>
                    <a:off x="2764" y="230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37" name="Oval 955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50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38" name="Oval 956"/>
                  <p:cNvSpPr>
                    <a:spLocks noChangeArrowheads="1"/>
                  </p:cNvSpPr>
                  <p:nvPr/>
                </p:nvSpPr>
                <p:spPr bwMode="auto">
                  <a:xfrm>
                    <a:off x="2703" y="2382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39" name="Oval 957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15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40" name="Oval 958"/>
                  <p:cNvSpPr>
                    <a:spLocks noChangeArrowheads="1"/>
                  </p:cNvSpPr>
                  <p:nvPr/>
                </p:nvSpPr>
                <p:spPr bwMode="auto">
                  <a:xfrm>
                    <a:off x="2702" y="234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41" name="Oval 959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6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42" name="Oval 960"/>
                  <p:cNvSpPr>
                    <a:spLocks noChangeArrowheads="1"/>
                  </p:cNvSpPr>
                  <p:nvPr/>
                </p:nvSpPr>
                <p:spPr bwMode="auto">
                  <a:xfrm>
                    <a:off x="2808" y="241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43" name="Oval 961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0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44" name="Oval 962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426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45" name="Oval 963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43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46" name="Oval 964"/>
                  <p:cNvSpPr>
                    <a:spLocks noChangeArrowheads="1"/>
                  </p:cNvSpPr>
                  <p:nvPr/>
                </p:nvSpPr>
                <p:spPr bwMode="auto">
                  <a:xfrm>
                    <a:off x="2892" y="244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47" name="Oval 965"/>
                  <p:cNvSpPr>
                    <a:spLocks noChangeArrowheads="1"/>
                  </p:cNvSpPr>
                  <p:nvPr/>
                </p:nvSpPr>
                <p:spPr bwMode="auto">
                  <a:xfrm>
                    <a:off x="2884" y="241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48" name="Oval 966"/>
                  <p:cNvSpPr>
                    <a:spLocks noChangeArrowheads="1"/>
                  </p:cNvSpPr>
                  <p:nvPr/>
                </p:nvSpPr>
                <p:spPr bwMode="auto">
                  <a:xfrm>
                    <a:off x="2806" y="2383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49" name="Oval 967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06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50" name="Oval 968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27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51" name="Oval 969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9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52" name="Oval 970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43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53" name="Oval 971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71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54" name="Oval 972"/>
                  <p:cNvSpPr>
                    <a:spLocks noChangeArrowheads="1"/>
                  </p:cNvSpPr>
                  <p:nvPr/>
                </p:nvSpPr>
                <p:spPr bwMode="auto">
                  <a:xfrm>
                    <a:off x="2764" y="244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55" name="Oval 973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5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56" name="Oval 974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207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57" name="Oval 975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5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58" name="Oval 976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43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59" name="Oval 977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40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60" name="Oval 978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484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61" name="Oval 979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3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62" name="Oval 980"/>
                  <p:cNvSpPr>
                    <a:spLocks noChangeArrowheads="1"/>
                  </p:cNvSpPr>
                  <p:nvPr/>
                </p:nvSpPr>
                <p:spPr bwMode="auto">
                  <a:xfrm>
                    <a:off x="2798" y="244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63" name="Oval 981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9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64" name="Oval 982"/>
                  <p:cNvSpPr>
                    <a:spLocks noChangeArrowheads="1"/>
                  </p:cNvSpPr>
                  <p:nvPr/>
                </p:nvSpPr>
                <p:spPr bwMode="auto">
                  <a:xfrm>
                    <a:off x="2913" y="230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65" name="Oval 983"/>
                  <p:cNvSpPr>
                    <a:spLocks noChangeArrowheads="1"/>
                  </p:cNvSpPr>
                  <p:nvPr/>
                </p:nvSpPr>
                <p:spPr bwMode="auto">
                  <a:xfrm>
                    <a:off x="2755" y="2421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66" name="Oval 984"/>
                  <p:cNvSpPr>
                    <a:spLocks noChangeArrowheads="1"/>
                  </p:cNvSpPr>
                  <p:nvPr/>
                </p:nvSpPr>
                <p:spPr bwMode="auto">
                  <a:xfrm>
                    <a:off x="2737" y="241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67" name="Oval 985"/>
                  <p:cNvSpPr>
                    <a:spLocks noChangeArrowheads="1"/>
                  </p:cNvSpPr>
                  <p:nvPr/>
                </p:nvSpPr>
                <p:spPr bwMode="auto">
                  <a:xfrm>
                    <a:off x="2771" y="234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68" name="Oval 986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8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69" name="Oval 987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32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70" name="Oval 988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1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71" name="Oval 989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27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72" name="Oval 990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3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73" name="Oval 991"/>
                  <p:cNvSpPr>
                    <a:spLocks noChangeArrowheads="1"/>
                  </p:cNvSpPr>
                  <p:nvPr/>
                </p:nvSpPr>
                <p:spPr bwMode="auto">
                  <a:xfrm>
                    <a:off x="2884" y="234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74" name="Oval 992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7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75" name="Oval 993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1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76" name="Oval 994"/>
                  <p:cNvSpPr>
                    <a:spLocks noChangeArrowheads="1"/>
                  </p:cNvSpPr>
                  <p:nvPr/>
                </p:nvSpPr>
                <p:spPr bwMode="auto">
                  <a:xfrm>
                    <a:off x="2877" y="238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77" name="Oval 995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40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78" name="Oval 996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71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79" name="Oval 997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5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80" name="Oval 998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9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81" name="Oval 999"/>
                  <p:cNvSpPr>
                    <a:spLocks noChangeArrowheads="1"/>
                  </p:cNvSpPr>
                  <p:nvPr/>
                </p:nvSpPr>
                <p:spPr bwMode="auto">
                  <a:xfrm>
                    <a:off x="2806" y="241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82" name="Oval 1000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423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83" name="Oval 1001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6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84" name="Oval 1002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96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85" name="Oval 1003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6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86" name="Oval 1004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56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87" name="Oval 1005"/>
                  <p:cNvSpPr>
                    <a:spLocks noChangeArrowheads="1"/>
                  </p:cNvSpPr>
                  <p:nvPr/>
                </p:nvSpPr>
                <p:spPr bwMode="auto">
                  <a:xfrm>
                    <a:off x="2849" y="238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88" name="Oval 1006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7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89" name="Oval 1007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6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90" name="Oval 1008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5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91" name="Oval 1009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94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92" name="Oval 1010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8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93" name="Oval 1011"/>
                  <p:cNvSpPr>
                    <a:spLocks noChangeArrowheads="1"/>
                  </p:cNvSpPr>
                  <p:nvPr/>
                </p:nvSpPr>
                <p:spPr bwMode="auto">
                  <a:xfrm>
                    <a:off x="2879" y="238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94" name="Oval 1012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9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95" name="Oval 1013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403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96" name="Oval 1014"/>
                  <p:cNvSpPr>
                    <a:spLocks noChangeArrowheads="1"/>
                  </p:cNvSpPr>
                  <p:nvPr/>
                </p:nvSpPr>
                <p:spPr bwMode="auto">
                  <a:xfrm>
                    <a:off x="2810" y="238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97" name="Oval 1015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40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98" name="Oval 1016"/>
                  <p:cNvSpPr>
                    <a:spLocks noChangeArrowheads="1"/>
                  </p:cNvSpPr>
                  <p:nvPr/>
                </p:nvSpPr>
                <p:spPr bwMode="auto">
                  <a:xfrm>
                    <a:off x="2700" y="241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699" name="Oval 1017"/>
                  <p:cNvSpPr>
                    <a:spLocks noChangeArrowheads="1"/>
                  </p:cNvSpPr>
                  <p:nvPr/>
                </p:nvSpPr>
                <p:spPr bwMode="auto">
                  <a:xfrm>
                    <a:off x="2918" y="234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00" name="Oval 1018"/>
                  <p:cNvSpPr>
                    <a:spLocks noChangeArrowheads="1"/>
                  </p:cNvSpPr>
                  <p:nvPr/>
                </p:nvSpPr>
                <p:spPr bwMode="auto">
                  <a:xfrm>
                    <a:off x="2842" y="241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01" name="Oval 1019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93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02" name="Oval 1020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0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03" name="Oval 1021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88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04" name="Oval 1022"/>
                  <p:cNvSpPr>
                    <a:spLocks noChangeArrowheads="1"/>
                  </p:cNvSpPr>
                  <p:nvPr/>
                </p:nvSpPr>
                <p:spPr bwMode="auto">
                  <a:xfrm>
                    <a:off x="2734" y="2443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05" name="Oval 1023"/>
                  <p:cNvSpPr>
                    <a:spLocks noChangeArrowheads="1"/>
                  </p:cNvSpPr>
                  <p:nvPr/>
                </p:nvSpPr>
                <p:spPr bwMode="auto">
                  <a:xfrm>
                    <a:off x="2843" y="234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06" name="Oval 1024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56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07" name="Oval 1025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04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08" name="Oval 1026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41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09" name="Oval 1027"/>
                  <p:cNvSpPr>
                    <a:spLocks noChangeArrowheads="1"/>
                  </p:cNvSpPr>
                  <p:nvPr/>
                </p:nvSpPr>
                <p:spPr bwMode="auto">
                  <a:xfrm>
                    <a:off x="2911" y="234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10" name="Oval 1028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41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11" name="Oval 1029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24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12" name="Oval 1030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7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13" name="Oval 1031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8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14" name="Oval 1032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403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15" name="Oval 1033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34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16" name="Oval 1034"/>
                  <p:cNvSpPr>
                    <a:spLocks noChangeArrowheads="1"/>
                  </p:cNvSpPr>
                  <p:nvPr/>
                </p:nvSpPr>
                <p:spPr bwMode="auto">
                  <a:xfrm>
                    <a:off x="2789" y="2422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17" name="Oval 1035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7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18" name="Oval 1036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8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19" name="Oval 1037"/>
                  <p:cNvSpPr>
                    <a:spLocks noChangeArrowheads="1"/>
                  </p:cNvSpPr>
                  <p:nvPr/>
                </p:nvSpPr>
                <p:spPr bwMode="auto">
                  <a:xfrm>
                    <a:off x="2913" y="234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20" name="Oval 1038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7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21" name="Oval 1039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40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22" name="Oval 1040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40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23" name="Oval 1041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81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24" name="Oval 1042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8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25" name="Oval 1043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6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26" name="Oval 1044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40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27" name="Oval 1045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40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28" name="Oval 1046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61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29" name="Oval 1047"/>
                  <p:cNvSpPr>
                    <a:spLocks noChangeArrowheads="1"/>
                  </p:cNvSpPr>
                  <p:nvPr/>
                </p:nvSpPr>
                <p:spPr bwMode="auto">
                  <a:xfrm>
                    <a:off x="2755" y="235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30" name="Oval 1048"/>
                  <p:cNvSpPr>
                    <a:spLocks noChangeArrowheads="1"/>
                  </p:cNvSpPr>
                  <p:nvPr/>
                </p:nvSpPr>
                <p:spPr bwMode="auto">
                  <a:xfrm>
                    <a:off x="2721" y="242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31" name="Oval 1049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40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32" name="Oval 1050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42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33" name="Oval 1051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6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34" name="Oval 1052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76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35" name="Oval 1053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98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36" name="Oval 1054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1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37" name="Oval 1055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41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38" name="Oval 1056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9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39" name="Oval 1057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9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40" name="Oval 1058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40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41" name="Oval 1059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7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42" name="Oval 1060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40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43" name="Oval 1061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93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44" name="Oval 1062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6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45" name="Oval 1063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74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46" name="Oval 1064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6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47" name="Oval 1065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61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48" name="Oval 1066"/>
                  <p:cNvSpPr>
                    <a:spLocks noChangeArrowheads="1"/>
                  </p:cNvSpPr>
                  <p:nvPr/>
                </p:nvSpPr>
                <p:spPr bwMode="auto">
                  <a:xfrm>
                    <a:off x="2858" y="2421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49" name="Oval 1067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65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50" name="Oval 1068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8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51" name="Oval 1069"/>
                  <p:cNvSpPr>
                    <a:spLocks noChangeArrowheads="1"/>
                  </p:cNvSpPr>
                  <p:nvPr/>
                </p:nvSpPr>
                <p:spPr bwMode="auto">
                  <a:xfrm>
                    <a:off x="2734" y="230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52" name="Oval 1070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8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53" name="Oval 1071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42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54" name="Oval 1072"/>
                  <p:cNvSpPr>
                    <a:spLocks noChangeArrowheads="1"/>
                  </p:cNvSpPr>
                  <p:nvPr/>
                </p:nvSpPr>
                <p:spPr bwMode="auto">
                  <a:xfrm>
                    <a:off x="2879" y="2442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55" name="Oval 1073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28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56" name="Oval 1074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40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57" name="Oval 1075"/>
                  <p:cNvSpPr>
                    <a:spLocks noChangeArrowheads="1"/>
                  </p:cNvSpPr>
                  <p:nvPr/>
                </p:nvSpPr>
                <p:spPr bwMode="auto">
                  <a:xfrm>
                    <a:off x="2729" y="244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58" name="Oval 1076"/>
                  <p:cNvSpPr>
                    <a:spLocks noChangeArrowheads="1"/>
                  </p:cNvSpPr>
                  <p:nvPr/>
                </p:nvSpPr>
                <p:spPr bwMode="auto">
                  <a:xfrm>
                    <a:off x="2729" y="230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59" name="Oval 1077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43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60" name="Oval 1078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98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61" name="Oval 1079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1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62" name="Oval 1080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43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63" name="Oval 1081"/>
                  <p:cNvSpPr>
                    <a:spLocks noChangeArrowheads="1"/>
                  </p:cNvSpPr>
                  <p:nvPr/>
                </p:nvSpPr>
                <p:spPr bwMode="auto">
                  <a:xfrm>
                    <a:off x="2734" y="234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64" name="Oval 1082"/>
                  <p:cNvSpPr>
                    <a:spLocks noChangeArrowheads="1"/>
                  </p:cNvSpPr>
                  <p:nvPr/>
                </p:nvSpPr>
                <p:spPr bwMode="auto">
                  <a:xfrm>
                    <a:off x="2824" y="2422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65" name="Oval 1083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96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66" name="Oval 1084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45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67" name="Oval 1085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42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68" name="Oval 1086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246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69" name="Oval 1087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67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70" name="Oval 1088"/>
                  <p:cNvSpPr>
                    <a:spLocks noChangeArrowheads="1"/>
                  </p:cNvSpPr>
                  <p:nvPr/>
                </p:nvSpPr>
                <p:spPr bwMode="auto">
                  <a:xfrm>
                    <a:off x="2764" y="246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71" name="Oval 1089"/>
                  <p:cNvSpPr>
                    <a:spLocks noChangeArrowheads="1"/>
                  </p:cNvSpPr>
                  <p:nvPr/>
                </p:nvSpPr>
                <p:spPr bwMode="auto">
                  <a:xfrm>
                    <a:off x="2892" y="231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72" name="Oval 1090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60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73" name="Oval 1091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40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74" name="Oval 1092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2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75" name="Oval 1093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1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76" name="Oval 1094"/>
                  <p:cNvSpPr>
                    <a:spLocks noChangeArrowheads="1"/>
                  </p:cNvSpPr>
                  <p:nvPr/>
                </p:nvSpPr>
                <p:spPr bwMode="auto">
                  <a:xfrm>
                    <a:off x="2892" y="2479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777" name="Oval 1095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04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</p:grpSp>
            <p:grpSp>
              <p:nvGrpSpPr>
                <p:cNvPr id="1296" name="Group 1297"/>
                <p:cNvGrpSpPr>
                  <a:grpSpLocks/>
                </p:cNvGrpSpPr>
                <p:nvPr/>
              </p:nvGrpSpPr>
              <p:grpSpPr bwMode="auto">
                <a:xfrm>
                  <a:off x="2695" y="2113"/>
                  <a:ext cx="246" cy="599"/>
                  <a:chOff x="2695" y="2113"/>
                  <a:chExt cx="246" cy="599"/>
                </a:xfrm>
              </p:grpSpPr>
              <p:sp>
                <p:nvSpPr>
                  <p:cNvPr id="1378" name="Oval 1097"/>
                  <p:cNvSpPr>
                    <a:spLocks noChangeArrowheads="1"/>
                  </p:cNvSpPr>
                  <p:nvPr/>
                </p:nvSpPr>
                <p:spPr bwMode="auto">
                  <a:xfrm>
                    <a:off x="2805" y="234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79" name="Oval 1098"/>
                  <p:cNvSpPr>
                    <a:spLocks noChangeArrowheads="1"/>
                  </p:cNvSpPr>
                  <p:nvPr/>
                </p:nvSpPr>
                <p:spPr bwMode="auto">
                  <a:xfrm>
                    <a:off x="2700" y="238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80" name="Oval 1099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539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81" name="Oval 1100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74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82" name="Oval 1101"/>
                  <p:cNvSpPr>
                    <a:spLocks noChangeArrowheads="1"/>
                  </p:cNvSpPr>
                  <p:nvPr/>
                </p:nvSpPr>
                <p:spPr bwMode="auto">
                  <a:xfrm>
                    <a:off x="2703" y="233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83" name="Oval 1102"/>
                  <p:cNvSpPr>
                    <a:spLocks noChangeArrowheads="1"/>
                  </p:cNvSpPr>
                  <p:nvPr/>
                </p:nvSpPr>
                <p:spPr bwMode="auto">
                  <a:xfrm>
                    <a:off x="2755" y="238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84" name="Oval 1103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403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85" name="Oval 1104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40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86" name="Oval 1105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94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87" name="Oval 1106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7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88" name="Oval 1107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91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89" name="Oval 1108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54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90" name="Oval 1109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7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91" name="Oval 1110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24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92" name="Oval 1111"/>
                  <p:cNvSpPr>
                    <a:spLocks noChangeArrowheads="1"/>
                  </p:cNvSpPr>
                  <p:nvPr/>
                </p:nvSpPr>
                <p:spPr bwMode="auto">
                  <a:xfrm>
                    <a:off x="2805" y="238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93" name="Oval 1112"/>
                  <p:cNvSpPr>
                    <a:spLocks noChangeArrowheads="1"/>
                  </p:cNvSpPr>
                  <p:nvPr/>
                </p:nvSpPr>
                <p:spPr bwMode="auto">
                  <a:xfrm>
                    <a:off x="2911" y="243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94" name="Oval 1113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8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95" name="Oval 1114"/>
                  <p:cNvSpPr>
                    <a:spLocks noChangeArrowheads="1"/>
                  </p:cNvSpPr>
                  <p:nvPr/>
                </p:nvSpPr>
                <p:spPr bwMode="auto">
                  <a:xfrm>
                    <a:off x="2842" y="234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96" name="Oval 1115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41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97" name="Oval 1116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49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98" name="Oval 1117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66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399" name="Oval 1118"/>
                  <p:cNvSpPr>
                    <a:spLocks noChangeArrowheads="1"/>
                  </p:cNvSpPr>
                  <p:nvPr/>
                </p:nvSpPr>
                <p:spPr bwMode="auto">
                  <a:xfrm>
                    <a:off x="2806" y="234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00" name="Oval 1119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281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01" name="Oval 1120"/>
                  <p:cNvSpPr>
                    <a:spLocks noChangeArrowheads="1"/>
                  </p:cNvSpPr>
                  <p:nvPr/>
                </p:nvSpPr>
                <p:spPr bwMode="auto">
                  <a:xfrm>
                    <a:off x="2911" y="2383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02" name="Oval 1121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9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03" name="Oval 1122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6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04" name="Oval 1123"/>
                  <p:cNvSpPr>
                    <a:spLocks noChangeArrowheads="1"/>
                  </p:cNvSpPr>
                  <p:nvPr/>
                </p:nvSpPr>
                <p:spPr bwMode="auto">
                  <a:xfrm>
                    <a:off x="2798" y="231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05" name="Oval 1124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5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06" name="Oval 1125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45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07" name="Oval 1126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7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08" name="Oval 1127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76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09" name="Oval 1128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56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10" name="Oval 1129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7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11" name="Oval 1130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6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12" name="Oval 1131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2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13" name="Oval 1132"/>
                  <p:cNvSpPr>
                    <a:spLocks noChangeArrowheads="1"/>
                  </p:cNvSpPr>
                  <p:nvPr/>
                </p:nvSpPr>
                <p:spPr bwMode="auto">
                  <a:xfrm>
                    <a:off x="2789" y="235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14" name="Oval 1133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18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15" name="Oval 1134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55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16" name="Oval 1135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7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17" name="Oval 1136"/>
                  <p:cNvSpPr>
                    <a:spLocks noChangeArrowheads="1"/>
                  </p:cNvSpPr>
                  <p:nvPr/>
                </p:nvSpPr>
                <p:spPr bwMode="auto">
                  <a:xfrm>
                    <a:off x="2770" y="230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18" name="Oval 1137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40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19" name="Oval 1138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566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20" name="Oval 1139"/>
                  <p:cNvSpPr>
                    <a:spLocks noChangeArrowheads="1"/>
                  </p:cNvSpPr>
                  <p:nvPr/>
                </p:nvSpPr>
                <p:spPr bwMode="auto">
                  <a:xfrm>
                    <a:off x="2770" y="238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21" name="Oval 1140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72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22" name="Oval 1141"/>
                  <p:cNvSpPr>
                    <a:spLocks noChangeArrowheads="1"/>
                  </p:cNvSpPr>
                  <p:nvPr/>
                </p:nvSpPr>
                <p:spPr bwMode="auto">
                  <a:xfrm>
                    <a:off x="2911" y="241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23" name="Oval 1142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504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24" name="Oval 1143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3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25" name="Oval 1144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113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26" name="Oval 1145"/>
                  <p:cNvSpPr>
                    <a:spLocks noChangeArrowheads="1"/>
                  </p:cNvSpPr>
                  <p:nvPr/>
                </p:nvSpPr>
                <p:spPr bwMode="auto">
                  <a:xfrm>
                    <a:off x="2789" y="222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27" name="Oval 1146"/>
                  <p:cNvSpPr>
                    <a:spLocks noChangeArrowheads="1"/>
                  </p:cNvSpPr>
                  <p:nvPr/>
                </p:nvSpPr>
                <p:spPr bwMode="auto">
                  <a:xfrm>
                    <a:off x="2892" y="238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28" name="Oval 1147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8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29" name="Oval 1148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63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30" name="Oval 1149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6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31" name="Oval 1150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6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32" name="Oval 1151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78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33" name="Oval 1152"/>
                  <p:cNvSpPr>
                    <a:spLocks noChangeArrowheads="1"/>
                  </p:cNvSpPr>
                  <p:nvPr/>
                </p:nvSpPr>
                <p:spPr bwMode="auto">
                  <a:xfrm>
                    <a:off x="2721" y="235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34" name="Oval 1153"/>
                  <p:cNvSpPr>
                    <a:spLocks noChangeArrowheads="1"/>
                  </p:cNvSpPr>
                  <p:nvPr/>
                </p:nvSpPr>
                <p:spPr bwMode="auto">
                  <a:xfrm>
                    <a:off x="2842" y="243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35" name="Oval 1154"/>
                  <p:cNvSpPr>
                    <a:spLocks noChangeArrowheads="1"/>
                  </p:cNvSpPr>
                  <p:nvPr/>
                </p:nvSpPr>
                <p:spPr bwMode="auto">
                  <a:xfrm>
                    <a:off x="2858" y="238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36" name="Oval 1155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3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37" name="Oval 1156"/>
                  <p:cNvSpPr>
                    <a:spLocks noChangeArrowheads="1"/>
                  </p:cNvSpPr>
                  <p:nvPr/>
                </p:nvSpPr>
                <p:spPr bwMode="auto">
                  <a:xfrm>
                    <a:off x="2849" y="234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38" name="Oval 1157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5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39" name="Oval 1158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42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40" name="Oval 1159"/>
                  <p:cNvSpPr>
                    <a:spLocks noChangeArrowheads="1"/>
                  </p:cNvSpPr>
                  <p:nvPr/>
                </p:nvSpPr>
                <p:spPr bwMode="auto">
                  <a:xfrm>
                    <a:off x="2808" y="230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41" name="Oval 1160"/>
                  <p:cNvSpPr>
                    <a:spLocks noChangeArrowheads="1"/>
                  </p:cNvSpPr>
                  <p:nvPr/>
                </p:nvSpPr>
                <p:spPr bwMode="auto">
                  <a:xfrm>
                    <a:off x="2789" y="238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42" name="Oval 1161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28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43" name="Oval 1162"/>
                  <p:cNvSpPr>
                    <a:spLocks noChangeArrowheads="1"/>
                  </p:cNvSpPr>
                  <p:nvPr/>
                </p:nvSpPr>
                <p:spPr bwMode="auto">
                  <a:xfrm>
                    <a:off x="2913" y="238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44" name="Oval 1163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0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45" name="Oval 1164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22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46" name="Oval 1165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68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47" name="Oval 1166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38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48" name="Oval 1167"/>
                  <p:cNvSpPr>
                    <a:spLocks noChangeArrowheads="1"/>
                  </p:cNvSpPr>
                  <p:nvPr/>
                </p:nvSpPr>
                <p:spPr bwMode="auto">
                  <a:xfrm>
                    <a:off x="2736" y="229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49" name="Oval 1168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287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50" name="Oval 1169"/>
                  <p:cNvSpPr>
                    <a:spLocks noChangeArrowheads="1"/>
                  </p:cNvSpPr>
                  <p:nvPr/>
                </p:nvSpPr>
                <p:spPr bwMode="auto">
                  <a:xfrm>
                    <a:off x="2824" y="221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51" name="Oval 1170"/>
                  <p:cNvSpPr>
                    <a:spLocks noChangeArrowheads="1"/>
                  </p:cNvSpPr>
                  <p:nvPr/>
                </p:nvSpPr>
                <p:spPr bwMode="auto">
                  <a:xfrm>
                    <a:off x="2810" y="230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52" name="Oval 1171"/>
                  <p:cNvSpPr>
                    <a:spLocks noChangeArrowheads="1"/>
                  </p:cNvSpPr>
                  <p:nvPr/>
                </p:nvSpPr>
                <p:spPr bwMode="auto">
                  <a:xfrm>
                    <a:off x="2789" y="245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53" name="Oval 1172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3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54" name="Oval 1173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26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55" name="Oval 1174"/>
                  <p:cNvSpPr>
                    <a:spLocks noChangeArrowheads="1"/>
                  </p:cNvSpPr>
                  <p:nvPr/>
                </p:nvSpPr>
                <p:spPr bwMode="auto">
                  <a:xfrm>
                    <a:off x="2721" y="247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56" name="Oval 1175"/>
                  <p:cNvSpPr>
                    <a:spLocks noChangeArrowheads="1"/>
                  </p:cNvSpPr>
                  <p:nvPr/>
                </p:nvSpPr>
                <p:spPr bwMode="auto">
                  <a:xfrm>
                    <a:off x="2798" y="226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57" name="Oval 1176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27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58" name="Oval 1177"/>
                  <p:cNvSpPr>
                    <a:spLocks noChangeArrowheads="1"/>
                  </p:cNvSpPr>
                  <p:nvPr/>
                </p:nvSpPr>
                <p:spPr bwMode="auto">
                  <a:xfrm>
                    <a:off x="2702" y="243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59" name="Oval 1178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28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60" name="Oval 1179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406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61" name="Oval 1180"/>
                  <p:cNvSpPr>
                    <a:spLocks noChangeArrowheads="1"/>
                  </p:cNvSpPr>
                  <p:nvPr/>
                </p:nvSpPr>
                <p:spPr bwMode="auto">
                  <a:xfrm>
                    <a:off x="2808" y="2294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62" name="Oval 1181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33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63" name="Oval 1182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2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64" name="Oval 1183"/>
                  <p:cNvSpPr>
                    <a:spLocks noChangeArrowheads="1"/>
                  </p:cNvSpPr>
                  <p:nvPr/>
                </p:nvSpPr>
                <p:spPr bwMode="auto">
                  <a:xfrm>
                    <a:off x="2879" y="230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65" name="Oval 1184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1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66" name="Oval 1185"/>
                  <p:cNvSpPr>
                    <a:spLocks noChangeArrowheads="1"/>
                  </p:cNvSpPr>
                  <p:nvPr/>
                </p:nvSpPr>
                <p:spPr bwMode="auto">
                  <a:xfrm>
                    <a:off x="2771" y="2382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67" name="Oval 1186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63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68" name="Oval 1187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41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69" name="Oval 1188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42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70" name="Oval 1189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11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71" name="Oval 1190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49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72" name="Oval 1191"/>
                  <p:cNvSpPr>
                    <a:spLocks noChangeArrowheads="1"/>
                  </p:cNvSpPr>
                  <p:nvPr/>
                </p:nvSpPr>
                <p:spPr bwMode="auto">
                  <a:xfrm>
                    <a:off x="2858" y="245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73" name="Oval 1192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68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74" name="Oval 1193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41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75" name="Oval 1194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28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76" name="Oval 1195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5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77" name="Oval 1196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32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78" name="Oval 1197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23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79" name="Oval 1198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2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80" name="Oval 1199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286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81" name="Oval 1200"/>
                  <p:cNvSpPr>
                    <a:spLocks noChangeArrowheads="1"/>
                  </p:cNvSpPr>
                  <p:nvPr/>
                </p:nvSpPr>
                <p:spPr bwMode="auto">
                  <a:xfrm>
                    <a:off x="2737" y="2382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82" name="Oval 1201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7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83" name="Oval 1202"/>
                  <p:cNvSpPr>
                    <a:spLocks noChangeArrowheads="1"/>
                  </p:cNvSpPr>
                  <p:nvPr/>
                </p:nvSpPr>
                <p:spPr bwMode="auto">
                  <a:xfrm>
                    <a:off x="2803" y="244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84" name="Oval 1203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6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85" name="Oval 1204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9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86" name="Oval 1205"/>
                  <p:cNvSpPr>
                    <a:spLocks noChangeArrowheads="1"/>
                  </p:cNvSpPr>
                  <p:nvPr/>
                </p:nvSpPr>
                <p:spPr bwMode="auto">
                  <a:xfrm>
                    <a:off x="2849" y="247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87" name="Oval 1206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52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88" name="Oval 1207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404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89" name="Oval 1208"/>
                  <p:cNvSpPr>
                    <a:spLocks noChangeArrowheads="1"/>
                  </p:cNvSpPr>
                  <p:nvPr/>
                </p:nvSpPr>
                <p:spPr bwMode="auto">
                  <a:xfrm>
                    <a:off x="2770" y="241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90" name="Oval 1209"/>
                  <p:cNvSpPr>
                    <a:spLocks noChangeArrowheads="1"/>
                  </p:cNvSpPr>
                  <p:nvPr/>
                </p:nvSpPr>
                <p:spPr bwMode="auto">
                  <a:xfrm>
                    <a:off x="2815" y="230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91" name="Oval 1210"/>
                  <p:cNvSpPr>
                    <a:spLocks noChangeArrowheads="1"/>
                  </p:cNvSpPr>
                  <p:nvPr/>
                </p:nvSpPr>
                <p:spPr bwMode="auto">
                  <a:xfrm>
                    <a:off x="2892" y="235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92" name="Oval 1211"/>
                  <p:cNvSpPr>
                    <a:spLocks noChangeArrowheads="1"/>
                  </p:cNvSpPr>
                  <p:nvPr/>
                </p:nvSpPr>
                <p:spPr bwMode="auto">
                  <a:xfrm>
                    <a:off x="2892" y="226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93" name="Oval 1212"/>
                  <p:cNvSpPr>
                    <a:spLocks noChangeArrowheads="1"/>
                  </p:cNvSpPr>
                  <p:nvPr/>
                </p:nvSpPr>
                <p:spPr bwMode="auto">
                  <a:xfrm>
                    <a:off x="2803" y="2307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94" name="Oval 1213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3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95" name="Oval 1214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1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96" name="Oval 1215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91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97" name="Oval 1216"/>
                  <p:cNvSpPr>
                    <a:spLocks noChangeArrowheads="1"/>
                  </p:cNvSpPr>
                  <p:nvPr/>
                </p:nvSpPr>
                <p:spPr bwMode="auto">
                  <a:xfrm>
                    <a:off x="2843" y="230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98" name="Oval 1217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58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499" name="Oval 1218"/>
                  <p:cNvSpPr>
                    <a:spLocks noChangeArrowheads="1"/>
                  </p:cNvSpPr>
                  <p:nvPr/>
                </p:nvSpPr>
                <p:spPr bwMode="auto">
                  <a:xfrm>
                    <a:off x="2918" y="230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00" name="Oval 1219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8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01" name="Oval 1220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8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02" name="Oval 1221"/>
                  <p:cNvSpPr>
                    <a:spLocks noChangeArrowheads="1"/>
                  </p:cNvSpPr>
                  <p:nvPr/>
                </p:nvSpPr>
                <p:spPr bwMode="auto">
                  <a:xfrm>
                    <a:off x="2918" y="244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03" name="Oval 1222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12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04" name="Oval 1223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52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05" name="Oval 1224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170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06" name="Oval 1225"/>
                  <p:cNvSpPr>
                    <a:spLocks noChangeArrowheads="1"/>
                  </p:cNvSpPr>
                  <p:nvPr/>
                </p:nvSpPr>
                <p:spPr bwMode="auto">
                  <a:xfrm>
                    <a:off x="2768" y="238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07" name="Oval 1226"/>
                  <p:cNvSpPr>
                    <a:spLocks noChangeArrowheads="1"/>
                  </p:cNvSpPr>
                  <p:nvPr/>
                </p:nvSpPr>
                <p:spPr bwMode="auto">
                  <a:xfrm>
                    <a:off x="2858" y="2481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08" name="Oval 1227"/>
                  <p:cNvSpPr>
                    <a:spLocks noChangeArrowheads="1"/>
                  </p:cNvSpPr>
                  <p:nvPr/>
                </p:nvSpPr>
                <p:spPr bwMode="auto">
                  <a:xfrm>
                    <a:off x="2736" y="243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09" name="Oval 1228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24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10" name="Oval 1229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27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11" name="Oval 1230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40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12" name="Oval 1231"/>
                  <p:cNvSpPr>
                    <a:spLocks noChangeArrowheads="1"/>
                  </p:cNvSpPr>
                  <p:nvPr/>
                </p:nvSpPr>
                <p:spPr bwMode="auto">
                  <a:xfrm>
                    <a:off x="2736" y="241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13" name="Oval 1232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6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14" name="Oval 1233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5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15" name="Oval 1234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7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16" name="Oval 1235"/>
                  <p:cNvSpPr>
                    <a:spLocks noChangeArrowheads="1"/>
                  </p:cNvSpPr>
                  <p:nvPr/>
                </p:nvSpPr>
                <p:spPr bwMode="auto">
                  <a:xfrm>
                    <a:off x="2806" y="243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17" name="Oval 1236"/>
                  <p:cNvSpPr>
                    <a:spLocks noChangeArrowheads="1"/>
                  </p:cNvSpPr>
                  <p:nvPr/>
                </p:nvSpPr>
                <p:spPr bwMode="auto">
                  <a:xfrm>
                    <a:off x="2808" y="2341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18" name="Oval 1237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5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19" name="Oval 1238"/>
                  <p:cNvSpPr>
                    <a:spLocks noChangeArrowheads="1"/>
                  </p:cNvSpPr>
                  <p:nvPr/>
                </p:nvSpPr>
                <p:spPr bwMode="auto">
                  <a:xfrm>
                    <a:off x="2876" y="243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20" name="Oval 1239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7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21" name="Oval 1240"/>
                  <p:cNvSpPr>
                    <a:spLocks noChangeArrowheads="1"/>
                  </p:cNvSpPr>
                  <p:nvPr/>
                </p:nvSpPr>
                <p:spPr bwMode="auto">
                  <a:xfrm>
                    <a:off x="2764" y="225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22" name="Oval 1241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52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23" name="Oval 1242"/>
                  <p:cNvSpPr>
                    <a:spLocks noChangeArrowheads="1"/>
                  </p:cNvSpPr>
                  <p:nvPr/>
                </p:nvSpPr>
                <p:spPr bwMode="auto">
                  <a:xfrm>
                    <a:off x="2815" y="242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24" name="Oval 1243"/>
                  <p:cNvSpPr>
                    <a:spLocks noChangeArrowheads="1"/>
                  </p:cNvSpPr>
                  <p:nvPr/>
                </p:nvSpPr>
                <p:spPr bwMode="auto">
                  <a:xfrm>
                    <a:off x="2798" y="242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25" name="Oval 1244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52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26" name="Oval 1245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7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27" name="Oval 1246"/>
                  <p:cNvSpPr>
                    <a:spLocks noChangeArrowheads="1"/>
                  </p:cNvSpPr>
                  <p:nvPr/>
                </p:nvSpPr>
                <p:spPr bwMode="auto">
                  <a:xfrm>
                    <a:off x="2913" y="2441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28" name="Oval 1247"/>
                  <p:cNvSpPr>
                    <a:spLocks noChangeArrowheads="1"/>
                  </p:cNvSpPr>
                  <p:nvPr/>
                </p:nvSpPr>
                <p:spPr bwMode="auto">
                  <a:xfrm>
                    <a:off x="2764" y="238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29" name="Oval 1248"/>
                  <p:cNvSpPr>
                    <a:spLocks noChangeArrowheads="1"/>
                  </p:cNvSpPr>
                  <p:nvPr/>
                </p:nvSpPr>
                <p:spPr bwMode="auto">
                  <a:xfrm>
                    <a:off x="2824" y="245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30" name="Oval 1249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9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31" name="Oval 1250"/>
                  <p:cNvSpPr>
                    <a:spLocks noChangeArrowheads="1"/>
                  </p:cNvSpPr>
                  <p:nvPr/>
                </p:nvSpPr>
                <p:spPr bwMode="auto">
                  <a:xfrm>
                    <a:off x="2770" y="243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32" name="Oval 1251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6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33" name="Oval 1252"/>
                  <p:cNvSpPr>
                    <a:spLocks noChangeArrowheads="1"/>
                  </p:cNvSpPr>
                  <p:nvPr/>
                </p:nvSpPr>
                <p:spPr bwMode="auto">
                  <a:xfrm>
                    <a:off x="2815" y="238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34" name="Oval 1253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40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35" name="Oval 1254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98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36" name="Oval 1255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9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37" name="Oval 1256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2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38" name="Oval 1257"/>
                  <p:cNvSpPr>
                    <a:spLocks noChangeArrowheads="1"/>
                  </p:cNvSpPr>
                  <p:nvPr/>
                </p:nvSpPr>
                <p:spPr bwMode="auto">
                  <a:xfrm>
                    <a:off x="2734" y="238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39" name="Oval 1258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458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40" name="Oval 1259"/>
                  <p:cNvSpPr>
                    <a:spLocks noChangeArrowheads="1"/>
                  </p:cNvSpPr>
                  <p:nvPr/>
                </p:nvSpPr>
                <p:spPr bwMode="auto">
                  <a:xfrm>
                    <a:off x="2824" y="2499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41" name="Oval 1260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8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42" name="Oval 1261"/>
                  <p:cNvSpPr>
                    <a:spLocks noChangeArrowheads="1"/>
                  </p:cNvSpPr>
                  <p:nvPr/>
                </p:nvSpPr>
                <p:spPr bwMode="auto">
                  <a:xfrm>
                    <a:off x="2695" y="244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43" name="Oval 1262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170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44" name="Oval 1263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6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45" name="Oval 1264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5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46" name="Oval 1265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91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47" name="Oval 1266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0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48" name="Oval 1267"/>
                  <p:cNvSpPr>
                    <a:spLocks noChangeArrowheads="1"/>
                  </p:cNvSpPr>
                  <p:nvPr/>
                </p:nvSpPr>
                <p:spPr bwMode="auto">
                  <a:xfrm>
                    <a:off x="2771" y="243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49" name="Oval 1268"/>
                  <p:cNvSpPr>
                    <a:spLocks noChangeArrowheads="1"/>
                  </p:cNvSpPr>
                  <p:nvPr/>
                </p:nvSpPr>
                <p:spPr bwMode="auto">
                  <a:xfrm>
                    <a:off x="2803" y="2385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50" name="Oval 1269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92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51" name="Oval 1270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392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52" name="Oval 1271"/>
                  <p:cNvSpPr>
                    <a:spLocks noChangeArrowheads="1"/>
                  </p:cNvSpPr>
                  <p:nvPr/>
                </p:nvSpPr>
                <p:spPr bwMode="auto">
                  <a:xfrm>
                    <a:off x="2768" y="244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53" name="Oval 1272"/>
                  <p:cNvSpPr>
                    <a:spLocks noChangeArrowheads="1"/>
                  </p:cNvSpPr>
                  <p:nvPr/>
                </p:nvSpPr>
                <p:spPr bwMode="auto">
                  <a:xfrm>
                    <a:off x="2884" y="2445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54" name="Oval 1273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60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55" name="Oval 1274"/>
                  <p:cNvSpPr>
                    <a:spLocks noChangeArrowheads="1"/>
                  </p:cNvSpPr>
                  <p:nvPr/>
                </p:nvSpPr>
                <p:spPr bwMode="auto">
                  <a:xfrm>
                    <a:off x="2918" y="224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56" name="Oval 1275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379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57" name="Oval 1276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92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58" name="Oval 1277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124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59" name="Oval 1278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404"/>
                    <a:ext cx="22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60" name="Oval 1279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7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61" name="Oval 1280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377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62" name="Oval 1281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412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63" name="Oval 1282"/>
                  <p:cNvSpPr>
                    <a:spLocks noChangeArrowheads="1"/>
                  </p:cNvSpPr>
                  <p:nvPr/>
                </p:nvSpPr>
                <p:spPr bwMode="auto">
                  <a:xfrm>
                    <a:off x="2815" y="2474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64" name="Oval 1283"/>
                  <p:cNvSpPr>
                    <a:spLocks noChangeArrowheads="1"/>
                  </p:cNvSpPr>
                  <p:nvPr/>
                </p:nvSpPr>
                <p:spPr bwMode="auto">
                  <a:xfrm>
                    <a:off x="2755" y="245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65" name="Oval 1284"/>
                  <p:cNvSpPr>
                    <a:spLocks noChangeArrowheads="1"/>
                  </p:cNvSpPr>
                  <p:nvPr/>
                </p:nvSpPr>
                <p:spPr bwMode="auto">
                  <a:xfrm>
                    <a:off x="2841" y="237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66" name="Oval 1285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324"/>
                    <a:ext cx="23" cy="22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67" name="Oval 1286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42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68" name="Oval 1287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68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69" name="Oval 1288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49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70" name="Oval 1289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37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71" name="Oval 1290"/>
                  <p:cNvSpPr>
                    <a:spLocks noChangeArrowheads="1"/>
                  </p:cNvSpPr>
                  <p:nvPr/>
                </p:nvSpPr>
                <p:spPr bwMode="auto">
                  <a:xfrm>
                    <a:off x="2738" y="2457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72" name="Oval 1291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490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73" name="Oval 1292"/>
                  <p:cNvSpPr>
                    <a:spLocks noChangeArrowheads="1"/>
                  </p:cNvSpPr>
                  <p:nvPr/>
                </p:nvSpPr>
                <p:spPr bwMode="auto">
                  <a:xfrm>
                    <a:off x="2875" y="2373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74" name="Oval 1293"/>
                  <p:cNvSpPr>
                    <a:spLocks noChangeArrowheads="1"/>
                  </p:cNvSpPr>
                  <p:nvPr/>
                </p:nvSpPr>
                <p:spPr bwMode="auto">
                  <a:xfrm>
                    <a:off x="2704" y="2409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75" name="Oval 1294"/>
                  <p:cNvSpPr>
                    <a:spLocks noChangeArrowheads="1"/>
                  </p:cNvSpPr>
                  <p:nvPr/>
                </p:nvSpPr>
                <p:spPr bwMode="auto">
                  <a:xfrm>
                    <a:off x="2910" y="2455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76" name="Oval 1295"/>
                  <p:cNvSpPr>
                    <a:spLocks noChangeArrowheads="1"/>
                  </p:cNvSpPr>
                  <p:nvPr/>
                </p:nvSpPr>
                <p:spPr bwMode="auto">
                  <a:xfrm>
                    <a:off x="2807" y="2411"/>
                    <a:ext cx="22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  <p:sp>
                <p:nvSpPr>
                  <p:cNvPr id="1577" name="Oval 1296"/>
                  <p:cNvSpPr>
                    <a:spLocks noChangeArrowheads="1"/>
                  </p:cNvSpPr>
                  <p:nvPr/>
                </p:nvSpPr>
                <p:spPr bwMode="auto">
                  <a:xfrm>
                    <a:off x="2772" y="2526"/>
                    <a:ext cx="23" cy="23"/>
                  </a:xfrm>
                  <a:prstGeom prst="ellipse">
                    <a:avLst/>
                  </a:pr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IN" dirty="0"/>
                  </a:p>
                </p:txBody>
              </p:sp>
            </p:grpSp>
            <p:sp>
              <p:nvSpPr>
                <p:cNvPr id="1297" name="Oval 1298"/>
                <p:cNvSpPr>
                  <a:spLocks noChangeArrowheads="1"/>
                </p:cNvSpPr>
                <p:nvPr/>
              </p:nvSpPr>
              <p:spPr bwMode="auto">
                <a:xfrm>
                  <a:off x="2772" y="2389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298" name="Oval 1299"/>
                <p:cNvSpPr>
                  <a:spLocks noChangeArrowheads="1"/>
                </p:cNvSpPr>
                <p:nvPr/>
              </p:nvSpPr>
              <p:spPr bwMode="auto">
                <a:xfrm>
                  <a:off x="2843" y="2439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299" name="Oval 1300"/>
                <p:cNvSpPr>
                  <a:spLocks noChangeArrowheads="1"/>
                </p:cNvSpPr>
                <p:nvPr/>
              </p:nvSpPr>
              <p:spPr bwMode="auto">
                <a:xfrm>
                  <a:off x="2841" y="2403"/>
                  <a:ext cx="23" cy="2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00" name="Oval 1301"/>
                <p:cNvSpPr>
                  <a:spLocks noChangeArrowheads="1"/>
                </p:cNvSpPr>
                <p:nvPr/>
              </p:nvSpPr>
              <p:spPr bwMode="auto">
                <a:xfrm>
                  <a:off x="2875" y="2405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01" name="Oval 1302"/>
                <p:cNvSpPr>
                  <a:spLocks noChangeArrowheads="1"/>
                </p:cNvSpPr>
                <p:nvPr/>
              </p:nvSpPr>
              <p:spPr bwMode="auto">
                <a:xfrm>
                  <a:off x="2841" y="2494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02" name="Oval 1303"/>
                <p:cNvSpPr>
                  <a:spLocks noChangeArrowheads="1"/>
                </p:cNvSpPr>
                <p:nvPr/>
              </p:nvSpPr>
              <p:spPr bwMode="auto">
                <a:xfrm>
                  <a:off x="2772" y="2356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03" name="Oval 1304"/>
                <p:cNvSpPr>
                  <a:spLocks noChangeArrowheads="1"/>
                </p:cNvSpPr>
                <p:nvPr/>
              </p:nvSpPr>
              <p:spPr bwMode="auto">
                <a:xfrm>
                  <a:off x="2798" y="2473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04" name="Oval 1305"/>
                <p:cNvSpPr>
                  <a:spLocks noChangeArrowheads="1"/>
                </p:cNvSpPr>
                <p:nvPr/>
              </p:nvSpPr>
              <p:spPr bwMode="auto">
                <a:xfrm>
                  <a:off x="2815" y="2448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05" name="Oval 1306"/>
                <p:cNvSpPr>
                  <a:spLocks noChangeArrowheads="1"/>
                </p:cNvSpPr>
                <p:nvPr/>
              </p:nvSpPr>
              <p:spPr bwMode="auto">
                <a:xfrm>
                  <a:off x="2789" y="2483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06" name="Oval 1307"/>
                <p:cNvSpPr>
                  <a:spLocks noChangeArrowheads="1"/>
                </p:cNvSpPr>
                <p:nvPr/>
              </p:nvSpPr>
              <p:spPr bwMode="auto">
                <a:xfrm>
                  <a:off x="2910" y="2504"/>
                  <a:ext cx="22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07" name="Oval 1308"/>
                <p:cNvSpPr>
                  <a:spLocks noChangeArrowheads="1"/>
                </p:cNvSpPr>
                <p:nvPr/>
              </p:nvSpPr>
              <p:spPr bwMode="auto">
                <a:xfrm>
                  <a:off x="2772" y="2659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08" name="Oval 1309"/>
                <p:cNvSpPr>
                  <a:spLocks noChangeArrowheads="1"/>
                </p:cNvSpPr>
                <p:nvPr/>
              </p:nvSpPr>
              <p:spPr bwMode="auto">
                <a:xfrm>
                  <a:off x="2704" y="2456"/>
                  <a:ext cx="22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09" name="Oval 1310"/>
                <p:cNvSpPr>
                  <a:spLocks noChangeArrowheads="1"/>
                </p:cNvSpPr>
                <p:nvPr/>
              </p:nvSpPr>
              <p:spPr bwMode="auto">
                <a:xfrm>
                  <a:off x="2875" y="2423"/>
                  <a:ext cx="23" cy="2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10" name="Oval 1311"/>
                <p:cNvSpPr>
                  <a:spLocks noChangeArrowheads="1"/>
                </p:cNvSpPr>
                <p:nvPr/>
              </p:nvSpPr>
              <p:spPr bwMode="auto">
                <a:xfrm>
                  <a:off x="2738" y="2506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11" name="Oval 1312"/>
                <p:cNvSpPr>
                  <a:spLocks noChangeArrowheads="1"/>
                </p:cNvSpPr>
                <p:nvPr/>
              </p:nvSpPr>
              <p:spPr bwMode="auto">
                <a:xfrm>
                  <a:off x="2721" y="2449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12" name="Oval 1313"/>
                <p:cNvSpPr>
                  <a:spLocks noChangeArrowheads="1"/>
                </p:cNvSpPr>
                <p:nvPr/>
              </p:nvSpPr>
              <p:spPr bwMode="auto">
                <a:xfrm>
                  <a:off x="2875" y="2397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13" name="Oval 1314"/>
                <p:cNvSpPr>
                  <a:spLocks noChangeArrowheads="1"/>
                </p:cNvSpPr>
                <p:nvPr/>
              </p:nvSpPr>
              <p:spPr bwMode="auto">
                <a:xfrm>
                  <a:off x="2808" y="2384"/>
                  <a:ext cx="23" cy="2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14" name="Oval 1315"/>
                <p:cNvSpPr>
                  <a:spLocks noChangeArrowheads="1"/>
                </p:cNvSpPr>
                <p:nvPr/>
              </p:nvSpPr>
              <p:spPr bwMode="auto">
                <a:xfrm>
                  <a:off x="2789" y="2501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15" name="Oval 1316"/>
                <p:cNvSpPr>
                  <a:spLocks noChangeArrowheads="1"/>
                </p:cNvSpPr>
                <p:nvPr/>
              </p:nvSpPr>
              <p:spPr bwMode="auto">
                <a:xfrm>
                  <a:off x="2772" y="2368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16" name="Oval 1317"/>
                <p:cNvSpPr>
                  <a:spLocks noChangeArrowheads="1"/>
                </p:cNvSpPr>
                <p:nvPr/>
              </p:nvSpPr>
              <p:spPr bwMode="auto">
                <a:xfrm>
                  <a:off x="2808" y="2383"/>
                  <a:ext cx="22" cy="2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17" name="Oval 1318"/>
                <p:cNvSpPr>
                  <a:spLocks noChangeArrowheads="1"/>
                </p:cNvSpPr>
                <p:nvPr/>
              </p:nvSpPr>
              <p:spPr bwMode="auto">
                <a:xfrm>
                  <a:off x="2824" y="2483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18" name="Oval 1319"/>
                <p:cNvSpPr>
                  <a:spLocks noChangeArrowheads="1"/>
                </p:cNvSpPr>
                <p:nvPr/>
              </p:nvSpPr>
              <p:spPr bwMode="auto">
                <a:xfrm>
                  <a:off x="2841" y="2369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19" name="Oval 1320"/>
                <p:cNvSpPr>
                  <a:spLocks noChangeArrowheads="1"/>
                </p:cNvSpPr>
                <p:nvPr/>
              </p:nvSpPr>
              <p:spPr bwMode="auto">
                <a:xfrm>
                  <a:off x="2815" y="2266"/>
                  <a:ext cx="23" cy="2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20" name="Oval 1321"/>
                <p:cNvSpPr>
                  <a:spLocks noChangeArrowheads="1"/>
                </p:cNvSpPr>
                <p:nvPr/>
              </p:nvSpPr>
              <p:spPr bwMode="auto">
                <a:xfrm>
                  <a:off x="2910" y="2381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21" name="Oval 1322"/>
                <p:cNvSpPr>
                  <a:spLocks noChangeArrowheads="1"/>
                </p:cNvSpPr>
                <p:nvPr/>
              </p:nvSpPr>
              <p:spPr bwMode="auto">
                <a:xfrm>
                  <a:off x="2910" y="2368"/>
                  <a:ext cx="22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22" name="Oval 1323"/>
                <p:cNvSpPr>
                  <a:spLocks noChangeArrowheads="1"/>
                </p:cNvSpPr>
                <p:nvPr/>
              </p:nvSpPr>
              <p:spPr bwMode="auto">
                <a:xfrm>
                  <a:off x="2841" y="2328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23" name="Oval 1324"/>
                <p:cNvSpPr>
                  <a:spLocks noChangeArrowheads="1"/>
                </p:cNvSpPr>
                <p:nvPr/>
              </p:nvSpPr>
              <p:spPr bwMode="auto">
                <a:xfrm>
                  <a:off x="2841" y="2571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24" name="Oval 1325"/>
                <p:cNvSpPr>
                  <a:spLocks noChangeArrowheads="1"/>
                </p:cNvSpPr>
                <p:nvPr/>
              </p:nvSpPr>
              <p:spPr bwMode="auto">
                <a:xfrm>
                  <a:off x="2910" y="2323"/>
                  <a:ext cx="22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25" name="Oval 1326"/>
                <p:cNvSpPr>
                  <a:spLocks noChangeArrowheads="1"/>
                </p:cNvSpPr>
                <p:nvPr/>
              </p:nvSpPr>
              <p:spPr bwMode="auto">
                <a:xfrm>
                  <a:off x="2824" y="2312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26" name="Oval 1327"/>
                <p:cNvSpPr>
                  <a:spLocks noChangeArrowheads="1"/>
                </p:cNvSpPr>
                <p:nvPr/>
              </p:nvSpPr>
              <p:spPr bwMode="auto">
                <a:xfrm>
                  <a:off x="2737" y="2434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27" name="Oval 1328"/>
                <p:cNvSpPr>
                  <a:spLocks noChangeArrowheads="1"/>
                </p:cNvSpPr>
                <p:nvPr/>
              </p:nvSpPr>
              <p:spPr bwMode="auto">
                <a:xfrm>
                  <a:off x="2879" y="2418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28" name="Line 1329"/>
                <p:cNvSpPr>
                  <a:spLocks noChangeShapeType="1"/>
                </p:cNvSpPr>
                <p:nvPr/>
              </p:nvSpPr>
              <p:spPr bwMode="auto">
                <a:xfrm>
                  <a:off x="2692" y="2389"/>
                  <a:ext cx="252" cy="0"/>
                </a:xfrm>
                <a:prstGeom prst="line">
                  <a:avLst/>
                </a:prstGeom>
                <a:noFill/>
                <a:ln w="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29" name="Oval 1330"/>
                <p:cNvSpPr>
                  <a:spLocks noChangeArrowheads="1"/>
                </p:cNvSpPr>
                <p:nvPr/>
              </p:nvSpPr>
              <p:spPr bwMode="auto">
                <a:xfrm>
                  <a:off x="3184" y="2536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30" name="Oval 1331"/>
                <p:cNvSpPr>
                  <a:spLocks noChangeArrowheads="1"/>
                </p:cNvSpPr>
                <p:nvPr/>
              </p:nvSpPr>
              <p:spPr bwMode="auto">
                <a:xfrm>
                  <a:off x="3184" y="2627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31" name="Oval 1332"/>
                <p:cNvSpPr>
                  <a:spLocks noChangeArrowheads="1"/>
                </p:cNvSpPr>
                <p:nvPr/>
              </p:nvSpPr>
              <p:spPr bwMode="auto">
                <a:xfrm>
                  <a:off x="3184" y="2295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32" name="Oval 1333"/>
                <p:cNvSpPr>
                  <a:spLocks noChangeArrowheads="1"/>
                </p:cNvSpPr>
                <p:nvPr/>
              </p:nvSpPr>
              <p:spPr bwMode="auto">
                <a:xfrm>
                  <a:off x="3184" y="2151"/>
                  <a:ext cx="23" cy="2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33" name="Oval 1334"/>
                <p:cNvSpPr>
                  <a:spLocks noChangeArrowheads="1"/>
                </p:cNvSpPr>
                <p:nvPr/>
              </p:nvSpPr>
              <p:spPr bwMode="auto">
                <a:xfrm>
                  <a:off x="3150" y="2141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34" name="Oval 1335"/>
                <p:cNvSpPr>
                  <a:spLocks noChangeArrowheads="1"/>
                </p:cNvSpPr>
                <p:nvPr/>
              </p:nvSpPr>
              <p:spPr bwMode="auto">
                <a:xfrm>
                  <a:off x="3218" y="2116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35" name="Line 1336"/>
                <p:cNvSpPr>
                  <a:spLocks noChangeShapeType="1"/>
                </p:cNvSpPr>
                <p:nvPr/>
              </p:nvSpPr>
              <p:spPr bwMode="auto">
                <a:xfrm>
                  <a:off x="3070" y="2322"/>
                  <a:ext cx="251" cy="0"/>
                </a:xfrm>
                <a:prstGeom prst="line">
                  <a:avLst/>
                </a:prstGeom>
                <a:noFill/>
                <a:ln w="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36" name="Oval 1337"/>
                <p:cNvSpPr>
                  <a:spLocks noChangeArrowheads="1"/>
                </p:cNvSpPr>
                <p:nvPr/>
              </p:nvSpPr>
              <p:spPr bwMode="auto">
                <a:xfrm>
                  <a:off x="3527" y="2560"/>
                  <a:ext cx="23" cy="2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37" name="Oval 1338"/>
                <p:cNvSpPr>
                  <a:spLocks noChangeArrowheads="1"/>
                </p:cNvSpPr>
                <p:nvPr/>
              </p:nvSpPr>
              <p:spPr bwMode="auto">
                <a:xfrm>
                  <a:off x="3562" y="2451"/>
                  <a:ext cx="22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38" name="Oval 1339"/>
                <p:cNvSpPr>
                  <a:spLocks noChangeArrowheads="1"/>
                </p:cNvSpPr>
                <p:nvPr/>
              </p:nvSpPr>
              <p:spPr bwMode="auto">
                <a:xfrm>
                  <a:off x="3527" y="2592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39" name="Oval 1340"/>
                <p:cNvSpPr>
                  <a:spLocks noChangeArrowheads="1"/>
                </p:cNvSpPr>
                <p:nvPr/>
              </p:nvSpPr>
              <p:spPr bwMode="auto">
                <a:xfrm>
                  <a:off x="3596" y="2404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40" name="Oval 1341"/>
                <p:cNvSpPr>
                  <a:spLocks noChangeArrowheads="1"/>
                </p:cNvSpPr>
                <p:nvPr/>
              </p:nvSpPr>
              <p:spPr bwMode="auto">
                <a:xfrm>
                  <a:off x="3493" y="2395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41" name="Oval 1342"/>
                <p:cNvSpPr>
                  <a:spLocks noChangeArrowheads="1"/>
                </p:cNvSpPr>
                <p:nvPr/>
              </p:nvSpPr>
              <p:spPr bwMode="auto">
                <a:xfrm>
                  <a:off x="3596" y="2573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42" name="Oval 1343"/>
                <p:cNvSpPr>
                  <a:spLocks noChangeArrowheads="1"/>
                </p:cNvSpPr>
                <p:nvPr/>
              </p:nvSpPr>
              <p:spPr bwMode="auto">
                <a:xfrm>
                  <a:off x="3527" y="2412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43" name="Oval 1344"/>
                <p:cNvSpPr>
                  <a:spLocks noChangeArrowheads="1"/>
                </p:cNvSpPr>
                <p:nvPr/>
              </p:nvSpPr>
              <p:spPr bwMode="auto">
                <a:xfrm>
                  <a:off x="3562" y="2625"/>
                  <a:ext cx="22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44" name="Oval 1345"/>
                <p:cNvSpPr>
                  <a:spLocks noChangeArrowheads="1"/>
                </p:cNvSpPr>
                <p:nvPr/>
              </p:nvSpPr>
              <p:spPr bwMode="auto">
                <a:xfrm>
                  <a:off x="3562" y="2579"/>
                  <a:ext cx="22" cy="2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45" name="Oval 1346"/>
                <p:cNvSpPr>
                  <a:spLocks noChangeArrowheads="1"/>
                </p:cNvSpPr>
                <p:nvPr/>
              </p:nvSpPr>
              <p:spPr bwMode="auto">
                <a:xfrm>
                  <a:off x="3527" y="2255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46" name="Oval 1347"/>
                <p:cNvSpPr>
                  <a:spLocks noChangeArrowheads="1"/>
                </p:cNvSpPr>
                <p:nvPr/>
              </p:nvSpPr>
              <p:spPr bwMode="auto">
                <a:xfrm>
                  <a:off x="3562" y="2371"/>
                  <a:ext cx="22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47" name="Oval 1348"/>
                <p:cNvSpPr>
                  <a:spLocks noChangeArrowheads="1"/>
                </p:cNvSpPr>
                <p:nvPr/>
              </p:nvSpPr>
              <p:spPr bwMode="auto">
                <a:xfrm>
                  <a:off x="3527" y="2501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48" name="Oval 1349"/>
                <p:cNvSpPr>
                  <a:spLocks noChangeArrowheads="1"/>
                </p:cNvSpPr>
                <p:nvPr/>
              </p:nvSpPr>
              <p:spPr bwMode="auto">
                <a:xfrm>
                  <a:off x="3562" y="2506"/>
                  <a:ext cx="22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49" name="Oval 1350"/>
                <p:cNvSpPr>
                  <a:spLocks noChangeArrowheads="1"/>
                </p:cNvSpPr>
                <p:nvPr/>
              </p:nvSpPr>
              <p:spPr bwMode="auto">
                <a:xfrm>
                  <a:off x="3459" y="2388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50" name="Oval 1351"/>
                <p:cNvSpPr>
                  <a:spLocks noChangeArrowheads="1"/>
                </p:cNvSpPr>
                <p:nvPr/>
              </p:nvSpPr>
              <p:spPr bwMode="auto">
                <a:xfrm>
                  <a:off x="3596" y="2451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51" name="Oval 1352"/>
                <p:cNvSpPr>
                  <a:spLocks noChangeArrowheads="1"/>
                </p:cNvSpPr>
                <p:nvPr/>
              </p:nvSpPr>
              <p:spPr bwMode="auto">
                <a:xfrm>
                  <a:off x="3527" y="2682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52" name="Oval 1353"/>
                <p:cNvSpPr>
                  <a:spLocks noChangeArrowheads="1"/>
                </p:cNvSpPr>
                <p:nvPr/>
              </p:nvSpPr>
              <p:spPr bwMode="auto">
                <a:xfrm>
                  <a:off x="3665" y="2382"/>
                  <a:ext cx="22" cy="2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53" name="Oval 1354"/>
                <p:cNvSpPr>
                  <a:spLocks noChangeArrowheads="1"/>
                </p:cNvSpPr>
                <p:nvPr/>
              </p:nvSpPr>
              <p:spPr bwMode="auto">
                <a:xfrm>
                  <a:off x="3562" y="2273"/>
                  <a:ext cx="22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54" name="Oval 1355"/>
                <p:cNvSpPr>
                  <a:spLocks noChangeArrowheads="1"/>
                </p:cNvSpPr>
                <p:nvPr/>
              </p:nvSpPr>
              <p:spPr bwMode="auto">
                <a:xfrm>
                  <a:off x="3562" y="2330"/>
                  <a:ext cx="22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55" name="Oval 1356"/>
                <p:cNvSpPr>
                  <a:spLocks noChangeArrowheads="1"/>
                </p:cNvSpPr>
                <p:nvPr/>
              </p:nvSpPr>
              <p:spPr bwMode="auto">
                <a:xfrm>
                  <a:off x="3630" y="2395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56" name="Oval 1357"/>
                <p:cNvSpPr>
                  <a:spLocks noChangeArrowheads="1"/>
                </p:cNvSpPr>
                <p:nvPr/>
              </p:nvSpPr>
              <p:spPr bwMode="auto">
                <a:xfrm>
                  <a:off x="3527" y="2120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57" name="Oval 1358"/>
                <p:cNvSpPr>
                  <a:spLocks noChangeArrowheads="1"/>
                </p:cNvSpPr>
                <p:nvPr/>
              </p:nvSpPr>
              <p:spPr bwMode="auto">
                <a:xfrm>
                  <a:off x="3459" y="2098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58" name="Oval 1359"/>
                <p:cNvSpPr>
                  <a:spLocks noChangeArrowheads="1"/>
                </p:cNvSpPr>
                <p:nvPr/>
              </p:nvSpPr>
              <p:spPr bwMode="auto">
                <a:xfrm>
                  <a:off x="3562" y="1944"/>
                  <a:ext cx="22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59" name="Oval 1360"/>
                <p:cNvSpPr>
                  <a:spLocks noChangeArrowheads="1"/>
                </p:cNvSpPr>
                <p:nvPr/>
              </p:nvSpPr>
              <p:spPr bwMode="auto">
                <a:xfrm>
                  <a:off x="3562" y="2699"/>
                  <a:ext cx="22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60" name="Oval 1361"/>
                <p:cNvSpPr>
                  <a:spLocks noChangeArrowheads="1"/>
                </p:cNvSpPr>
                <p:nvPr/>
              </p:nvSpPr>
              <p:spPr bwMode="auto">
                <a:xfrm>
                  <a:off x="3596" y="2686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61" name="Oval 1362"/>
                <p:cNvSpPr>
                  <a:spLocks noChangeArrowheads="1"/>
                </p:cNvSpPr>
                <p:nvPr/>
              </p:nvSpPr>
              <p:spPr bwMode="auto">
                <a:xfrm>
                  <a:off x="3562" y="2414"/>
                  <a:ext cx="22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62" name="Oval 1363"/>
                <p:cNvSpPr>
                  <a:spLocks noChangeArrowheads="1"/>
                </p:cNvSpPr>
                <p:nvPr/>
              </p:nvSpPr>
              <p:spPr bwMode="auto">
                <a:xfrm>
                  <a:off x="3562" y="2085"/>
                  <a:ext cx="22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63" name="Oval 1364"/>
                <p:cNvSpPr>
                  <a:spLocks noChangeArrowheads="1"/>
                </p:cNvSpPr>
                <p:nvPr/>
              </p:nvSpPr>
              <p:spPr bwMode="auto">
                <a:xfrm>
                  <a:off x="3596" y="2081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64" name="Oval 1365"/>
                <p:cNvSpPr>
                  <a:spLocks noChangeArrowheads="1"/>
                </p:cNvSpPr>
                <p:nvPr/>
              </p:nvSpPr>
              <p:spPr bwMode="auto">
                <a:xfrm>
                  <a:off x="3562" y="2172"/>
                  <a:ext cx="22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65" name="Oval 1366"/>
                <p:cNvSpPr>
                  <a:spLocks noChangeArrowheads="1"/>
                </p:cNvSpPr>
                <p:nvPr/>
              </p:nvSpPr>
              <p:spPr bwMode="auto">
                <a:xfrm>
                  <a:off x="3562" y="2131"/>
                  <a:ext cx="22" cy="2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66" name="Oval 1367"/>
                <p:cNvSpPr>
                  <a:spLocks noChangeArrowheads="1"/>
                </p:cNvSpPr>
                <p:nvPr/>
              </p:nvSpPr>
              <p:spPr bwMode="auto">
                <a:xfrm>
                  <a:off x="3493" y="2160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67" name="Oval 1368"/>
                <p:cNvSpPr>
                  <a:spLocks noChangeArrowheads="1"/>
                </p:cNvSpPr>
                <p:nvPr/>
              </p:nvSpPr>
              <p:spPr bwMode="auto">
                <a:xfrm>
                  <a:off x="3527" y="2170"/>
                  <a:ext cx="23" cy="2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68" name="Oval 1369"/>
                <p:cNvSpPr>
                  <a:spLocks noChangeArrowheads="1"/>
                </p:cNvSpPr>
                <p:nvPr/>
              </p:nvSpPr>
              <p:spPr bwMode="auto">
                <a:xfrm>
                  <a:off x="3596" y="2264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69" name="Oval 1370"/>
                <p:cNvSpPr>
                  <a:spLocks noChangeArrowheads="1"/>
                </p:cNvSpPr>
                <p:nvPr/>
              </p:nvSpPr>
              <p:spPr bwMode="auto">
                <a:xfrm>
                  <a:off x="3562" y="2211"/>
                  <a:ext cx="22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70" name="Oval 1371"/>
                <p:cNvSpPr>
                  <a:spLocks noChangeArrowheads="1"/>
                </p:cNvSpPr>
                <p:nvPr/>
              </p:nvSpPr>
              <p:spPr bwMode="auto">
                <a:xfrm>
                  <a:off x="3596" y="2120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71" name="Oval 1372"/>
                <p:cNvSpPr>
                  <a:spLocks noChangeArrowheads="1"/>
                </p:cNvSpPr>
                <p:nvPr/>
              </p:nvSpPr>
              <p:spPr bwMode="auto">
                <a:xfrm>
                  <a:off x="3630" y="2168"/>
                  <a:ext cx="23" cy="22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72" name="Oval 1373"/>
                <p:cNvSpPr>
                  <a:spLocks noChangeArrowheads="1"/>
                </p:cNvSpPr>
                <p:nvPr/>
              </p:nvSpPr>
              <p:spPr bwMode="auto">
                <a:xfrm>
                  <a:off x="3527" y="2297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73" name="Oval 1374"/>
                <p:cNvSpPr>
                  <a:spLocks noChangeArrowheads="1"/>
                </p:cNvSpPr>
                <p:nvPr/>
              </p:nvSpPr>
              <p:spPr bwMode="auto">
                <a:xfrm>
                  <a:off x="3630" y="2105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74" name="Oval 1375"/>
                <p:cNvSpPr>
                  <a:spLocks noChangeArrowheads="1"/>
                </p:cNvSpPr>
                <p:nvPr/>
              </p:nvSpPr>
              <p:spPr bwMode="auto">
                <a:xfrm>
                  <a:off x="3596" y="2172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75" name="Oval 1376"/>
                <p:cNvSpPr>
                  <a:spLocks noChangeArrowheads="1"/>
                </p:cNvSpPr>
                <p:nvPr/>
              </p:nvSpPr>
              <p:spPr bwMode="auto">
                <a:xfrm>
                  <a:off x="3493" y="2113"/>
                  <a:ext cx="23" cy="23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76" name="Line 1377"/>
                <p:cNvSpPr>
                  <a:spLocks noChangeShapeType="1"/>
                </p:cNvSpPr>
                <p:nvPr/>
              </p:nvSpPr>
              <p:spPr bwMode="auto">
                <a:xfrm>
                  <a:off x="3447" y="2345"/>
                  <a:ext cx="252" cy="0"/>
                </a:xfrm>
                <a:prstGeom prst="line">
                  <a:avLst/>
                </a:prstGeom>
                <a:noFill/>
                <a:ln w="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 dirty="0"/>
                </a:p>
              </p:txBody>
            </p:sp>
            <p:sp>
              <p:nvSpPr>
                <p:cNvPr id="1377" name="Rectangle 1378"/>
                <p:cNvSpPr>
                  <a:spLocks noChangeArrowheads="1"/>
                </p:cNvSpPr>
                <p:nvPr/>
              </p:nvSpPr>
              <p:spPr bwMode="auto">
                <a:xfrm rot="16200000">
                  <a:off x="1424" y="2246"/>
                  <a:ext cx="992" cy="2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algn="ctr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kumimoji="0" lang="en-US" sz="10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itchFamily="18" charset="0"/>
                      <a:cs typeface="Arial" pitchFamily="34" charset="0"/>
                    </a:rPr>
                    <a:t>MMP21 transcript</a:t>
                  </a:r>
                </a:p>
                <a:p>
                  <a:pPr algn="ctr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kumimoji="0" lang="en-US" sz="10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itchFamily="18" charset="0"/>
                      <a:cs typeface="Arial" pitchFamily="34" charset="0"/>
                    </a:rPr>
                    <a:t>(Log</a:t>
                  </a:r>
                  <a:r>
                    <a:rPr kumimoji="0" lang="en-US" sz="1000" b="1" i="0" u="none" strike="noStrike" cap="none" normalizeH="0" baseline="-2500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itchFamily="18" charset="0"/>
                      <a:cs typeface="Arial" pitchFamily="34" charset="0"/>
                    </a:rPr>
                    <a:t>2</a:t>
                  </a:r>
                  <a:r>
                    <a:rPr kumimoji="0" lang="en-US" sz="10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itchFamily="18" charset="0"/>
                      <a:cs typeface="Arial" pitchFamily="34" charset="0"/>
                    </a:rPr>
                    <a:t> ratio)</a:t>
                  </a:r>
                  <a:endPara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286" name="TextBox 1285"/>
              <p:cNvSpPr txBox="1"/>
              <p:nvPr/>
            </p:nvSpPr>
            <p:spPr>
              <a:xfrm>
                <a:off x="2400263" y="4219415"/>
                <a:ext cx="1681497" cy="20871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Times New Roman" pitchFamily="18" charset="0"/>
                    <a:cs typeface="Times New Roman" pitchFamily="18" charset="0"/>
                  </a:rPr>
                  <a:t> TCGA ii            GSE22866</a:t>
                </a:r>
                <a:endParaRPr lang="en-IN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1287" name="Straight Connector 1286"/>
              <p:cNvCxnSpPr/>
              <p:nvPr/>
            </p:nvCxnSpPr>
            <p:spPr>
              <a:xfrm>
                <a:off x="2385475" y="4212569"/>
                <a:ext cx="72598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8" name="Straight Connector 1287"/>
              <p:cNvCxnSpPr/>
              <p:nvPr/>
            </p:nvCxnSpPr>
            <p:spPr>
              <a:xfrm>
                <a:off x="3278847" y="4213699"/>
                <a:ext cx="72598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89" name="Right Bracket 1288"/>
              <p:cNvSpPr/>
              <p:nvPr/>
            </p:nvSpPr>
            <p:spPr>
              <a:xfrm rot="16200000">
                <a:off x="2719007" y="2600688"/>
                <a:ext cx="64008" cy="457200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IN" dirty="0"/>
              </a:p>
            </p:txBody>
          </p:sp>
          <p:sp>
            <p:nvSpPr>
              <p:cNvPr id="1290" name="Right Bracket 1289"/>
              <p:cNvSpPr/>
              <p:nvPr/>
            </p:nvSpPr>
            <p:spPr>
              <a:xfrm rot="16200000">
                <a:off x="3632420" y="2600688"/>
                <a:ext cx="64008" cy="457200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IN" dirty="0"/>
              </a:p>
            </p:txBody>
          </p:sp>
          <p:sp>
            <p:nvSpPr>
              <p:cNvPr id="1291" name="TextBox 1290"/>
              <p:cNvSpPr txBox="1"/>
              <p:nvPr/>
            </p:nvSpPr>
            <p:spPr>
              <a:xfrm>
                <a:off x="2581734" y="2597941"/>
                <a:ext cx="338554" cy="25569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itchFamily="18" charset="0"/>
                    <a:cs typeface="Times New Roman" pitchFamily="18" charset="0"/>
                  </a:rPr>
                  <a:t>**</a:t>
                </a:r>
                <a:endParaRPr lang="en-IN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292" name="TextBox 1291"/>
              <p:cNvSpPr txBox="1"/>
              <p:nvPr/>
            </p:nvSpPr>
            <p:spPr>
              <a:xfrm>
                <a:off x="3520723" y="2594599"/>
                <a:ext cx="298480" cy="2272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ns</a:t>
                </a:r>
                <a:endParaRPr lang="en-IN" sz="10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1281" name="Rectangle 13"/>
            <p:cNvSpPr>
              <a:spLocks noChangeArrowheads="1"/>
            </p:cNvSpPr>
            <p:nvPr/>
          </p:nvSpPr>
          <p:spPr bwMode="auto">
            <a:xfrm>
              <a:off x="4635933" y="3553727"/>
              <a:ext cx="367251" cy="2510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Control </a:t>
              </a:r>
            </a:p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Brain</a:t>
              </a:r>
              <a:endParaRPr kumimoji="0" lang="en-US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2" name="Rectangle 13"/>
            <p:cNvSpPr>
              <a:spLocks noChangeArrowheads="1"/>
            </p:cNvSpPr>
            <p:nvPr/>
          </p:nvSpPr>
          <p:spPr bwMode="auto">
            <a:xfrm>
              <a:off x="3559948" y="3553727"/>
              <a:ext cx="367420" cy="251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Control </a:t>
              </a:r>
            </a:p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Brain</a:t>
              </a:r>
              <a:endParaRPr kumimoji="0" lang="en-US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3" name="Rectangle 15"/>
            <p:cNvSpPr>
              <a:spLocks noChangeArrowheads="1"/>
            </p:cNvSpPr>
            <p:nvPr/>
          </p:nvSpPr>
          <p:spPr bwMode="auto">
            <a:xfrm>
              <a:off x="4138138" y="3553727"/>
              <a:ext cx="275946" cy="132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GBM</a:t>
              </a:r>
              <a:endPara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4" name="Rectangle 1283"/>
            <p:cNvSpPr>
              <a:spLocks noChangeArrowheads="1"/>
            </p:cNvSpPr>
            <p:nvPr/>
          </p:nvSpPr>
          <p:spPr bwMode="auto">
            <a:xfrm>
              <a:off x="5220233" y="3553727"/>
              <a:ext cx="275946" cy="1322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cs typeface="Arial" pitchFamily="34" charset="0"/>
                </a:rPr>
                <a:t>GBM</a:t>
              </a:r>
              <a:endPara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111" name="TextBox 2110"/>
          <p:cNvSpPr txBox="1"/>
          <p:nvPr/>
        </p:nvSpPr>
        <p:spPr>
          <a:xfrm>
            <a:off x="1143000" y="37802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IN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12" name="TextBox 2111"/>
          <p:cNvSpPr txBox="1"/>
          <p:nvPr/>
        </p:nvSpPr>
        <p:spPr>
          <a:xfrm>
            <a:off x="1143000" y="168323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IN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13" name="TextBox 2112"/>
          <p:cNvSpPr txBox="1"/>
          <p:nvPr/>
        </p:nvSpPr>
        <p:spPr>
          <a:xfrm>
            <a:off x="4672994" y="168323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n-IN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14" name="TextBox 2113"/>
          <p:cNvSpPr txBox="1"/>
          <p:nvPr/>
        </p:nvSpPr>
        <p:spPr>
          <a:xfrm>
            <a:off x="1143000" y="403562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D</a:t>
            </a:r>
            <a:endParaRPr lang="en-IN" sz="1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975" name="Group 1974"/>
          <p:cNvGrpSpPr/>
          <p:nvPr/>
        </p:nvGrpSpPr>
        <p:grpSpPr>
          <a:xfrm>
            <a:off x="1650522" y="335186"/>
            <a:ext cx="5486400" cy="1036414"/>
            <a:chOff x="1650522" y="304800"/>
            <a:chExt cx="5486400" cy="1036414"/>
          </a:xfrm>
        </p:grpSpPr>
        <p:sp>
          <p:nvSpPr>
            <p:cNvPr id="4" name="Rectangle 3"/>
            <p:cNvSpPr/>
            <p:nvPr/>
          </p:nvSpPr>
          <p:spPr>
            <a:xfrm>
              <a:off x="1650522" y="658345"/>
              <a:ext cx="5486400" cy="6893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5" name="Rectangle 4"/>
            <p:cNvSpPr/>
            <p:nvPr/>
          </p:nvSpPr>
          <p:spPr>
            <a:xfrm>
              <a:off x="2498594" y="304800"/>
              <a:ext cx="2705580" cy="26515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1200" b="1" dirty="0">
                  <a:latin typeface="Times New Roman" pitchFamily="18" charset="0"/>
                  <a:cs typeface="Times New Roman" pitchFamily="18" charset="0"/>
                </a:rPr>
                <a:t>Chromosome 10 - NC_000010.11</a:t>
              </a:r>
              <a:endParaRPr lang="en-IN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6" name="Straight Arrow Connector 5"/>
            <p:cNvCxnSpPr/>
            <p:nvPr/>
          </p:nvCxnSpPr>
          <p:spPr>
            <a:xfrm>
              <a:off x="3454104" y="1002995"/>
              <a:ext cx="1581912" cy="0"/>
            </a:xfrm>
            <a:prstGeom prst="straightConnector1">
              <a:avLst/>
            </a:prstGeom>
            <a:ln w="38100">
              <a:solidFill>
                <a:srgbClr val="FF0000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Arrow Connector 6"/>
            <p:cNvCxnSpPr/>
            <p:nvPr/>
          </p:nvCxnSpPr>
          <p:spPr>
            <a:xfrm>
              <a:off x="2350144" y="934943"/>
              <a:ext cx="594360" cy="0"/>
            </a:xfrm>
            <a:prstGeom prst="straightConnector1">
              <a:avLst/>
            </a:prstGeom>
            <a:ln w="38100">
              <a:solidFill>
                <a:srgbClr val="FF0000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Arrow Connector 7"/>
            <p:cNvCxnSpPr/>
            <p:nvPr/>
          </p:nvCxnSpPr>
          <p:spPr>
            <a:xfrm flipH="1">
              <a:off x="4867248" y="845534"/>
              <a:ext cx="137160" cy="0"/>
            </a:xfrm>
            <a:prstGeom prst="straightConnector1">
              <a:avLst/>
            </a:prstGeom>
            <a:ln w="19050">
              <a:solidFill>
                <a:srgbClr val="002060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8"/>
            <p:cNvCxnSpPr/>
            <p:nvPr/>
          </p:nvCxnSpPr>
          <p:spPr>
            <a:xfrm flipH="1">
              <a:off x="5058061" y="1116083"/>
              <a:ext cx="1371600" cy="0"/>
            </a:xfrm>
            <a:prstGeom prst="straightConnector1">
              <a:avLst/>
            </a:prstGeom>
            <a:ln w="38100">
              <a:solidFill>
                <a:srgbClr val="002060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4020430" y="775148"/>
              <a:ext cx="546634" cy="20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Times New Roman" pitchFamily="18" charset="0"/>
                  <a:cs typeface="Times New Roman" pitchFamily="18" charset="0"/>
                </a:rPr>
                <a:t>UROS</a:t>
              </a:r>
              <a:endParaRPr lang="en-IN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417468" y="716117"/>
              <a:ext cx="630532" cy="20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Times New Roman" pitchFamily="18" charset="0"/>
                  <a:cs typeface="Times New Roman" pitchFamily="18" charset="0"/>
                </a:rPr>
                <a:t>MMP21</a:t>
              </a:r>
              <a:endParaRPr lang="en-IN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461506" y="883976"/>
              <a:ext cx="585787" cy="20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Times New Roman" pitchFamily="18" charset="0"/>
                  <a:cs typeface="Times New Roman" pitchFamily="18" charset="0"/>
                </a:rPr>
                <a:t>BCCIP</a:t>
              </a:r>
              <a:endParaRPr lang="en-IN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947013" y="734466"/>
              <a:ext cx="697649" cy="2062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Times New Roman" pitchFamily="18" charset="0"/>
                  <a:cs typeface="Times New Roman" pitchFamily="18" charset="0"/>
                </a:rPr>
                <a:t>MIR4484</a:t>
              </a:r>
              <a:endParaRPr lang="en-IN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74" name="TextBox 1973"/>
            <p:cNvSpPr txBox="1"/>
            <p:nvPr/>
          </p:nvSpPr>
          <p:spPr>
            <a:xfrm>
              <a:off x="2101477" y="970057"/>
              <a:ext cx="125066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chr10:127455027-127464390</a:t>
              </a:r>
              <a:endParaRPr lang="en-IN" sz="700" dirty="0"/>
            </a:p>
          </p:txBody>
        </p:sp>
        <p:sp>
          <p:nvSpPr>
            <p:cNvPr id="2118" name="TextBox 2117"/>
            <p:cNvSpPr txBox="1"/>
            <p:nvPr/>
          </p:nvSpPr>
          <p:spPr>
            <a:xfrm>
              <a:off x="3628116" y="1033181"/>
              <a:ext cx="129554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chr10:127477147-127511837</a:t>
              </a:r>
              <a:endParaRPr lang="en-IN" sz="700" dirty="0"/>
            </a:p>
          </p:txBody>
        </p:sp>
        <p:sp>
          <p:nvSpPr>
            <p:cNvPr id="2119" name="TextBox 2118"/>
            <p:cNvSpPr txBox="1"/>
            <p:nvPr/>
          </p:nvSpPr>
          <p:spPr>
            <a:xfrm>
              <a:off x="5068342" y="1141159"/>
              <a:ext cx="129554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smtClean="0"/>
                <a:t>chr10:127512104-127542264</a:t>
              </a:r>
              <a:endParaRPr lang="en-IN" sz="700" dirty="0"/>
            </a:p>
          </p:txBody>
        </p:sp>
      </p:grpSp>
      <p:grpSp>
        <p:nvGrpSpPr>
          <p:cNvPr id="2116" name="Group 2115"/>
          <p:cNvGrpSpPr/>
          <p:nvPr/>
        </p:nvGrpSpPr>
        <p:grpSpPr>
          <a:xfrm>
            <a:off x="1048855" y="4113433"/>
            <a:ext cx="2743200" cy="2286000"/>
            <a:chOff x="934426" y="1598833"/>
            <a:chExt cx="2754312" cy="2296975"/>
          </a:xfrm>
        </p:grpSpPr>
        <p:grpSp>
          <p:nvGrpSpPr>
            <p:cNvPr id="2117" name="Group 7"/>
            <p:cNvGrpSpPr>
              <a:grpSpLocks/>
            </p:cNvGrpSpPr>
            <p:nvPr/>
          </p:nvGrpSpPr>
          <p:grpSpPr bwMode="auto">
            <a:xfrm>
              <a:off x="934426" y="1609807"/>
              <a:ext cx="2754312" cy="2286001"/>
              <a:chOff x="183" y="768"/>
              <a:chExt cx="2231" cy="1497"/>
            </a:xfrm>
          </p:grpSpPr>
          <p:sp>
            <p:nvSpPr>
              <p:cNvPr id="2122" name="AutoShape 6"/>
              <p:cNvSpPr>
                <a:spLocks noChangeAspect="1" noChangeArrowheads="1" noTextEdit="1"/>
              </p:cNvSpPr>
              <p:nvPr/>
            </p:nvSpPr>
            <p:spPr bwMode="auto">
              <a:xfrm>
                <a:off x="192" y="768"/>
                <a:ext cx="2222" cy="14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23" name="Rectangle 8"/>
              <p:cNvSpPr>
                <a:spLocks noChangeArrowheads="1"/>
              </p:cNvSpPr>
              <p:nvPr/>
            </p:nvSpPr>
            <p:spPr bwMode="auto">
              <a:xfrm>
                <a:off x="192" y="768"/>
                <a:ext cx="2222" cy="14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24" name="Rectangle 9"/>
              <p:cNvSpPr>
                <a:spLocks noChangeArrowheads="1"/>
              </p:cNvSpPr>
              <p:nvPr/>
            </p:nvSpPr>
            <p:spPr bwMode="auto">
              <a:xfrm>
                <a:off x="666" y="923"/>
                <a:ext cx="1510" cy="11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25" name="Line 10"/>
              <p:cNvSpPr>
                <a:spLocks noChangeShapeType="1"/>
              </p:cNvSpPr>
              <p:nvPr/>
            </p:nvSpPr>
            <p:spPr bwMode="auto">
              <a:xfrm>
                <a:off x="666" y="1383"/>
                <a:ext cx="1511" cy="0"/>
              </a:xfrm>
              <a:prstGeom prst="line">
                <a:avLst/>
              </a:prstGeom>
              <a:noFill/>
              <a:ln w="11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26" name="Line 11"/>
              <p:cNvSpPr>
                <a:spLocks noChangeShapeType="1"/>
              </p:cNvSpPr>
              <p:nvPr/>
            </p:nvSpPr>
            <p:spPr bwMode="auto">
              <a:xfrm>
                <a:off x="1044" y="1383"/>
                <a:ext cx="0" cy="33"/>
              </a:xfrm>
              <a:prstGeom prst="line">
                <a:avLst/>
              </a:prstGeom>
              <a:noFill/>
              <a:ln w="11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27" name="Rectangle 12"/>
              <p:cNvSpPr>
                <a:spLocks noChangeArrowheads="1"/>
              </p:cNvSpPr>
              <p:nvPr/>
            </p:nvSpPr>
            <p:spPr bwMode="auto">
              <a:xfrm>
                <a:off x="875" y="2059"/>
                <a:ext cx="347" cy="2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Control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 brain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8" name="Line 13"/>
              <p:cNvSpPr>
                <a:spLocks noChangeShapeType="1"/>
              </p:cNvSpPr>
              <p:nvPr/>
            </p:nvSpPr>
            <p:spPr bwMode="auto">
              <a:xfrm>
                <a:off x="1800" y="1383"/>
                <a:ext cx="0" cy="33"/>
              </a:xfrm>
              <a:prstGeom prst="line">
                <a:avLst/>
              </a:prstGeom>
              <a:noFill/>
              <a:ln w="11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29" name="Rectangle 14"/>
              <p:cNvSpPr>
                <a:spLocks noChangeArrowheads="1"/>
              </p:cNvSpPr>
              <p:nvPr/>
            </p:nvSpPr>
            <p:spPr bwMode="auto">
              <a:xfrm>
                <a:off x="1695" y="2059"/>
                <a:ext cx="224" cy="1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GBM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0" name="Line 15"/>
              <p:cNvSpPr>
                <a:spLocks noChangeShapeType="1"/>
              </p:cNvSpPr>
              <p:nvPr/>
            </p:nvSpPr>
            <p:spPr bwMode="auto">
              <a:xfrm flipV="1">
                <a:off x="666" y="923"/>
                <a:ext cx="0" cy="1150"/>
              </a:xfrm>
              <a:prstGeom prst="line">
                <a:avLst/>
              </a:prstGeom>
              <a:noFill/>
              <a:ln w="11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31" name="Line 16"/>
              <p:cNvSpPr>
                <a:spLocks noChangeShapeType="1"/>
              </p:cNvSpPr>
              <p:nvPr/>
            </p:nvSpPr>
            <p:spPr bwMode="auto">
              <a:xfrm flipH="1">
                <a:off x="634" y="2073"/>
                <a:ext cx="32" cy="0"/>
              </a:xfrm>
              <a:prstGeom prst="line">
                <a:avLst/>
              </a:prstGeom>
              <a:noFill/>
              <a:ln w="11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32" name="Rectangle 17"/>
              <p:cNvSpPr>
                <a:spLocks noChangeArrowheads="1"/>
              </p:cNvSpPr>
              <p:nvPr/>
            </p:nvSpPr>
            <p:spPr bwMode="auto">
              <a:xfrm>
                <a:off x="521" y="2024"/>
                <a:ext cx="101" cy="1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-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3" name="Line 18"/>
              <p:cNvSpPr>
                <a:spLocks noChangeShapeType="1"/>
              </p:cNvSpPr>
              <p:nvPr/>
            </p:nvSpPr>
            <p:spPr bwMode="auto">
              <a:xfrm flipH="1">
                <a:off x="634" y="1843"/>
                <a:ext cx="32" cy="0"/>
              </a:xfrm>
              <a:prstGeom prst="line">
                <a:avLst/>
              </a:prstGeom>
              <a:noFill/>
              <a:ln w="11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34" name="Rectangle 19"/>
              <p:cNvSpPr>
                <a:spLocks noChangeArrowheads="1"/>
              </p:cNvSpPr>
              <p:nvPr/>
            </p:nvSpPr>
            <p:spPr bwMode="auto">
              <a:xfrm>
                <a:off x="521" y="1794"/>
                <a:ext cx="101" cy="1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-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5" name="Line 20"/>
              <p:cNvSpPr>
                <a:spLocks noChangeShapeType="1"/>
              </p:cNvSpPr>
              <p:nvPr/>
            </p:nvSpPr>
            <p:spPr bwMode="auto">
              <a:xfrm flipH="1">
                <a:off x="634" y="1613"/>
                <a:ext cx="32" cy="0"/>
              </a:xfrm>
              <a:prstGeom prst="line">
                <a:avLst/>
              </a:prstGeom>
              <a:noFill/>
              <a:ln w="11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36" name="Rectangle 21"/>
              <p:cNvSpPr>
                <a:spLocks noChangeArrowheads="1"/>
              </p:cNvSpPr>
              <p:nvPr/>
            </p:nvSpPr>
            <p:spPr bwMode="auto">
              <a:xfrm>
                <a:off x="521" y="1564"/>
                <a:ext cx="101" cy="1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-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7" name="Line 22"/>
              <p:cNvSpPr>
                <a:spLocks noChangeShapeType="1"/>
              </p:cNvSpPr>
              <p:nvPr/>
            </p:nvSpPr>
            <p:spPr bwMode="auto">
              <a:xfrm flipH="1">
                <a:off x="634" y="1383"/>
                <a:ext cx="32" cy="0"/>
              </a:xfrm>
              <a:prstGeom prst="line">
                <a:avLst/>
              </a:prstGeom>
              <a:noFill/>
              <a:ln w="11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38" name="Rectangle 23"/>
              <p:cNvSpPr>
                <a:spLocks noChangeArrowheads="1"/>
              </p:cNvSpPr>
              <p:nvPr/>
            </p:nvSpPr>
            <p:spPr bwMode="auto">
              <a:xfrm>
                <a:off x="548" y="1334"/>
                <a:ext cx="74" cy="1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9" name="Line 24"/>
              <p:cNvSpPr>
                <a:spLocks noChangeShapeType="1"/>
              </p:cNvSpPr>
              <p:nvPr/>
            </p:nvSpPr>
            <p:spPr bwMode="auto">
              <a:xfrm flipH="1">
                <a:off x="634" y="1153"/>
                <a:ext cx="32" cy="0"/>
              </a:xfrm>
              <a:prstGeom prst="line">
                <a:avLst/>
              </a:prstGeom>
              <a:noFill/>
              <a:ln w="11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40" name="Rectangle 25"/>
              <p:cNvSpPr>
                <a:spLocks noChangeArrowheads="1"/>
              </p:cNvSpPr>
              <p:nvPr/>
            </p:nvSpPr>
            <p:spPr bwMode="auto">
              <a:xfrm>
                <a:off x="548" y="1104"/>
                <a:ext cx="74" cy="1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41" name="Line 26"/>
              <p:cNvSpPr>
                <a:spLocks noChangeShapeType="1"/>
              </p:cNvSpPr>
              <p:nvPr/>
            </p:nvSpPr>
            <p:spPr bwMode="auto">
              <a:xfrm flipH="1">
                <a:off x="634" y="923"/>
                <a:ext cx="32" cy="0"/>
              </a:xfrm>
              <a:prstGeom prst="line">
                <a:avLst/>
              </a:prstGeom>
              <a:noFill/>
              <a:ln w="11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42" name="Rectangle 27"/>
              <p:cNvSpPr>
                <a:spLocks noChangeArrowheads="1"/>
              </p:cNvSpPr>
              <p:nvPr/>
            </p:nvSpPr>
            <p:spPr bwMode="auto">
              <a:xfrm>
                <a:off x="548" y="874"/>
                <a:ext cx="74" cy="1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43" name="Oval 28"/>
              <p:cNvSpPr>
                <a:spLocks noChangeArrowheads="1"/>
              </p:cNvSpPr>
              <p:nvPr/>
            </p:nvSpPr>
            <p:spPr bwMode="auto">
              <a:xfrm>
                <a:off x="997" y="1310"/>
                <a:ext cx="23" cy="24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44" name="Oval 29"/>
              <p:cNvSpPr>
                <a:spLocks noChangeArrowheads="1"/>
              </p:cNvSpPr>
              <p:nvPr/>
            </p:nvSpPr>
            <p:spPr bwMode="auto">
              <a:xfrm>
                <a:off x="1032" y="1318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45" name="Oval 30"/>
              <p:cNvSpPr>
                <a:spLocks noChangeArrowheads="1"/>
              </p:cNvSpPr>
              <p:nvPr/>
            </p:nvSpPr>
            <p:spPr bwMode="auto">
              <a:xfrm>
                <a:off x="1032" y="1463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46" name="Oval 31"/>
              <p:cNvSpPr>
                <a:spLocks noChangeArrowheads="1"/>
              </p:cNvSpPr>
              <p:nvPr/>
            </p:nvSpPr>
            <p:spPr bwMode="auto">
              <a:xfrm>
                <a:off x="1032" y="1365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47" name="Oval 32"/>
              <p:cNvSpPr>
                <a:spLocks noChangeArrowheads="1"/>
              </p:cNvSpPr>
              <p:nvPr/>
            </p:nvSpPr>
            <p:spPr bwMode="auto">
              <a:xfrm>
                <a:off x="1032" y="1426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48" name="Oval 33"/>
              <p:cNvSpPr>
                <a:spLocks noChangeArrowheads="1"/>
              </p:cNvSpPr>
              <p:nvPr/>
            </p:nvSpPr>
            <p:spPr bwMode="auto">
              <a:xfrm>
                <a:off x="997" y="1339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49" name="Oval 34"/>
              <p:cNvSpPr>
                <a:spLocks noChangeArrowheads="1"/>
              </p:cNvSpPr>
              <p:nvPr/>
            </p:nvSpPr>
            <p:spPr bwMode="auto">
              <a:xfrm>
                <a:off x="1066" y="1348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50" name="Oval 35"/>
              <p:cNvSpPr>
                <a:spLocks noChangeArrowheads="1"/>
              </p:cNvSpPr>
              <p:nvPr/>
            </p:nvSpPr>
            <p:spPr bwMode="auto">
              <a:xfrm>
                <a:off x="997" y="1408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51" name="Line 36"/>
              <p:cNvSpPr>
                <a:spLocks noChangeShapeType="1"/>
              </p:cNvSpPr>
              <p:nvPr/>
            </p:nvSpPr>
            <p:spPr bwMode="auto">
              <a:xfrm>
                <a:off x="792" y="1383"/>
                <a:ext cx="502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52" name="Oval 37"/>
              <p:cNvSpPr>
                <a:spLocks noChangeArrowheads="1"/>
              </p:cNvSpPr>
              <p:nvPr/>
            </p:nvSpPr>
            <p:spPr bwMode="auto">
              <a:xfrm>
                <a:off x="1822" y="1283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53" name="Oval 38"/>
              <p:cNvSpPr>
                <a:spLocks noChangeArrowheads="1"/>
              </p:cNvSpPr>
              <p:nvPr/>
            </p:nvSpPr>
            <p:spPr bwMode="auto">
              <a:xfrm>
                <a:off x="1788" y="1218"/>
                <a:ext cx="22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54" name="Oval 39"/>
              <p:cNvSpPr>
                <a:spLocks noChangeArrowheads="1"/>
              </p:cNvSpPr>
              <p:nvPr/>
            </p:nvSpPr>
            <p:spPr bwMode="auto">
              <a:xfrm>
                <a:off x="1753" y="1478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55" name="Oval 40"/>
              <p:cNvSpPr>
                <a:spLocks noChangeArrowheads="1"/>
              </p:cNvSpPr>
              <p:nvPr/>
            </p:nvSpPr>
            <p:spPr bwMode="auto">
              <a:xfrm>
                <a:off x="1856" y="1339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56" name="Oval 41"/>
              <p:cNvSpPr>
                <a:spLocks noChangeArrowheads="1"/>
              </p:cNvSpPr>
              <p:nvPr/>
            </p:nvSpPr>
            <p:spPr bwMode="auto">
              <a:xfrm>
                <a:off x="1788" y="1420"/>
                <a:ext cx="22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57" name="Oval 42"/>
              <p:cNvSpPr>
                <a:spLocks noChangeArrowheads="1"/>
              </p:cNvSpPr>
              <p:nvPr/>
            </p:nvSpPr>
            <p:spPr bwMode="auto">
              <a:xfrm>
                <a:off x="1788" y="1177"/>
                <a:ext cx="22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58" name="Oval 43"/>
              <p:cNvSpPr>
                <a:spLocks noChangeArrowheads="1"/>
              </p:cNvSpPr>
              <p:nvPr/>
            </p:nvSpPr>
            <p:spPr bwMode="auto">
              <a:xfrm>
                <a:off x="1788" y="1288"/>
                <a:ext cx="22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59" name="Oval 44"/>
              <p:cNvSpPr>
                <a:spLocks noChangeArrowheads="1"/>
              </p:cNvSpPr>
              <p:nvPr/>
            </p:nvSpPr>
            <p:spPr bwMode="auto">
              <a:xfrm>
                <a:off x="1822" y="1547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60" name="Oval 45"/>
              <p:cNvSpPr>
                <a:spLocks noChangeArrowheads="1"/>
              </p:cNvSpPr>
              <p:nvPr/>
            </p:nvSpPr>
            <p:spPr bwMode="auto">
              <a:xfrm>
                <a:off x="1788" y="1362"/>
                <a:ext cx="22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61" name="Oval 46"/>
              <p:cNvSpPr>
                <a:spLocks noChangeArrowheads="1"/>
              </p:cNvSpPr>
              <p:nvPr/>
            </p:nvSpPr>
            <p:spPr bwMode="auto">
              <a:xfrm>
                <a:off x="1753" y="1449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62" name="Oval 47"/>
              <p:cNvSpPr>
                <a:spLocks noChangeArrowheads="1"/>
              </p:cNvSpPr>
              <p:nvPr/>
            </p:nvSpPr>
            <p:spPr bwMode="auto">
              <a:xfrm>
                <a:off x="1788" y="1325"/>
                <a:ext cx="22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63" name="Oval 48"/>
              <p:cNvSpPr>
                <a:spLocks noChangeArrowheads="1"/>
              </p:cNvSpPr>
              <p:nvPr/>
            </p:nvSpPr>
            <p:spPr bwMode="auto">
              <a:xfrm>
                <a:off x="1822" y="1187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64" name="Oval 49"/>
              <p:cNvSpPr>
                <a:spLocks noChangeArrowheads="1"/>
              </p:cNvSpPr>
              <p:nvPr/>
            </p:nvSpPr>
            <p:spPr bwMode="auto">
              <a:xfrm>
                <a:off x="1753" y="1340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65" name="Oval 50"/>
              <p:cNvSpPr>
                <a:spLocks noChangeArrowheads="1"/>
              </p:cNvSpPr>
              <p:nvPr/>
            </p:nvSpPr>
            <p:spPr bwMode="auto">
              <a:xfrm>
                <a:off x="1719" y="1255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66" name="Oval 51"/>
              <p:cNvSpPr>
                <a:spLocks noChangeArrowheads="1"/>
              </p:cNvSpPr>
              <p:nvPr/>
            </p:nvSpPr>
            <p:spPr bwMode="auto">
              <a:xfrm>
                <a:off x="1856" y="1444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67" name="Oval 52"/>
              <p:cNvSpPr>
                <a:spLocks noChangeArrowheads="1"/>
              </p:cNvSpPr>
              <p:nvPr/>
            </p:nvSpPr>
            <p:spPr bwMode="auto">
              <a:xfrm>
                <a:off x="1822" y="1167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68" name="Oval 53"/>
              <p:cNvSpPr>
                <a:spLocks noChangeArrowheads="1"/>
              </p:cNvSpPr>
              <p:nvPr/>
            </p:nvSpPr>
            <p:spPr bwMode="auto">
              <a:xfrm>
                <a:off x="1788" y="1122"/>
                <a:ext cx="22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69" name="Oval 54"/>
              <p:cNvSpPr>
                <a:spLocks noChangeArrowheads="1"/>
              </p:cNvSpPr>
              <p:nvPr/>
            </p:nvSpPr>
            <p:spPr bwMode="auto">
              <a:xfrm>
                <a:off x="1822" y="1046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70" name="Oval 55"/>
              <p:cNvSpPr>
                <a:spLocks noChangeArrowheads="1"/>
              </p:cNvSpPr>
              <p:nvPr/>
            </p:nvSpPr>
            <p:spPr bwMode="auto">
              <a:xfrm>
                <a:off x="1753" y="1218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71" name="Oval 56"/>
              <p:cNvSpPr>
                <a:spLocks noChangeArrowheads="1"/>
              </p:cNvSpPr>
              <p:nvPr/>
            </p:nvSpPr>
            <p:spPr bwMode="auto">
              <a:xfrm>
                <a:off x="1788" y="1066"/>
                <a:ext cx="22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72" name="Oval 57"/>
              <p:cNvSpPr>
                <a:spLocks noChangeArrowheads="1"/>
              </p:cNvSpPr>
              <p:nvPr/>
            </p:nvSpPr>
            <p:spPr bwMode="auto">
              <a:xfrm>
                <a:off x="1788" y="1564"/>
                <a:ext cx="22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73" name="Oval 58"/>
              <p:cNvSpPr>
                <a:spLocks noChangeArrowheads="1"/>
              </p:cNvSpPr>
              <p:nvPr/>
            </p:nvSpPr>
            <p:spPr bwMode="auto">
              <a:xfrm>
                <a:off x="1788" y="1606"/>
                <a:ext cx="22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74" name="Oval 59"/>
              <p:cNvSpPr>
                <a:spLocks noChangeArrowheads="1"/>
              </p:cNvSpPr>
              <p:nvPr/>
            </p:nvSpPr>
            <p:spPr bwMode="auto">
              <a:xfrm>
                <a:off x="1822" y="1474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75" name="Oval 60"/>
              <p:cNvSpPr>
                <a:spLocks noChangeArrowheads="1"/>
              </p:cNvSpPr>
              <p:nvPr/>
            </p:nvSpPr>
            <p:spPr bwMode="auto">
              <a:xfrm>
                <a:off x="1822" y="1306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76" name="Oval 61"/>
              <p:cNvSpPr>
                <a:spLocks noChangeArrowheads="1"/>
              </p:cNvSpPr>
              <p:nvPr/>
            </p:nvSpPr>
            <p:spPr bwMode="auto">
              <a:xfrm>
                <a:off x="1719" y="1297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77" name="Oval 62"/>
              <p:cNvSpPr>
                <a:spLocks noChangeArrowheads="1"/>
              </p:cNvSpPr>
              <p:nvPr/>
            </p:nvSpPr>
            <p:spPr bwMode="auto">
              <a:xfrm>
                <a:off x="1788" y="1460"/>
                <a:ext cx="22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78" name="Oval 63"/>
              <p:cNvSpPr>
                <a:spLocks noChangeArrowheads="1"/>
              </p:cNvSpPr>
              <p:nvPr/>
            </p:nvSpPr>
            <p:spPr bwMode="auto">
              <a:xfrm>
                <a:off x="1753" y="1095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79" name="Oval 64"/>
              <p:cNvSpPr>
                <a:spLocks noChangeArrowheads="1"/>
              </p:cNvSpPr>
              <p:nvPr/>
            </p:nvSpPr>
            <p:spPr bwMode="auto">
              <a:xfrm>
                <a:off x="1753" y="1272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80" name="Oval 65"/>
              <p:cNvSpPr>
                <a:spLocks noChangeArrowheads="1"/>
              </p:cNvSpPr>
              <p:nvPr/>
            </p:nvSpPr>
            <p:spPr bwMode="auto">
              <a:xfrm>
                <a:off x="1753" y="1417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81" name="Oval 66"/>
              <p:cNvSpPr>
                <a:spLocks noChangeArrowheads="1"/>
              </p:cNvSpPr>
              <p:nvPr/>
            </p:nvSpPr>
            <p:spPr bwMode="auto">
              <a:xfrm>
                <a:off x="1753" y="1311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82" name="Oval 67"/>
              <p:cNvSpPr>
                <a:spLocks noChangeArrowheads="1"/>
              </p:cNvSpPr>
              <p:nvPr/>
            </p:nvSpPr>
            <p:spPr bwMode="auto">
              <a:xfrm>
                <a:off x="1788" y="1824"/>
                <a:ext cx="22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83" name="Oval 68"/>
              <p:cNvSpPr>
                <a:spLocks noChangeArrowheads="1"/>
              </p:cNvSpPr>
              <p:nvPr/>
            </p:nvSpPr>
            <p:spPr bwMode="auto">
              <a:xfrm>
                <a:off x="1822" y="1350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84" name="Oval 69"/>
              <p:cNvSpPr>
                <a:spLocks noChangeArrowheads="1"/>
              </p:cNvSpPr>
              <p:nvPr/>
            </p:nvSpPr>
            <p:spPr bwMode="auto">
              <a:xfrm>
                <a:off x="1822" y="1452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85" name="Oval 70"/>
              <p:cNvSpPr>
                <a:spLocks noChangeArrowheads="1"/>
              </p:cNvSpPr>
              <p:nvPr/>
            </p:nvSpPr>
            <p:spPr bwMode="auto">
              <a:xfrm>
                <a:off x="1788" y="1506"/>
                <a:ext cx="22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86" name="Oval 71"/>
              <p:cNvSpPr>
                <a:spLocks noChangeArrowheads="1"/>
              </p:cNvSpPr>
              <p:nvPr/>
            </p:nvSpPr>
            <p:spPr bwMode="auto">
              <a:xfrm>
                <a:off x="1856" y="1260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87" name="Oval 72"/>
              <p:cNvSpPr>
                <a:spLocks noChangeArrowheads="1"/>
              </p:cNvSpPr>
              <p:nvPr/>
            </p:nvSpPr>
            <p:spPr bwMode="auto">
              <a:xfrm>
                <a:off x="1822" y="1391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88" name="Oval 73"/>
              <p:cNvSpPr>
                <a:spLocks noChangeArrowheads="1"/>
              </p:cNvSpPr>
              <p:nvPr/>
            </p:nvSpPr>
            <p:spPr bwMode="auto">
              <a:xfrm>
                <a:off x="1719" y="1434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89" name="Line 74"/>
              <p:cNvSpPr>
                <a:spLocks noChangeShapeType="1"/>
              </p:cNvSpPr>
              <p:nvPr/>
            </p:nvSpPr>
            <p:spPr bwMode="auto">
              <a:xfrm>
                <a:off x="1548" y="1357"/>
                <a:ext cx="502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90" name="Rectangle 76"/>
              <p:cNvSpPr>
                <a:spLocks noChangeArrowheads="1"/>
              </p:cNvSpPr>
              <p:nvPr/>
            </p:nvSpPr>
            <p:spPr bwMode="auto">
              <a:xfrm rot="16200000">
                <a:off x="-324" y="1376"/>
                <a:ext cx="1263" cy="2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BCCIP</a:t>
                </a:r>
                <a:r>
                  <a:rPr kumimoji="0" lang="en-US" sz="1000" b="1" i="0" u="none" strike="noStrike" cap="none" normalizeH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 t</a:t>
                </a:r>
                <a:r>
                  <a: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ranscript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(Log</a:t>
                </a:r>
                <a:r>
                  <a:rPr kumimoji="0" lang="en-US" sz="1000" b="1" i="0" u="none" strike="noStrike" cap="none" normalizeH="0" baseline="-25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2 </a:t>
                </a:r>
                <a:r>
                  <a: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Ratio)</a:t>
                </a:r>
                <a:endPara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120" name="Right Bracket 2119"/>
            <p:cNvSpPr/>
            <p:nvPr/>
          </p:nvSpPr>
          <p:spPr>
            <a:xfrm rot="16200000">
              <a:off x="2426341" y="1409289"/>
              <a:ext cx="75378" cy="914400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2121" name="TextBox 2120"/>
            <p:cNvSpPr txBox="1"/>
            <p:nvPr/>
          </p:nvSpPr>
          <p:spPr>
            <a:xfrm>
              <a:off x="2321239" y="1598833"/>
              <a:ext cx="298367" cy="2676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ns</a:t>
              </a:r>
              <a:endParaRPr lang="en-IN" sz="1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191" name="Group 2190"/>
          <p:cNvGrpSpPr/>
          <p:nvPr/>
        </p:nvGrpSpPr>
        <p:grpSpPr>
          <a:xfrm>
            <a:off x="4648200" y="4114800"/>
            <a:ext cx="2743200" cy="2286000"/>
            <a:chOff x="3984605" y="1600200"/>
            <a:chExt cx="2743200" cy="2298045"/>
          </a:xfrm>
        </p:grpSpPr>
        <p:grpSp>
          <p:nvGrpSpPr>
            <p:cNvPr id="2192" name="Group 79"/>
            <p:cNvGrpSpPr>
              <a:grpSpLocks/>
            </p:cNvGrpSpPr>
            <p:nvPr/>
          </p:nvGrpSpPr>
          <p:grpSpPr bwMode="auto">
            <a:xfrm>
              <a:off x="3984605" y="1612243"/>
              <a:ext cx="2743200" cy="2286002"/>
              <a:chOff x="2879" y="787"/>
              <a:chExt cx="2245" cy="1497"/>
            </a:xfrm>
          </p:grpSpPr>
          <p:sp>
            <p:nvSpPr>
              <p:cNvPr id="2195" name="AutoShape 78"/>
              <p:cNvSpPr>
                <a:spLocks noChangeAspect="1" noChangeArrowheads="1" noTextEdit="1"/>
              </p:cNvSpPr>
              <p:nvPr/>
            </p:nvSpPr>
            <p:spPr bwMode="auto">
              <a:xfrm>
                <a:off x="2879" y="787"/>
                <a:ext cx="2245" cy="14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96" name="Rectangle 80"/>
              <p:cNvSpPr>
                <a:spLocks noChangeArrowheads="1"/>
              </p:cNvSpPr>
              <p:nvPr/>
            </p:nvSpPr>
            <p:spPr bwMode="auto">
              <a:xfrm>
                <a:off x="2879" y="787"/>
                <a:ext cx="2245" cy="14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97" name="Rectangle 81"/>
              <p:cNvSpPr>
                <a:spLocks noChangeArrowheads="1"/>
              </p:cNvSpPr>
              <p:nvPr/>
            </p:nvSpPr>
            <p:spPr bwMode="auto">
              <a:xfrm>
                <a:off x="3372" y="941"/>
                <a:ext cx="1513" cy="11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98" name="Line 82"/>
              <p:cNvSpPr>
                <a:spLocks noChangeShapeType="1"/>
              </p:cNvSpPr>
              <p:nvPr/>
            </p:nvSpPr>
            <p:spPr bwMode="auto">
              <a:xfrm>
                <a:off x="3372" y="1701"/>
                <a:ext cx="1514" cy="0"/>
              </a:xfrm>
              <a:prstGeom prst="line">
                <a:avLst/>
              </a:prstGeom>
              <a:noFill/>
              <a:ln w="1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199" name="Line 83"/>
              <p:cNvSpPr>
                <a:spLocks noChangeShapeType="1"/>
              </p:cNvSpPr>
              <p:nvPr/>
            </p:nvSpPr>
            <p:spPr bwMode="auto">
              <a:xfrm>
                <a:off x="3750" y="1701"/>
                <a:ext cx="0" cy="32"/>
              </a:xfrm>
              <a:prstGeom prst="line">
                <a:avLst/>
              </a:prstGeom>
              <a:noFill/>
              <a:ln w="1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00" name="Rectangle 84"/>
              <p:cNvSpPr>
                <a:spLocks noChangeArrowheads="1"/>
              </p:cNvSpPr>
              <p:nvPr/>
            </p:nvSpPr>
            <p:spPr bwMode="auto">
              <a:xfrm>
                <a:off x="3561" y="2073"/>
                <a:ext cx="377" cy="2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Control 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brain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01" name="Line 85"/>
              <p:cNvSpPr>
                <a:spLocks noChangeShapeType="1"/>
              </p:cNvSpPr>
              <p:nvPr/>
            </p:nvSpPr>
            <p:spPr bwMode="auto">
              <a:xfrm>
                <a:off x="4508" y="1701"/>
                <a:ext cx="0" cy="32"/>
              </a:xfrm>
              <a:prstGeom prst="line">
                <a:avLst/>
              </a:prstGeom>
              <a:noFill/>
              <a:ln w="1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02" name="Rectangle 86"/>
              <p:cNvSpPr>
                <a:spLocks noChangeArrowheads="1"/>
              </p:cNvSpPr>
              <p:nvPr/>
            </p:nvSpPr>
            <p:spPr bwMode="auto">
              <a:xfrm>
                <a:off x="4395" y="2082"/>
                <a:ext cx="226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GBM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03" name="Line 87"/>
              <p:cNvSpPr>
                <a:spLocks noChangeShapeType="1"/>
              </p:cNvSpPr>
              <p:nvPr/>
            </p:nvSpPr>
            <p:spPr bwMode="auto">
              <a:xfrm flipV="1">
                <a:off x="3372" y="941"/>
                <a:ext cx="0" cy="1140"/>
              </a:xfrm>
              <a:prstGeom prst="line">
                <a:avLst/>
              </a:prstGeom>
              <a:noFill/>
              <a:ln w="1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04" name="Line 88"/>
              <p:cNvSpPr>
                <a:spLocks noChangeShapeType="1"/>
              </p:cNvSpPr>
              <p:nvPr/>
            </p:nvSpPr>
            <p:spPr bwMode="auto">
              <a:xfrm flipH="1">
                <a:off x="3339" y="2081"/>
                <a:ext cx="33" cy="0"/>
              </a:xfrm>
              <a:prstGeom prst="line">
                <a:avLst/>
              </a:prstGeom>
              <a:noFill/>
              <a:ln w="1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05" name="Rectangle 89"/>
              <p:cNvSpPr>
                <a:spLocks noChangeArrowheads="1"/>
              </p:cNvSpPr>
              <p:nvPr/>
            </p:nvSpPr>
            <p:spPr bwMode="auto">
              <a:xfrm>
                <a:off x="3226" y="2032"/>
                <a:ext cx="10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-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06" name="Line 90"/>
              <p:cNvSpPr>
                <a:spLocks noChangeShapeType="1"/>
              </p:cNvSpPr>
              <p:nvPr/>
            </p:nvSpPr>
            <p:spPr bwMode="auto">
              <a:xfrm flipH="1">
                <a:off x="3339" y="1891"/>
                <a:ext cx="33" cy="0"/>
              </a:xfrm>
              <a:prstGeom prst="line">
                <a:avLst/>
              </a:prstGeom>
              <a:noFill/>
              <a:ln w="1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07" name="Rectangle 91"/>
              <p:cNvSpPr>
                <a:spLocks noChangeArrowheads="1"/>
              </p:cNvSpPr>
              <p:nvPr/>
            </p:nvSpPr>
            <p:spPr bwMode="auto">
              <a:xfrm>
                <a:off x="3226" y="1842"/>
                <a:ext cx="102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-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08" name="Line 92"/>
              <p:cNvSpPr>
                <a:spLocks noChangeShapeType="1"/>
              </p:cNvSpPr>
              <p:nvPr/>
            </p:nvSpPr>
            <p:spPr bwMode="auto">
              <a:xfrm flipH="1">
                <a:off x="3339" y="1701"/>
                <a:ext cx="33" cy="0"/>
              </a:xfrm>
              <a:prstGeom prst="line">
                <a:avLst/>
              </a:prstGeom>
              <a:noFill/>
              <a:ln w="1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09" name="Rectangle 93"/>
              <p:cNvSpPr>
                <a:spLocks noChangeArrowheads="1"/>
              </p:cNvSpPr>
              <p:nvPr/>
            </p:nvSpPr>
            <p:spPr bwMode="auto">
              <a:xfrm>
                <a:off x="3253" y="1652"/>
                <a:ext cx="7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10" name="Line 94"/>
              <p:cNvSpPr>
                <a:spLocks noChangeShapeType="1"/>
              </p:cNvSpPr>
              <p:nvPr/>
            </p:nvSpPr>
            <p:spPr bwMode="auto">
              <a:xfrm flipH="1">
                <a:off x="3339" y="1511"/>
                <a:ext cx="33" cy="0"/>
              </a:xfrm>
              <a:prstGeom prst="line">
                <a:avLst/>
              </a:prstGeom>
              <a:noFill/>
              <a:ln w="1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11" name="Rectangle 95"/>
              <p:cNvSpPr>
                <a:spLocks noChangeArrowheads="1"/>
              </p:cNvSpPr>
              <p:nvPr/>
            </p:nvSpPr>
            <p:spPr bwMode="auto">
              <a:xfrm>
                <a:off x="3253" y="1462"/>
                <a:ext cx="7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12" name="Line 96"/>
              <p:cNvSpPr>
                <a:spLocks noChangeShapeType="1"/>
              </p:cNvSpPr>
              <p:nvPr/>
            </p:nvSpPr>
            <p:spPr bwMode="auto">
              <a:xfrm flipH="1">
                <a:off x="3339" y="1321"/>
                <a:ext cx="33" cy="0"/>
              </a:xfrm>
              <a:prstGeom prst="line">
                <a:avLst/>
              </a:prstGeom>
              <a:noFill/>
              <a:ln w="1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13" name="Rectangle 97"/>
              <p:cNvSpPr>
                <a:spLocks noChangeArrowheads="1"/>
              </p:cNvSpPr>
              <p:nvPr/>
            </p:nvSpPr>
            <p:spPr bwMode="auto">
              <a:xfrm>
                <a:off x="3253" y="1272"/>
                <a:ext cx="7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14" name="Line 98"/>
              <p:cNvSpPr>
                <a:spLocks noChangeShapeType="1"/>
              </p:cNvSpPr>
              <p:nvPr/>
            </p:nvSpPr>
            <p:spPr bwMode="auto">
              <a:xfrm flipH="1">
                <a:off x="3339" y="1131"/>
                <a:ext cx="33" cy="0"/>
              </a:xfrm>
              <a:prstGeom prst="line">
                <a:avLst/>
              </a:prstGeom>
              <a:noFill/>
              <a:ln w="1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15" name="Rectangle 99"/>
              <p:cNvSpPr>
                <a:spLocks noChangeArrowheads="1"/>
              </p:cNvSpPr>
              <p:nvPr/>
            </p:nvSpPr>
            <p:spPr bwMode="auto">
              <a:xfrm>
                <a:off x="3253" y="1082"/>
                <a:ext cx="7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16" name="Line 100"/>
              <p:cNvSpPr>
                <a:spLocks noChangeShapeType="1"/>
              </p:cNvSpPr>
              <p:nvPr/>
            </p:nvSpPr>
            <p:spPr bwMode="auto">
              <a:xfrm flipH="1">
                <a:off x="3339" y="941"/>
                <a:ext cx="33" cy="0"/>
              </a:xfrm>
              <a:prstGeom prst="line">
                <a:avLst/>
              </a:prstGeom>
              <a:noFill/>
              <a:ln w="1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17" name="Rectangle 101"/>
              <p:cNvSpPr>
                <a:spLocks noChangeArrowheads="1"/>
              </p:cNvSpPr>
              <p:nvPr/>
            </p:nvSpPr>
            <p:spPr bwMode="auto">
              <a:xfrm>
                <a:off x="3253" y="892"/>
                <a:ext cx="75" cy="1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18" name="Oval 102"/>
              <p:cNvSpPr>
                <a:spLocks noChangeArrowheads="1"/>
              </p:cNvSpPr>
              <p:nvPr/>
            </p:nvSpPr>
            <p:spPr bwMode="auto">
              <a:xfrm>
                <a:off x="3772" y="1668"/>
                <a:ext cx="23" cy="22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19" name="Oval 103"/>
              <p:cNvSpPr>
                <a:spLocks noChangeArrowheads="1"/>
              </p:cNvSpPr>
              <p:nvPr/>
            </p:nvSpPr>
            <p:spPr bwMode="auto">
              <a:xfrm>
                <a:off x="3704" y="1582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20" name="Oval 104"/>
              <p:cNvSpPr>
                <a:spLocks noChangeArrowheads="1"/>
              </p:cNvSpPr>
              <p:nvPr/>
            </p:nvSpPr>
            <p:spPr bwMode="auto">
              <a:xfrm>
                <a:off x="3738" y="1917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21" name="Oval 105"/>
              <p:cNvSpPr>
                <a:spLocks noChangeArrowheads="1"/>
              </p:cNvSpPr>
              <p:nvPr/>
            </p:nvSpPr>
            <p:spPr bwMode="auto">
              <a:xfrm>
                <a:off x="3738" y="1594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22" name="Oval 106"/>
              <p:cNvSpPr>
                <a:spLocks noChangeArrowheads="1"/>
              </p:cNvSpPr>
              <p:nvPr/>
            </p:nvSpPr>
            <p:spPr bwMode="auto">
              <a:xfrm>
                <a:off x="3738" y="1737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23" name="Oval 107"/>
              <p:cNvSpPr>
                <a:spLocks noChangeArrowheads="1"/>
              </p:cNvSpPr>
              <p:nvPr/>
            </p:nvSpPr>
            <p:spPr bwMode="auto">
              <a:xfrm>
                <a:off x="3704" y="1706"/>
                <a:ext cx="23" cy="22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24" name="Oval 108"/>
              <p:cNvSpPr>
                <a:spLocks noChangeArrowheads="1"/>
              </p:cNvSpPr>
              <p:nvPr/>
            </p:nvSpPr>
            <p:spPr bwMode="auto">
              <a:xfrm>
                <a:off x="3704" y="1642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25" name="Oval 109"/>
              <p:cNvSpPr>
                <a:spLocks noChangeArrowheads="1"/>
              </p:cNvSpPr>
              <p:nvPr/>
            </p:nvSpPr>
            <p:spPr bwMode="auto">
              <a:xfrm>
                <a:off x="3738" y="1675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26" name="Line 110"/>
              <p:cNvSpPr>
                <a:spLocks noChangeShapeType="1"/>
              </p:cNvSpPr>
              <p:nvPr/>
            </p:nvSpPr>
            <p:spPr bwMode="auto">
              <a:xfrm>
                <a:off x="3498" y="1701"/>
                <a:ext cx="504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27" name="Oval 111"/>
              <p:cNvSpPr>
                <a:spLocks noChangeArrowheads="1"/>
              </p:cNvSpPr>
              <p:nvPr/>
            </p:nvSpPr>
            <p:spPr bwMode="auto">
              <a:xfrm>
                <a:off x="4462" y="1545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28" name="Oval 112"/>
              <p:cNvSpPr>
                <a:spLocks noChangeArrowheads="1"/>
              </p:cNvSpPr>
              <p:nvPr/>
            </p:nvSpPr>
            <p:spPr bwMode="auto">
              <a:xfrm>
                <a:off x="4496" y="1588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29" name="Oval 113"/>
              <p:cNvSpPr>
                <a:spLocks noChangeArrowheads="1"/>
              </p:cNvSpPr>
              <p:nvPr/>
            </p:nvSpPr>
            <p:spPr bwMode="auto">
              <a:xfrm>
                <a:off x="4462" y="1788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30" name="Oval 114"/>
              <p:cNvSpPr>
                <a:spLocks noChangeArrowheads="1"/>
              </p:cNvSpPr>
              <p:nvPr/>
            </p:nvSpPr>
            <p:spPr bwMode="auto">
              <a:xfrm>
                <a:off x="4530" y="1491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31" name="Oval 115"/>
              <p:cNvSpPr>
                <a:spLocks noChangeArrowheads="1"/>
              </p:cNvSpPr>
              <p:nvPr/>
            </p:nvSpPr>
            <p:spPr bwMode="auto">
              <a:xfrm>
                <a:off x="4393" y="1616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32" name="Oval 116"/>
              <p:cNvSpPr>
                <a:spLocks noChangeArrowheads="1"/>
              </p:cNvSpPr>
              <p:nvPr/>
            </p:nvSpPr>
            <p:spPr bwMode="auto">
              <a:xfrm>
                <a:off x="4462" y="1482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33" name="Oval 117"/>
              <p:cNvSpPr>
                <a:spLocks noChangeArrowheads="1"/>
              </p:cNvSpPr>
              <p:nvPr/>
            </p:nvSpPr>
            <p:spPr bwMode="auto">
              <a:xfrm>
                <a:off x="4565" y="1525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34" name="Oval 118"/>
              <p:cNvSpPr>
                <a:spLocks noChangeArrowheads="1"/>
              </p:cNvSpPr>
              <p:nvPr/>
            </p:nvSpPr>
            <p:spPr bwMode="auto">
              <a:xfrm>
                <a:off x="4496" y="1315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35" name="Oval 119"/>
              <p:cNvSpPr>
                <a:spLocks noChangeArrowheads="1"/>
              </p:cNvSpPr>
              <p:nvPr/>
            </p:nvSpPr>
            <p:spPr bwMode="auto">
              <a:xfrm>
                <a:off x="4496" y="1753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36" name="Oval 120"/>
              <p:cNvSpPr>
                <a:spLocks noChangeArrowheads="1"/>
              </p:cNvSpPr>
              <p:nvPr/>
            </p:nvSpPr>
            <p:spPr bwMode="auto">
              <a:xfrm>
                <a:off x="4462" y="1639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37" name="Oval 121"/>
              <p:cNvSpPr>
                <a:spLocks noChangeArrowheads="1"/>
              </p:cNvSpPr>
              <p:nvPr/>
            </p:nvSpPr>
            <p:spPr bwMode="auto">
              <a:xfrm>
                <a:off x="4462" y="1668"/>
                <a:ext cx="23" cy="22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38" name="Oval 122"/>
              <p:cNvSpPr>
                <a:spLocks noChangeArrowheads="1"/>
              </p:cNvSpPr>
              <p:nvPr/>
            </p:nvSpPr>
            <p:spPr bwMode="auto">
              <a:xfrm>
                <a:off x="4565" y="1666"/>
                <a:ext cx="23" cy="22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39" name="Oval 123"/>
              <p:cNvSpPr>
                <a:spLocks noChangeArrowheads="1"/>
              </p:cNvSpPr>
              <p:nvPr/>
            </p:nvSpPr>
            <p:spPr bwMode="auto">
              <a:xfrm>
                <a:off x="4427" y="1635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40" name="Oval 124"/>
              <p:cNvSpPr>
                <a:spLocks noChangeArrowheads="1"/>
              </p:cNvSpPr>
              <p:nvPr/>
            </p:nvSpPr>
            <p:spPr bwMode="auto">
              <a:xfrm>
                <a:off x="4359" y="1613"/>
                <a:ext cx="22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41" name="Oval 125"/>
              <p:cNvSpPr>
                <a:spLocks noChangeArrowheads="1"/>
              </p:cNvSpPr>
              <p:nvPr/>
            </p:nvSpPr>
            <p:spPr bwMode="auto">
              <a:xfrm>
                <a:off x="4599" y="1615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42" name="Oval 126"/>
              <p:cNvSpPr>
                <a:spLocks noChangeArrowheads="1"/>
              </p:cNvSpPr>
              <p:nvPr/>
            </p:nvSpPr>
            <p:spPr bwMode="auto">
              <a:xfrm>
                <a:off x="4565" y="1763"/>
                <a:ext cx="23" cy="22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43" name="Oval 127"/>
              <p:cNvSpPr>
                <a:spLocks noChangeArrowheads="1"/>
              </p:cNvSpPr>
              <p:nvPr/>
            </p:nvSpPr>
            <p:spPr bwMode="auto">
              <a:xfrm>
                <a:off x="4462" y="1445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44" name="Oval 128"/>
              <p:cNvSpPr>
                <a:spLocks noChangeArrowheads="1"/>
              </p:cNvSpPr>
              <p:nvPr/>
            </p:nvSpPr>
            <p:spPr bwMode="auto">
              <a:xfrm>
                <a:off x="4530" y="1675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45" name="Oval 129"/>
              <p:cNvSpPr>
                <a:spLocks noChangeArrowheads="1"/>
              </p:cNvSpPr>
              <p:nvPr/>
            </p:nvSpPr>
            <p:spPr bwMode="auto">
              <a:xfrm>
                <a:off x="4462" y="1719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46" name="Oval 130"/>
              <p:cNvSpPr>
                <a:spLocks noChangeArrowheads="1"/>
              </p:cNvSpPr>
              <p:nvPr/>
            </p:nvSpPr>
            <p:spPr bwMode="auto">
              <a:xfrm>
                <a:off x="4599" y="1461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47" name="Oval 131"/>
              <p:cNvSpPr>
                <a:spLocks noChangeArrowheads="1"/>
              </p:cNvSpPr>
              <p:nvPr/>
            </p:nvSpPr>
            <p:spPr bwMode="auto">
              <a:xfrm>
                <a:off x="4496" y="1238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48" name="Oval 132"/>
              <p:cNvSpPr>
                <a:spLocks noChangeArrowheads="1"/>
              </p:cNvSpPr>
              <p:nvPr/>
            </p:nvSpPr>
            <p:spPr bwMode="auto">
              <a:xfrm>
                <a:off x="4633" y="1610"/>
                <a:ext cx="23" cy="22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49" name="Oval 133"/>
              <p:cNvSpPr>
                <a:spLocks noChangeArrowheads="1"/>
              </p:cNvSpPr>
              <p:nvPr/>
            </p:nvSpPr>
            <p:spPr bwMode="auto">
              <a:xfrm>
                <a:off x="4565" y="1626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50" name="Oval 134"/>
              <p:cNvSpPr>
                <a:spLocks noChangeArrowheads="1"/>
              </p:cNvSpPr>
              <p:nvPr/>
            </p:nvSpPr>
            <p:spPr bwMode="auto">
              <a:xfrm>
                <a:off x="4427" y="1471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51" name="Oval 135"/>
              <p:cNvSpPr>
                <a:spLocks noChangeArrowheads="1"/>
              </p:cNvSpPr>
              <p:nvPr/>
            </p:nvSpPr>
            <p:spPr bwMode="auto">
              <a:xfrm>
                <a:off x="4496" y="1414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52" name="Oval 136"/>
              <p:cNvSpPr>
                <a:spLocks noChangeArrowheads="1"/>
              </p:cNvSpPr>
              <p:nvPr/>
            </p:nvSpPr>
            <p:spPr bwMode="auto">
              <a:xfrm>
                <a:off x="4496" y="1639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53" name="Oval 137"/>
              <p:cNvSpPr>
                <a:spLocks noChangeArrowheads="1"/>
              </p:cNvSpPr>
              <p:nvPr/>
            </p:nvSpPr>
            <p:spPr bwMode="auto">
              <a:xfrm>
                <a:off x="4565" y="1478"/>
                <a:ext cx="23" cy="22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54" name="Oval 138"/>
              <p:cNvSpPr>
                <a:spLocks noChangeArrowheads="1"/>
              </p:cNvSpPr>
              <p:nvPr/>
            </p:nvSpPr>
            <p:spPr bwMode="auto">
              <a:xfrm>
                <a:off x="4530" y="1566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55" name="Oval 139"/>
              <p:cNvSpPr>
                <a:spLocks noChangeArrowheads="1"/>
              </p:cNvSpPr>
              <p:nvPr/>
            </p:nvSpPr>
            <p:spPr bwMode="auto">
              <a:xfrm>
                <a:off x="4427" y="1653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56" name="Oval 140"/>
              <p:cNvSpPr>
                <a:spLocks noChangeArrowheads="1"/>
              </p:cNvSpPr>
              <p:nvPr/>
            </p:nvSpPr>
            <p:spPr bwMode="auto">
              <a:xfrm>
                <a:off x="4530" y="1637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57" name="Oval 141"/>
              <p:cNvSpPr>
                <a:spLocks noChangeArrowheads="1"/>
              </p:cNvSpPr>
              <p:nvPr/>
            </p:nvSpPr>
            <p:spPr bwMode="auto">
              <a:xfrm>
                <a:off x="4496" y="1717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58" name="Oval 142"/>
              <p:cNvSpPr>
                <a:spLocks noChangeArrowheads="1"/>
              </p:cNvSpPr>
              <p:nvPr/>
            </p:nvSpPr>
            <p:spPr bwMode="auto">
              <a:xfrm>
                <a:off x="4496" y="1885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59" name="Oval 143"/>
              <p:cNvSpPr>
                <a:spLocks noChangeArrowheads="1"/>
              </p:cNvSpPr>
              <p:nvPr/>
            </p:nvSpPr>
            <p:spPr bwMode="auto">
              <a:xfrm>
                <a:off x="4530" y="1538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60" name="Oval 144"/>
              <p:cNvSpPr>
                <a:spLocks noChangeArrowheads="1"/>
              </p:cNvSpPr>
              <p:nvPr/>
            </p:nvSpPr>
            <p:spPr bwMode="auto">
              <a:xfrm>
                <a:off x="4496" y="1451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61" name="Oval 145"/>
              <p:cNvSpPr>
                <a:spLocks noChangeArrowheads="1"/>
              </p:cNvSpPr>
              <p:nvPr/>
            </p:nvSpPr>
            <p:spPr bwMode="auto">
              <a:xfrm>
                <a:off x="4496" y="1165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62" name="Oval 146"/>
              <p:cNvSpPr>
                <a:spLocks noChangeArrowheads="1"/>
              </p:cNvSpPr>
              <p:nvPr/>
            </p:nvSpPr>
            <p:spPr bwMode="auto">
              <a:xfrm>
                <a:off x="4462" y="1562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63" name="Oval 147"/>
              <p:cNvSpPr>
                <a:spLocks noChangeArrowheads="1"/>
              </p:cNvSpPr>
              <p:nvPr/>
            </p:nvSpPr>
            <p:spPr bwMode="auto">
              <a:xfrm>
                <a:off x="4427" y="1533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64" name="Oval 148"/>
              <p:cNvSpPr>
                <a:spLocks noChangeArrowheads="1"/>
              </p:cNvSpPr>
              <p:nvPr/>
            </p:nvSpPr>
            <p:spPr bwMode="auto">
              <a:xfrm>
                <a:off x="4496" y="1549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65" name="Oval 149"/>
              <p:cNvSpPr>
                <a:spLocks noChangeArrowheads="1"/>
              </p:cNvSpPr>
              <p:nvPr/>
            </p:nvSpPr>
            <p:spPr bwMode="auto">
              <a:xfrm>
                <a:off x="4496" y="1494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66" name="Oval 150"/>
              <p:cNvSpPr>
                <a:spLocks noChangeArrowheads="1"/>
              </p:cNvSpPr>
              <p:nvPr/>
            </p:nvSpPr>
            <p:spPr bwMode="auto">
              <a:xfrm>
                <a:off x="4496" y="1100"/>
                <a:ext cx="23" cy="22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67" name="Oval 151"/>
              <p:cNvSpPr>
                <a:spLocks noChangeArrowheads="1"/>
              </p:cNvSpPr>
              <p:nvPr/>
            </p:nvSpPr>
            <p:spPr bwMode="auto">
              <a:xfrm>
                <a:off x="4462" y="1714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68" name="Oval 152"/>
              <p:cNvSpPr>
                <a:spLocks noChangeArrowheads="1"/>
              </p:cNvSpPr>
              <p:nvPr/>
            </p:nvSpPr>
            <p:spPr bwMode="auto">
              <a:xfrm>
                <a:off x="4496" y="1679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69" name="Oval 153"/>
              <p:cNvSpPr>
                <a:spLocks noChangeArrowheads="1"/>
              </p:cNvSpPr>
              <p:nvPr/>
            </p:nvSpPr>
            <p:spPr bwMode="auto">
              <a:xfrm>
                <a:off x="4530" y="1748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70" name="Oval 154"/>
              <p:cNvSpPr>
                <a:spLocks noChangeArrowheads="1"/>
              </p:cNvSpPr>
              <p:nvPr/>
            </p:nvSpPr>
            <p:spPr bwMode="auto">
              <a:xfrm>
                <a:off x="4530" y="1767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71" name="Oval 155"/>
              <p:cNvSpPr>
                <a:spLocks noChangeArrowheads="1"/>
              </p:cNvSpPr>
              <p:nvPr/>
            </p:nvSpPr>
            <p:spPr bwMode="auto">
              <a:xfrm>
                <a:off x="4427" y="1766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72" name="Oval 156"/>
              <p:cNvSpPr>
                <a:spLocks noChangeArrowheads="1"/>
              </p:cNvSpPr>
              <p:nvPr/>
            </p:nvSpPr>
            <p:spPr bwMode="auto">
              <a:xfrm>
                <a:off x="4496" y="1790"/>
                <a:ext cx="23" cy="23"/>
              </a:xfrm>
              <a:prstGeom prst="ellipse">
                <a:avLst/>
              </a:prstGeom>
              <a:solidFill>
                <a:srgbClr val="000000"/>
              </a:solidFill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73" name="Line 157"/>
              <p:cNvSpPr>
                <a:spLocks noChangeShapeType="1"/>
              </p:cNvSpPr>
              <p:nvPr/>
            </p:nvSpPr>
            <p:spPr bwMode="auto">
              <a:xfrm>
                <a:off x="4255" y="1594"/>
                <a:ext cx="504" cy="0"/>
              </a:xfrm>
              <a:prstGeom prst="line">
                <a:avLst/>
              </a:prstGeom>
              <a:noFill/>
              <a:ln w="6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274" name="Rectangle 159"/>
              <p:cNvSpPr>
                <a:spLocks noChangeArrowheads="1"/>
              </p:cNvSpPr>
              <p:nvPr/>
            </p:nvSpPr>
            <p:spPr bwMode="auto">
              <a:xfrm rot="16200000">
                <a:off x="2318" y="1449"/>
                <a:ext cx="1376" cy="2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MMP21 transcript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(Log</a:t>
                </a:r>
                <a:r>
                  <a:rPr kumimoji="0" lang="en-US" sz="1000" b="1" i="0" u="none" strike="noStrike" cap="none" normalizeH="0" baseline="-2500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2</a:t>
                </a:r>
                <a:r>
                  <a:rPr kumimoji="0" 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Arial" pitchFamily="34" charset="0"/>
                  </a:rPr>
                  <a:t> Ratio)</a:t>
                </a:r>
                <a:endPara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193" name="Right Bracket 2192"/>
            <p:cNvSpPr/>
            <p:nvPr/>
          </p:nvSpPr>
          <p:spPr>
            <a:xfrm rot="16200000">
              <a:off x="5468404" y="1410656"/>
              <a:ext cx="75378" cy="914400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  <p:sp>
          <p:nvSpPr>
            <p:cNvPr id="2194" name="TextBox 2193"/>
            <p:cNvSpPr txBox="1"/>
            <p:nvPr/>
          </p:nvSpPr>
          <p:spPr>
            <a:xfrm>
              <a:off x="5363302" y="1600200"/>
              <a:ext cx="298367" cy="2676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ns</a:t>
              </a:r>
              <a:endParaRPr lang="en-IN" sz="1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275" name="TextBox 2274"/>
          <p:cNvSpPr txBox="1"/>
          <p:nvPr/>
        </p:nvSpPr>
        <p:spPr>
          <a:xfrm>
            <a:off x="4672994" y="403562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E</a:t>
            </a:r>
            <a:endParaRPr lang="en-IN" sz="14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399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24</Words>
  <Application>Microsoft Office PowerPoint</Application>
  <PresentationFormat>On-screen Show (4:3)</PresentationFormat>
  <Paragraphs>7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CB-LAB</dc:creator>
  <cp:lastModifiedBy>MCB-LAB</cp:lastModifiedBy>
  <cp:revision>9</cp:revision>
  <dcterms:created xsi:type="dcterms:W3CDTF">2016-12-15T12:15:44Z</dcterms:created>
  <dcterms:modified xsi:type="dcterms:W3CDTF">2016-12-15T12:20:02Z</dcterms:modified>
</cp:coreProperties>
</file>